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theme/themeOverride8.xml" ContentType="application/vnd.openxmlformats-officedocument.themeOverride+xml"/>
  <Override PartName="/ppt/charts/chart9.xml" ContentType="application/vnd.openxmlformats-officedocument.drawingml.chart+xml"/>
  <Override PartName="/ppt/theme/themeOverride9.xml" ContentType="application/vnd.openxmlformats-officedocument.themeOverride+xml"/>
  <Override PartName="/ppt/charts/chart10.xml" ContentType="application/vnd.openxmlformats-officedocument.drawingml.chart+xml"/>
  <Override PartName="/ppt/theme/themeOverride10.xml" ContentType="application/vnd.openxmlformats-officedocument.themeOverride+xml"/>
  <Override PartName="/ppt/charts/chart11.xml" ContentType="application/vnd.openxmlformats-officedocument.drawingml.chart+xml"/>
  <Override PartName="/ppt/theme/themeOverride11.xml" ContentType="application/vnd.openxmlformats-officedocument.themeOverride+xml"/>
  <Override PartName="/ppt/charts/chart12.xml" ContentType="application/vnd.openxmlformats-officedocument.drawingml.chart+xml"/>
  <Override PartName="/ppt/theme/themeOverride12.xml" ContentType="application/vnd.openxmlformats-officedocument.themeOverride+xml"/>
  <Override PartName="/ppt/charts/chart13.xml" ContentType="application/vnd.openxmlformats-officedocument.drawingml.chart+xml"/>
  <Override PartName="/ppt/theme/themeOverride13.xml" ContentType="application/vnd.openxmlformats-officedocument.themeOverride+xml"/>
  <Override PartName="/ppt/charts/chart14.xml" ContentType="application/vnd.openxmlformats-officedocument.drawingml.chart+xml"/>
  <Override PartName="/ppt/theme/themeOverride14.xml" ContentType="application/vnd.openxmlformats-officedocument.themeOverride+xml"/>
  <Override PartName="/ppt/charts/chart15.xml" ContentType="application/vnd.openxmlformats-officedocument.drawingml.chart+xml"/>
  <Override PartName="/ppt/theme/themeOverride15.xml" ContentType="application/vnd.openxmlformats-officedocument.themeOverride+xml"/>
  <Override PartName="/ppt/charts/chart16.xml" ContentType="application/vnd.openxmlformats-officedocument.drawingml.chart+xml"/>
  <Override PartName="/ppt/theme/themeOverride16.xml" ContentType="application/vnd.openxmlformats-officedocument.themeOverride+xml"/>
  <Override PartName="/ppt/charts/chart17.xml" ContentType="application/vnd.openxmlformats-officedocument.drawingml.chart+xml"/>
  <Override PartName="/ppt/theme/themeOverride17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  <p:sldId id="260" r:id="rId3"/>
  </p:sldIdLst>
  <p:sldSz cx="6858000" cy="9906000" type="A4"/>
  <p:notesSz cx="7099300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859" autoAdjust="0"/>
    <p:restoredTop sz="94660"/>
  </p:normalViewPr>
  <p:slideViewPr>
    <p:cSldViewPr snapToGrid="0">
      <p:cViewPr>
        <p:scale>
          <a:sx n="125" d="100"/>
          <a:sy n="125" d="100"/>
        </p:scale>
        <p:origin x="-2634" y="165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5/10/relationships/revisionInfo" Target="revisionInfo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D:\170312%20Fig.4%20revised_yf.xlsx" TargetMode="External"/><Relationship Id="rId1" Type="http://schemas.openxmlformats.org/officeDocument/2006/relationships/themeOverride" Target="../theme/themeOverride1.xml"/></Relationships>
</file>

<file path=ppt/charts/_rels/chart10.xml.rels><?xml version="1.0" encoding="UTF-8" standalone="yes"?>
<Relationships xmlns="http://schemas.openxmlformats.org/package/2006/relationships"><Relationship Id="rId2" Type="http://schemas.openxmlformats.org/officeDocument/2006/relationships/oleObject" Target="file:///D:\170312%20Fig.4%20revised_yf.xlsx" TargetMode="External"/><Relationship Id="rId1" Type="http://schemas.openxmlformats.org/officeDocument/2006/relationships/themeOverride" Target="../theme/themeOverride10.xml"/></Relationships>
</file>

<file path=ppt/charts/_rels/chart1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nakajima\Desktop\170524%20Fig.S3%20raw%20data.xlsx" TargetMode="External"/><Relationship Id="rId1" Type="http://schemas.openxmlformats.org/officeDocument/2006/relationships/themeOverride" Target="../theme/themeOverride11.xml"/></Relationships>
</file>

<file path=ppt/charts/_rels/chart1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nakajima\Desktop\170524%20Fig.S3%20raw%20data.xlsx" TargetMode="External"/><Relationship Id="rId1" Type="http://schemas.openxmlformats.org/officeDocument/2006/relationships/themeOverride" Target="../theme/themeOverride12.xml"/></Relationships>
</file>

<file path=ppt/charts/_rels/chart1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nakajima\Desktop\170524%20Fig.S3%20raw%20data.xlsx" TargetMode="External"/><Relationship Id="rId1" Type="http://schemas.openxmlformats.org/officeDocument/2006/relationships/themeOverride" Target="../theme/themeOverride13.xml"/></Relationships>
</file>

<file path=ppt/charts/_rels/chart1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nakajima\Desktop\170524%20Fig.S3%20raw%20data.xlsx" TargetMode="External"/><Relationship Id="rId1" Type="http://schemas.openxmlformats.org/officeDocument/2006/relationships/themeOverride" Target="../theme/themeOverride14.xml"/></Relationships>
</file>

<file path=ppt/charts/_rels/chart15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nakajima\Desktop\170524%20Fig.S3%20raw%20data.xlsx" TargetMode="External"/><Relationship Id="rId1" Type="http://schemas.openxmlformats.org/officeDocument/2006/relationships/themeOverride" Target="../theme/themeOverride15.xml"/></Relationships>
</file>

<file path=ppt/charts/_rels/chart16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nakajima\Desktop\170524%20Fig.S3%20raw%20data.xlsx" TargetMode="External"/><Relationship Id="rId1" Type="http://schemas.openxmlformats.org/officeDocument/2006/relationships/themeOverride" Target="../theme/themeOverride16.xml"/></Relationships>
</file>

<file path=ppt/charts/_rels/chart17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nakajima\Desktop\170524%20Fig.S3%20raw%20data.xlsx" TargetMode="External"/><Relationship Id="rId1" Type="http://schemas.openxmlformats.org/officeDocument/2006/relationships/themeOverride" Target="../theme/themeOverride17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D:\170312%20Fig.4%20revised_yf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D:\170312%20Fig.4%20revised_yf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D:\170312%20Fig.4%20revised_yf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D:\170312%20Fig.4%20revised_yf.xlsx" TargetMode="External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oleObject" Target="file:///D:\170312%20Fig.4%20revised_yf.xlsx" TargetMode="External"/><Relationship Id="rId1" Type="http://schemas.openxmlformats.org/officeDocument/2006/relationships/themeOverride" Target="../theme/themeOverride6.xm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oleObject" Target="file:///D:\170312%20Fig.4%20revised_yf.xlsx" TargetMode="External"/><Relationship Id="rId1" Type="http://schemas.openxmlformats.org/officeDocument/2006/relationships/themeOverride" Target="../theme/themeOverride7.xm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oleObject" Target="file:///D:\170312%20Fig.4%20revised_yf.xlsx" TargetMode="External"/><Relationship Id="rId1" Type="http://schemas.openxmlformats.org/officeDocument/2006/relationships/themeOverride" Target="../theme/themeOverride8.xm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oleObject" Target="file:///D:\170312%20Fig.4%20revised_yf.xlsx" TargetMode="External"/><Relationship Id="rId1" Type="http://schemas.openxmlformats.org/officeDocument/2006/relationships/themeOverride" Target="../theme/themeOverrid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676918889819596"/>
          <c:y val="7.7828830394782861E-2"/>
          <c:w val="0.72844125955808425"/>
          <c:h val="0.74162361283594025"/>
        </c:manualLayout>
      </c:layout>
      <c:scatterChart>
        <c:scatterStyle val="lineMarker"/>
        <c:varyColors val="0"/>
        <c:ser>
          <c:idx val="0"/>
          <c:order val="0"/>
          <c:tx>
            <c:v>25</c:v>
          </c:tx>
          <c:spPr>
            <a:ln w="15875">
              <a:solidFill>
                <a:srgbClr val="1F497D"/>
              </a:solidFill>
            </a:ln>
          </c:spPr>
          <c:marker>
            <c:symbol val="circle"/>
            <c:size val="4"/>
            <c:spPr>
              <a:solidFill>
                <a:srgbClr val="1F497D"/>
              </a:solidFill>
              <a:ln w="952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AE$75:$AE$79</c:f>
                <c:numCache>
                  <c:formatCode>General</c:formatCode>
                  <c:ptCount val="5"/>
                  <c:pt idx="0">
                    <c:v>35.596293537794431</c:v>
                  </c:pt>
                  <c:pt idx="1">
                    <c:v>26.326766705159308</c:v>
                  </c:pt>
                  <c:pt idx="2">
                    <c:v>9.0536632464999727</c:v>
                  </c:pt>
                  <c:pt idx="3">
                    <c:v>5.2423126432182512</c:v>
                  </c:pt>
                  <c:pt idx="4">
                    <c:v>0.4428795242505163</c:v>
                  </c:pt>
                </c:numCache>
              </c:numRef>
            </c:plus>
            <c:minus>
              <c:numRef>
                <c:f>APAP!$AE$75:$AE$79</c:f>
                <c:numCache>
                  <c:formatCode>General</c:formatCode>
                  <c:ptCount val="5"/>
                  <c:pt idx="0">
                    <c:v>35.596293537794431</c:v>
                  </c:pt>
                  <c:pt idx="1">
                    <c:v>26.326766705159308</c:v>
                  </c:pt>
                  <c:pt idx="2">
                    <c:v>9.0536632464999727</c:v>
                  </c:pt>
                  <c:pt idx="3">
                    <c:v>5.2423126432182512</c:v>
                  </c:pt>
                  <c:pt idx="4">
                    <c:v>0.4428795242505163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AE$42:$AE$46</c:f>
              <c:numCache>
                <c:formatCode>General</c:formatCode>
                <c:ptCount val="5"/>
                <c:pt idx="0">
                  <c:v>119.48072065201849</c:v>
                </c:pt>
                <c:pt idx="1">
                  <c:v>47.028263667127405</c:v>
                </c:pt>
                <c:pt idx="2">
                  <c:v>26.829631571421764</c:v>
                </c:pt>
                <c:pt idx="3">
                  <c:v>9.4990705876745629</c:v>
                </c:pt>
                <c:pt idx="4">
                  <c:v>0.5248796530193985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4F81-4F1D-96BE-B92CC99D8C74}"/>
            </c:ext>
          </c:extLst>
        </c:ser>
        <c:ser>
          <c:idx val="1"/>
          <c:order val="1"/>
          <c:tx>
            <c:v>26</c:v>
          </c:tx>
          <c:spPr>
            <a:ln w="1587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AF$75:$AF$79</c:f>
                <c:numCache>
                  <c:formatCode>General</c:formatCode>
                  <c:ptCount val="5"/>
                  <c:pt idx="0">
                    <c:v>39.037100474230002</c:v>
                  </c:pt>
                  <c:pt idx="1">
                    <c:v>23.512937048898422</c:v>
                  </c:pt>
                  <c:pt idx="2">
                    <c:v>8.3325369271222804</c:v>
                  </c:pt>
                  <c:pt idx="3">
                    <c:v>4.3137755800895796</c:v>
                  </c:pt>
                  <c:pt idx="4">
                    <c:v>0.20543228158720181</c:v>
                  </c:pt>
                </c:numCache>
              </c:numRef>
            </c:plus>
            <c:minus>
              <c:numRef>
                <c:f>APAP!$AF$75:$AF$79</c:f>
                <c:numCache>
                  <c:formatCode>General</c:formatCode>
                  <c:ptCount val="5"/>
                  <c:pt idx="0">
                    <c:v>39.037100474230002</c:v>
                  </c:pt>
                  <c:pt idx="1">
                    <c:v>23.512937048898422</c:v>
                  </c:pt>
                  <c:pt idx="2">
                    <c:v>8.3325369271222804</c:v>
                  </c:pt>
                  <c:pt idx="3">
                    <c:v>4.3137755800895796</c:v>
                  </c:pt>
                  <c:pt idx="4">
                    <c:v>0.20543228158720181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AF$42:$AF$46</c:f>
              <c:numCache>
                <c:formatCode>General</c:formatCode>
                <c:ptCount val="5"/>
                <c:pt idx="0">
                  <c:v>116.4277485032202</c:v>
                </c:pt>
                <c:pt idx="1">
                  <c:v>42.241612681864254</c:v>
                </c:pt>
                <c:pt idx="2">
                  <c:v>24.291587184668945</c:v>
                </c:pt>
                <c:pt idx="3">
                  <c:v>8.2428340289975512</c:v>
                </c:pt>
                <c:pt idx="4">
                  <c:v>0.3053367833242047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4F81-4F1D-96BE-B92CC99D8C74}"/>
            </c:ext>
          </c:extLst>
        </c:ser>
        <c:ser>
          <c:idx val="2"/>
          <c:order val="2"/>
          <c:tx>
            <c:v>27</c:v>
          </c:tx>
          <c:spPr>
            <a:ln w="15875">
              <a:solidFill>
                <a:srgbClr val="C0504D"/>
              </a:solidFill>
            </a:ln>
          </c:spPr>
          <c:marker>
            <c:symbol val="circle"/>
            <c:size val="4"/>
            <c:spPr>
              <a:solidFill>
                <a:srgbClr val="C0504D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AG$75:$AG$79</c:f>
                <c:numCache>
                  <c:formatCode>General</c:formatCode>
                  <c:ptCount val="5"/>
                  <c:pt idx="0">
                    <c:v>37.833722865859436</c:v>
                  </c:pt>
                  <c:pt idx="1">
                    <c:v>25.186874219607756</c:v>
                  </c:pt>
                  <c:pt idx="2">
                    <c:v>8.1256866402233427</c:v>
                  </c:pt>
                  <c:pt idx="3">
                    <c:v>4.694452238941718</c:v>
                  </c:pt>
                  <c:pt idx="4">
                    <c:v>9.6073946660316836E-2</c:v>
                  </c:pt>
                </c:numCache>
              </c:numRef>
            </c:plus>
            <c:minus>
              <c:numRef>
                <c:f>APAP!$AG$75:$AG$79</c:f>
                <c:numCache>
                  <c:formatCode>General</c:formatCode>
                  <c:ptCount val="5"/>
                  <c:pt idx="0">
                    <c:v>37.833722865859436</c:v>
                  </c:pt>
                  <c:pt idx="1">
                    <c:v>25.186874219607756</c:v>
                  </c:pt>
                  <c:pt idx="2">
                    <c:v>8.1256866402233427</c:v>
                  </c:pt>
                  <c:pt idx="3">
                    <c:v>4.694452238941718</c:v>
                  </c:pt>
                  <c:pt idx="4">
                    <c:v>9.6073946660316836E-2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AG$42:$AG$46</c:f>
              <c:numCache>
                <c:formatCode>General</c:formatCode>
                <c:ptCount val="5"/>
                <c:pt idx="0">
                  <c:v>126.21441477915982</c:v>
                </c:pt>
                <c:pt idx="1">
                  <c:v>44.144042825974495</c:v>
                </c:pt>
                <c:pt idx="2">
                  <c:v>23.410333115904542</c:v>
                </c:pt>
                <c:pt idx="3">
                  <c:v>8.1588279838352946</c:v>
                </c:pt>
                <c:pt idx="4">
                  <c:v>0.195685912863537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4F81-4F1D-96BE-B92CC99D8C74}"/>
            </c:ext>
          </c:extLst>
        </c:ser>
        <c:ser>
          <c:idx val="3"/>
          <c:order val="3"/>
          <c:tx>
            <c:v>28</c:v>
          </c:tx>
          <c:spPr>
            <a:ln w="15875">
              <a:solidFill>
                <a:srgbClr val="F79646"/>
              </a:solidFill>
            </a:ln>
          </c:spPr>
          <c:marker>
            <c:symbol val="circle"/>
            <c:size val="4"/>
            <c:spPr>
              <a:solidFill>
                <a:srgbClr val="F79646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AH$75:$AH$79</c:f>
                <c:numCache>
                  <c:formatCode>General</c:formatCode>
                  <c:ptCount val="5"/>
                  <c:pt idx="0">
                    <c:v>34.384420035687924</c:v>
                  </c:pt>
                  <c:pt idx="1">
                    <c:v>25.321244836990669</c:v>
                  </c:pt>
                  <c:pt idx="2">
                    <c:v>8.5587250943981275</c:v>
                  </c:pt>
                  <c:pt idx="3">
                    <c:v>3.4302408965144964</c:v>
                  </c:pt>
                  <c:pt idx="4">
                    <c:v>4.0133680755680308E-2</c:v>
                  </c:pt>
                </c:numCache>
              </c:numRef>
            </c:plus>
            <c:minus>
              <c:numRef>
                <c:f>APAP!$AH$75:$AH$79</c:f>
                <c:numCache>
                  <c:formatCode>General</c:formatCode>
                  <c:ptCount val="5"/>
                  <c:pt idx="0">
                    <c:v>34.384420035687924</c:v>
                  </c:pt>
                  <c:pt idx="1">
                    <c:v>25.321244836990669</c:v>
                  </c:pt>
                  <c:pt idx="2">
                    <c:v>8.5587250943981275</c:v>
                  </c:pt>
                  <c:pt idx="3">
                    <c:v>3.4302408965144964</c:v>
                  </c:pt>
                  <c:pt idx="4">
                    <c:v>4.0133680755680308E-2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AH$42:$AH$46</c:f>
              <c:numCache>
                <c:formatCode>General</c:formatCode>
                <c:ptCount val="5"/>
                <c:pt idx="0">
                  <c:v>139.92683687648289</c:v>
                </c:pt>
                <c:pt idx="1">
                  <c:v>46.650471212106901</c:v>
                </c:pt>
                <c:pt idx="2">
                  <c:v>24.123035040787968</c:v>
                </c:pt>
                <c:pt idx="3">
                  <c:v>7.9089903678006639</c:v>
                </c:pt>
                <c:pt idx="4">
                  <c:v>0.238205518427843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4F81-4F1D-96BE-B92CC99D8C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130368"/>
        <c:axId val="31131904"/>
      </c:scatterChart>
      <c:valAx>
        <c:axId val="31130368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31131904"/>
        <c:crosses val="autoZero"/>
        <c:crossBetween val="midCat"/>
      </c:valAx>
      <c:valAx>
        <c:axId val="31131904"/>
        <c:scaling>
          <c:orientation val="minMax"/>
          <c:max val="200"/>
          <c:min val="0"/>
        </c:scaling>
        <c:delete val="0"/>
        <c:axPos val="l"/>
        <c:majorGridlines>
          <c:spPr>
            <a:ln w="6350">
              <a:solidFill>
                <a:sysClr val="windowText" lastClr="000000"/>
              </a:solidFill>
              <a:prstDash val="sysDot"/>
            </a:ln>
          </c:spPr>
        </c:majorGridlines>
        <c:minorGridlines>
          <c:spPr>
            <a:ln>
              <a:solidFill>
                <a:sysClr val="windowText" lastClr="000000"/>
              </a:solidFill>
              <a:prstDash val="sysDot"/>
            </a:ln>
          </c:spPr>
        </c:minorGridlines>
        <c:numFmt formatCode="General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31130368"/>
        <c:crossesAt val="0.1"/>
        <c:crossBetween val="midCat"/>
        <c:majorUnit val="100"/>
        <c:minorUnit val="50"/>
      </c:valAx>
      <c:spPr>
        <a:noFill/>
      </c:spPr>
    </c:plotArea>
    <c:legend>
      <c:legendPos val="r"/>
      <c:layout>
        <c:manualLayout>
          <c:xMode val="edge"/>
          <c:yMode val="edge"/>
          <c:x val="0.63351969980560141"/>
          <c:y val="8.3355555555555558E-2"/>
          <c:w val="0.27121394158566914"/>
          <c:h val="0.23730972222222221"/>
        </c:manualLayout>
      </c:layout>
      <c:overlay val="0"/>
      <c:spPr>
        <a:noFill/>
      </c:spPr>
      <c:txPr>
        <a:bodyPr/>
        <a:lstStyle/>
        <a:p>
          <a:pPr>
            <a:defRPr sz="600">
              <a:latin typeface="+mn-lt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676918889819596"/>
          <c:y val="7.7828830394782861E-2"/>
          <c:w val="0.72844125955808425"/>
          <c:h val="0.74162361283594025"/>
        </c:manualLayout>
      </c:layout>
      <c:scatterChart>
        <c:scatterStyle val="lineMarker"/>
        <c:varyColors val="0"/>
        <c:ser>
          <c:idx val="0"/>
          <c:order val="0"/>
          <c:tx>
            <c:v>9</c:v>
          </c:tx>
          <c:spPr>
            <a:ln w="15875">
              <a:solidFill>
                <a:srgbClr val="1F497D"/>
              </a:solidFill>
            </a:ln>
          </c:spPr>
          <c:marker>
            <c:symbol val="circle"/>
            <c:size val="4"/>
            <c:spPr>
              <a:solidFill>
                <a:srgbClr val="1F497D"/>
              </a:solidFill>
              <a:ln w="952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FB1'!$O$75:$O$79</c:f>
                <c:numCache>
                  <c:formatCode>General</c:formatCode>
                  <c:ptCount val="5"/>
                  <c:pt idx="0">
                    <c:v>2.2089565364885755</c:v>
                  </c:pt>
                  <c:pt idx="1">
                    <c:v>0.93972468412225152</c:v>
                  </c:pt>
                  <c:pt idx="2">
                    <c:v>0.52219440876630396</c:v>
                  </c:pt>
                  <c:pt idx="3">
                    <c:v>0.35310807312089626</c:v>
                  </c:pt>
                  <c:pt idx="4">
                    <c:v>5.9508255263657182E-2</c:v>
                  </c:pt>
                </c:numCache>
              </c:numRef>
            </c:plus>
            <c:minus>
              <c:numRef>
                <c:f>'AFB1'!$O$75:$O$79</c:f>
                <c:numCache>
                  <c:formatCode>General</c:formatCode>
                  <c:ptCount val="5"/>
                  <c:pt idx="0">
                    <c:v>2.2089565364885755</c:v>
                  </c:pt>
                  <c:pt idx="1">
                    <c:v>0.93972468412225152</c:v>
                  </c:pt>
                  <c:pt idx="2">
                    <c:v>0.52219440876630396</c:v>
                  </c:pt>
                  <c:pt idx="3">
                    <c:v>0.35310807312089626</c:v>
                  </c:pt>
                  <c:pt idx="4">
                    <c:v>5.9508255263657182E-2</c:v>
                  </c:pt>
                </c:numCache>
              </c:numRef>
            </c:minus>
          </c:errBars>
          <c:xVal>
            <c:numRef>
              <c:f>'AFB1'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'AFB1'!$O$42:$O$46</c:f>
              <c:numCache>
                <c:formatCode>0</c:formatCode>
                <c:ptCount val="5"/>
                <c:pt idx="0">
                  <c:v>12.105598716281802</c:v>
                </c:pt>
                <c:pt idx="1">
                  <c:v>4.9955406552550423</c:v>
                </c:pt>
                <c:pt idx="2">
                  <c:v>3.0106845183728588</c:v>
                </c:pt>
                <c:pt idx="3">
                  <c:v>1.1298797588730214</c:v>
                </c:pt>
                <c:pt idx="4">
                  <c:v>0.2256535895038844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698A-464D-9C41-768A2822B1B2}"/>
            </c:ext>
          </c:extLst>
        </c:ser>
        <c:ser>
          <c:idx val="1"/>
          <c:order val="1"/>
          <c:tx>
            <c:v>10</c:v>
          </c:tx>
          <c:spPr>
            <a:ln w="1587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FB1'!$P$75:$P$79</c:f>
                <c:numCache>
                  <c:formatCode>General</c:formatCode>
                  <c:ptCount val="5"/>
                  <c:pt idx="0">
                    <c:v>2.1961220465142728</c:v>
                  </c:pt>
                  <c:pt idx="1">
                    <c:v>0.51215703590522565</c:v>
                  </c:pt>
                  <c:pt idx="2">
                    <c:v>0.53950404489695736</c:v>
                  </c:pt>
                  <c:pt idx="3">
                    <c:v>0.16765723044847883</c:v>
                  </c:pt>
                  <c:pt idx="4">
                    <c:v>5.0538275739656455E-2</c:v>
                  </c:pt>
                </c:numCache>
              </c:numRef>
            </c:plus>
            <c:minus>
              <c:numRef>
                <c:f>'AFB1'!$P$75:$P$79</c:f>
                <c:numCache>
                  <c:formatCode>General</c:formatCode>
                  <c:ptCount val="5"/>
                  <c:pt idx="0">
                    <c:v>2.1961220465142728</c:v>
                  </c:pt>
                  <c:pt idx="1">
                    <c:v>0.51215703590522565</c:v>
                  </c:pt>
                  <c:pt idx="2">
                    <c:v>0.53950404489695736</c:v>
                  </c:pt>
                  <c:pt idx="3">
                    <c:v>0.16765723044847883</c:v>
                  </c:pt>
                  <c:pt idx="4">
                    <c:v>5.0538275739656455E-2</c:v>
                  </c:pt>
                </c:numCache>
              </c:numRef>
            </c:minus>
          </c:errBars>
          <c:xVal>
            <c:numRef>
              <c:f>'AFB1'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'AFB1'!$P$42:$P$46</c:f>
              <c:numCache>
                <c:formatCode>0</c:formatCode>
                <c:ptCount val="5"/>
                <c:pt idx="0">
                  <c:v>7.8907856093979429</c:v>
                </c:pt>
                <c:pt idx="1">
                  <c:v>2.3080029368575623</c:v>
                </c:pt>
                <c:pt idx="2">
                  <c:v>0.97687224669603534</c:v>
                </c:pt>
                <c:pt idx="3">
                  <c:v>0.44787077826725408</c:v>
                </c:pt>
                <c:pt idx="4">
                  <c:v>0.2026431718061673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698A-464D-9C41-768A2822B1B2}"/>
            </c:ext>
          </c:extLst>
        </c:ser>
        <c:ser>
          <c:idx val="2"/>
          <c:order val="2"/>
          <c:tx>
            <c:v>11</c:v>
          </c:tx>
          <c:spPr>
            <a:ln w="15875">
              <a:solidFill>
                <a:srgbClr val="C0504D"/>
              </a:solidFill>
            </a:ln>
          </c:spPr>
          <c:marker>
            <c:symbol val="circle"/>
            <c:size val="4"/>
            <c:spPr>
              <a:solidFill>
                <a:srgbClr val="C0504D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FB1'!$Q$75:$Q$79</c:f>
                <c:numCache>
                  <c:formatCode>General</c:formatCode>
                  <c:ptCount val="5"/>
                  <c:pt idx="0">
                    <c:v>2.346744243957982</c:v>
                  </c:pt>
                  <c:pt idx="1">
                    <c:v>0.43288873736422084</c:v>
                  </c:pt>
                  <c:pt idx="2">
                    <c:v>0.33288395175653546</c:v>
                  </c:pt>
                  <c:pt idx="3">
                    <c:v>0.17092297196386561</c:v>
                  </c:pt>
                  <c:pt idx="4">
                    <c:v>3.7977907072186977E-2</c:v>
                  </c:pt>
                </c:numCache>
              </c:numRef>
            </c:plus>
            <c:minus>
              <c:numRef>
                <c:f>'AFB1'!$Q$75:$Q$79</c:f>
                <c:numCache>
                  <c:formatCode>General</c:formatCode>
                  <c:ptCount val="5"/>
                  <c:pt idx="0">
                    <c:v>2.346744243957982</c:v>
                  </c:pt>
                  <c:pt idx="1">
                    <c:v>0.43288873736422084</c:v>
                  </c:pt>
                  <c:pt idx="2">
                    <c:v>0.33288395175653546</c:v>
                  </c:pt>
                  <c:pt idx="3">
                    <c:v>0.17092297196386561</c:v>
                  </c:pt>
                  <c:pt idx="4">
                    <c:v>3.7977907072186977E-2</c:v>
                  </c:pt>
                </c:numCache>
              </c:numRef>
            </c:minus>
          </c:errBars>
          <c:xVal>
            <c:numRef>
              <c:f>'AFB1'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'AFB1'!$Q$42:$Q$46</c:f>
              <c:numCache>
                <c:formatCode>0</c:formatCode>
                <c:ptCount val="5"/>
                <c:pt idx="0">
                  <c:v>6.8975527153973317</c:v>
                </c:pt>
                <c:pt idx="1">
                  <c:v>1.7868806192799256</c:v>
                </c:pt>
                <c:pt idx="2">
                  <c:v>0.63137523686650809</c:v>
                </c:pt>
                <c:pt idx="3">
                  <c:v>0.38624359956456872</c:v>
                </c:pt>
                <c:pt idx="4">
                  <c:v>0.2013869290005241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698A-464D-9C41-768A2822B1B2}"/>
            </c:ext>
          </c:extLst>
        </c:ser>
        <c:ser>
          <c:idx val="3"/>
          <c:order val="3"/>
          <c:tx>
            <c:v>12</c:v>
          </c:tx>
          <c:spPr>
            <a:ln w="15875">
              <a:solidFill>
                <a:srgbClr val="F79646"/>
              </a:solidFill>
            </a:ln>
          </c:spPr>
          <c:marker>
            <c:symbol val="circle"/>
            <c:size val="4"/>
            <c:spPr>
              <a:solidFill>
                <a:srgbClr val="F79646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FB1'!$R$75:$R$79</c:f>
                <c:numCache>
                  <c:formatCode>General</c:formatCode>
                  <c:ptCount val="5"/>
                  <c:pt idx="0">
                    <c:v>1.7480900154313161</c:v>
                  </c:pt>
                  <c:pt idx="1">
                    <c:v>0.38714162458024376</c:v>
                  </c:pt>
                  <c:pt idx="2">
                    <c:v>0.30503682821663358</c:v>
                  </c:pt>
                  <c:pt idx="3">
                    <c:v>0.12280495375294379</c:v>
                  </c:pt>
                  <c:pt idx="4">
                    <c:v>3.8954080847155216E-2</c:v>
                  </c:pt>
                </c:numCache>
              </c:numRef>
            </c:plus>
            <c:minus>
              <c:numRef>
                <c:f>'AFB1'!$R$75:$R$79</c:f>
                <c:numCache>
                  <c:formatCode>General</c:formatCode>
                  <c:ptCount val="5"/>
                  <c:pt idx="0">
                    <c:v>1.7480900154313161</c:v>
                  </c:pt>
                  <c:pt idx="1">
                    <c:v>0.38714162458024376</c:v>
                  </c:pt>
                  <c:pt idx="2">
                    <c:v>0.30503682821663358</c:v>
                  </c:pt>
                  <c:pt idx="3">
                    <c:v>0.12280495375294379</c:v>
                  </c:pt>
                  <c:pt idx="4">
                    <c:v>3.8954080847155216E-2</c:v>
                  </c:pt>
                </c:numCache>
              </c:numRef>
            </c:minus>
          </c:errBars>
          <c:xVal>
            <c:numRef>
              <c:f>'AFB1'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'AFB1'!$R$42:$R$46</c:f>
              <c:numCache>
                <c:formatCode>0</c:formatCode>
                <c:ptCount val="5"/>
                <c:pt idx="0">
                  <c:v>5.3580046078645038</c:v>
                </c:pt>
                <c:pt idx="1">
                  <c:v>1.2953781250972942</c:v>
                </c:pt>
                <c:pt idx="2">
                  <c:v>0.55866465332046455</c:v>
                </c:pt>
                <c:pt idx="3">
                  <c:v>0.31620691802359974</c:v>
                </c:pt>
                <c:pt idx="4">
                  <c:v>0.1844702512531523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698A-464D-9C41-768A2822B1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2343552"/>
        <c:axId val="146588800"/>
      </c:scatterChart>
      <c:valAx>
        <c:axId val="142343552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146588800"/>
        <c:crosses val="autoZero"/>
        <c:crossBetween val="midCat"/>
      </c:valAx>
      <c:valAx>
        <c:axId val="146588800"/>
        <c:scaling>
          <c:orientation val="minMax"/>
          <c:max val="100"/>
          <c:min val="0"/>
        </c:scaling>
        <c:delete val="0"/>
        <c:axPos val="l"/>
        <c:majorGridlines>
          <c:spPr>
            <a:ln w="9525">
              <a:solidFill>
                <a:sysClr val="windowText" lastClr="000000"/>
              </a:solidFill>
              <a:prstDash val="sysDot"/>
            </a:ln>
          </c:spPr>
        </c:majorGridlines>
        <c:minorGridlines>
          <c:spPr>
            <a:ln w="6350">
              <a:solidFill>
                <a:sysClr val="windowText" lastClr="000000"/>
              </a:solidFill>
              <a:prstDash val="sysDot"/>
            </a:ln>
          </c:spPr>
        </c:minorGridlines>
        <c:numFmt formatCode="0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42343552"/>
        <c:crossesAt val="0.1"/>
        <c:crossBetween val="midCat"/>
        <c:majorUnit val="50"/>
        <c:minorUnit val="50"/>
      </c:valAx>
      <c:spPr>
        <a:noFill/>
      </c:spPr>
    </c:plotArea>
    <c:legend>
      <c:legendPos val="r"/>
      <c:layout>
        <c:manualLayout>
          <c:xMode val="edge"/>
          <c:yMode val="edge"/>
          <c:x val="0.63853953287160137"/>
          <c:y val="3.9805555555555523E-3"/>
          <c:w val="0.2791003694135259"/>
          <c:h val="0.23730972222222221"/>
        </c:manualLayout>
      </c:layout>
      <c:overlay val="0"/>
      <c:spPr>
        <a:solidFill>
          <a:sysClr val="window" lastClr="FFFFFF"/>
        </a:solidFill>
      </c:spPr>
      <c:txPr>
        <a:bodyPr/>
        <a:lstStyle/>
        <a:p>
          <a:pPr>
            <a:defRPr sz="600">
              <a:latin typeface="+mn-lt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0469847321583839"/>
          <c:y val="8.6648611111111107E-2"/>
          <c:w val="0.72844125955808425"/>
          <c:h val="0.74162361283594025"/>
        </c:manualLayout>
      </c:layout>
      <c:scatterChart>
        <c:scatterStyle val="lineMarker"/>
        <c:varyColors val="0"/>
        <c:ser>
          <c:idx val="0"/>
          <c:order val="0"/>
          <c:tx>
            <c:v>1</c:v>
          </c:tx>
          <c:spPr>
            <a:ln w="15875">
              <a:solidFill>
                <a:srgbClr val="1F497D"/>
              </a:solidFill>
            </a:ln>
          </c:spPr>
          <c:marker>
            <c:symbol val="circle"/>
            <c:size val="4"/>
            <c:spPr>
              <a:solidFill>
                <a:srgbClr val="1F497D"/>
              </a:solidFill>
              <a:ln w="952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G$75:$G$79</c:f>
                <c:numCache>
                  <c:formatCode>General</c:formatCode>
                  <c:ptCount val="5"/>
                  <c:pt idx="0">
                    <c:v>4.410945043937657</c:v>
                  </c:pt>
                  <c:pt idx="1">
                    <c:v>0.92357194305612389</c:v>
                  </c:pt>
                  <c:pt idx="2">
                    <c:v>4.6260059973919443</c:v>
                  </c:pt>
                  <c:pt idx="3">
                    <c:v>6.6905200385189589</c:v>
                  </c:pt>
                  <c:pt idx="4">
                    <c:v>6.5792544725346582</c:v>
                  </c:pt>
                </c:numCache>
              </c:numRef>
            </c:plus>
            <c:minus>
              <c:numRef>
                <c:f>MCA!$G$75:$G$79</c:f>
                <c:numCache>
                  <c:formatCode>General</c:formatCode>
                  <c:ptCount val="5"/>
                  <c:pt idx="0">
                    <c:v>4.410945043937657</c:v>
                  </c:pt>
                  <c:pt idx="1">
                    <c:v>0.92357194305612389</c:v>
                  </c:pt>
                  <c:pt idx="2">
                    <c:v>4.6260059973919443</c:v>
                  </c:pt>
                  <c:pt idx="3">
                    <c:v>6.6905200385189589</c:v>
                  </c:pt>
                  <c:pt idx="4">
                    <c:v>6.5792544725346582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G$42:$G$46</c:f>
              <c:numCache>
                <c:formatCode>0</c:formatCode>
                <c:ptCount val="5"/>
                <c:pt idx="0">
                  <c:v>94.478471314201812</c:v>
                </c:pt>
                <c:pt idx="1">
                  <c:v>83.995136833895359</c:v>
                </c:pt>
                <c:pt idx="2">
                  <c:v>91.469674030234216</c:v>
                </c:pt>
                <c:pt idx="3">
                  <c:v>95.863154634918445</c:v>
                </c:pt>
                <c:pt idx="4">
                  <c:v>77.62370105292134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67B-47B8-B40E-7440DBC52B69}"/>
            </c:ext>
          </c:extLst>
        </c:ser>
        <c:ser>
          <c:idx val="1"/>
          <c:order val="1"/>
          <c:tx>
            <c:v>2</c:v>
          </c:tx>
          <c:spPr>
            <a:ln w="1587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H$75:$H$79</c:f>
                <c:numCache>
                  <c:formatCode>General</c:formatCode>
                  <c:ptCount val="5"/>
                  <c:pt idx="0">
                    <c:v>11.630944872510735</c:v>
                  </c:pt>
                  <c:pt idx="1">
                    <c:v>4.6678768520945004</c:v>
                  </c:pt>
                  <c:pt idx="2">
                    <c:v>5.2101296545406184</c:v>
                  </c:pt>
                  <c:pt idx="3">
                    <c:v>7.2094076123284419</c:v>
                  </c:pt>
                  <c:pt idx="4">
                    <c:v>3.7974951299568924</c:v>
                  </c:pt>
                </c:numCache>
              </c:numRef>
            </c:plus>
            <c:minus>
              <c:numRef>
                <c:f>MCA!$H$75:$H$79</c:f>
                <c:numCache>
                  <c:formatCode>General</c:formatCode>
                  <c:ptCount val="5"/>
                  <c:pt idx="0">
                    <c:v>11.630944872510735</c:v>
                  </c:pt>
                  <c:pt idx="1">
                    <c:v>4.6678768520945004</c:v>
                  </c:pt>
                  <c:pt idx="2">
                    <c:v>5.2101296545406184</c:v>
                  </c:pt>
                  <c:pt idx="3">
                    <c:v>7.2094076123284419</c:v>
                  </c:pt>
                  <c:pt idx="4">
                    <c:v>3.7974951299568924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H$42:$H$46</c:f>
              <c:numCache>
                <c:formatCode>0</c:formatCode>
                <c:ptCount val="5"/>
                <c:pt idx="0">
                  <c:v>88.081014976444933</c:v>
                </c:pt>
                <c:pt idx="1">
                  <c:v>81.503026213798876</c:v>
                </c:pt>
                <c:pt idx="2">
                  <c:v>82.869742279841432</c:v>
                </c:pt>
                <c:pt idx="3">
                  <c:v>86.786751328361262</c:v>
                </c:pt>
                <c:pt idx="4">
                  <c:v>78.25246695663697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E67B-47B8-B40E-7440DBC52B69}"/>
            </c:ext>
          </c:extLst>
        </c:ser>
        <c:ser>
          <c:idx val="2"/>
          <c:order val="2"/>
          <c:tx>
            <c:v>3</c:v>
          </c:tx>
          <c:spPr>
            <a:ln w="15875">
              <a:solidFill>
                <a:srgbClr val="C0504D"/>
              </a:solidFill>
            </a:ln>
          </c:spPr>
          <c:marker>
            <c:symbol val="circle"/>
            <c:size val="4"/>
            <c:spPr>
              <a:solidFill>
                <a:srgbClr val="C0504D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I$75:$I$79</c:f>
                <c:numCache>
                  <c:formatCode>General</c:formatCode>
                  <c:ptCount val="5"/>
                  <c:pt idx="0">
                    <c:v>7.220187677061964</c:v>
                  </c:pt>
                  <c:pt idx="1">
                    <c:v>1.4950010361376871</c:v>
                  </c:pt>
                  <c:pt idx="2">
                    <c:v>2.8479119885596642</c:v>
                  </c:pt>
                  <c:pt idx="3">
                    <c:v>4.2299252429826932</c:v>
                  </c:pt>
                  <c:pt idx="4">
                    <c:v>3.1460622569111889</c:v>
                  </c:pt>
                </c:numCache>
              </c:numRef>
            </c:plus>
            <c:minus>
              <c:numRef>
                <c:f>MCA!$I$75:$I$79</c:f>
                <c:numCache>
                  <c:formatCode>General</c:formatCode>
                  <c:ptCount val="5"/>
                  <c:pt idx="0">
                    <c:v>7.220187677061964</c:v>
                  </c:pt>
                  <c:pt idx="1">
                    <c:v>1.4950010361376871</c:v>
                  </c:pt>
                  <c:pt idx="2">
                    <c:v>2.8479119885596642</c:v>
                  </c:pt>
                  <c:pt idx="3">
                    <c:v>4.2299252429826932</c:v>
                  </c:pt>
                  <c:pt idx="4">
                    <c:v>3.1460622569111889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I$42:$I$46</c:f>
              <c:numCache>
                <c:formatCode>0</c:formatCode>
                <c:ptCount val="5"/>
                <c:pt idx="0">
                  <c:v>83.56811142590908</c:v>
                </c:pt>
                <c:pt idx="1">
                  <c:v>75.991645068842672</c:v>
                </c:pt>
                <c:pt idx="2">
                  <c:v>74.903328517049999</c:v>
                </c:pt>
                <c:pt idx="3">
                  <c:v>77.778008322235749</c:v>
                </c:pt>
                <c:pt idx="4">
                  <c:v>64.77460925858159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E67B-47B8-B40E-7440DBC52B69}"/>
            </c:ext>
          </c:extLst>
        </c:ser>
        <c:ser>
          <c:idx val="3"/>
          <c:order val="3"/>
          <c:tx>
            <c:v>4</c:v>
          </c:tx>
          <c:spPr>
            <a:ln w="15875">
              <a:solidFill>
                <a:srgbClr val="F79646"/>
              </a:solidFill>
            </a:ln>
          </c:spPr>
          <c:marker>
            <c:symbol val="circle"/>
            <c:size val="4"/>
            <c:spPr>
              <a:solidFill>
                <a:srgbClr val="F79646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J$75:$J$79</c:f>
                <c:numCache>
                  <c:formatCode>General</c:formatCode>
                  <c:ptCount val="5"/>
                  <c:pt idx="0">
                    <c:v>8.791335046458407</c:v>
                  </c:pt>
                  <c:pt idx="1">
                    <c:v>1.6981022804406325</c:v>
                  </c:pt>
                  <c:pt idx="2">
                    <c:v>1.5384501590371031</c:v>
                  </c:pt>
                  <c:pt idx="3">
                    <c:v>3.1041127547266036</c:v>
                  </c:pt>
                  <c:pt idx="4">
                    <c:v>2.6544331721311401</c:v>
                  </c:pt>
                </c:numCache>
              </c:numRef>
            </c:plus>
            <c:minus>
              <c:numRef>
                <c:f>MCA!$J$75:$J$79</c:f>
                <c:numCache>
                  <c:formatCode>General</c:formatCode>
                  <c:ptCount val="5"/>
                  <c:pt idx="0">
                    <c:v>8.791335046458407</c:v>
                  </c:pt>
                  <c:pt idx="1">
                    <c:v>1.6981022804406325</c:v>
                  </c:pt>
                  <c:pt idx="2">
                    <c:v>1.5384501590371031</c:v>
                  </c:pt>
                  <c:pt idx="3">
                    <c:v>3.1041127547266036</c:v>
                  </c:pt>
                  <c:pt idx="4">
                    <c:v>2.6544331721311401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J$42:$J$46</c:f>
              <c:numCache>
                <c:formatCode>0</c:formatCode>
                <c:ptCount val="5"/>
                <c:pt idx="0">
                  <c:v>81.439084835521044</c:v>
                </c:pt>
                <c:pt idx="1">
                  <c:v>72.886242065025172</c:v>
                </c:pt>
                <c:pt idx="2">
                  <c:v>70.554168276433955</c:v>
                </c:pt>
                <c:pt idx="3">
                  <c:v>68.475825221676729</c:v>
                </c:pt>
                <c:pt idx="4">
                  <c:v>61.5802417948983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E67B-47B8-B40E-7440DBC52B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651392"/>
        <c:axId val="146665472"/>
      </c:scatterChart>
      <c:valAx>
        <c:axId val="146651392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146665472"/>
        <c:crosses val="autoZero"/>
        <c:crossBetween val="midCat"/>
      </c:valAx>
      <c:valAx>
        <c:axId val="146665472"/>
        <c:scaling>
          <c:orientation val="minMax"/>
          <c:max val="150"/>
          <c:min val="0"/>
        </c:scaling>
        <c:delete val="0"/>
        <c:axPos val="l"/>
        <c:majorGridlines>
          <c:spPr>
            <a:ln w="9525">
              <a:solidFill>
                <a:sysClr val="windowText" lastClr="000000"/>
              </a:solidFill>
              <a:prstDash val="sysDot"/>
            </a:ln>
          </c:spPr>
        </c:majorGridlines>
        <c:minorGridlines>
          <c:spPr>
            <a:ln w="6350">
              <a:solidFill>
                <a:sysClr val="windowText" lastClr="000000"/>
              </a:solidFill>
              <a:prstDash val="sysDot"/>
            </a:ln>
          </c:spPr>
        </c:minorGridlines>
        <c:numFmt formatCode="0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46651392"/>
        <c:crossesAt val="0.1"/>
        <c:crossBetween val="midCat"/>
        <c:majorUnit val="50"/>
        <c:minorUnit val="50"/>
      </c:valAx>
      <c:spPr>
        <a:noFill/>
      </c:spPr>
    </c:plotArea>
    <c:legend>
      <c:legendPos val="r"/>
      <c:layout>
        <c:manualLayout>
          <c:xMode val="edge"/>
          <c:yMode val="edge"/>
          <c:x val="0.65441773571407857"/>
          <c:y val="9.4345833333333337E-2"/>
          <c:w val="0.24069719942811149"/>
          <c:h val="0.23730972222222221"/>
        </c:manualLayout>
      </c:layout>
      <c:overlay val="0"/>
      <c:spPr>
        <a:noFill/>
      </c:spPr>
      <c:txPr>
        <a:bodyPr/>
        <a:lstStyle/>
        <a:p>
          <a:pPr>
            <a:defRPr sz="600">
              <a:latin typeface="+mn-lt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676918889819596"/>
          <c:y val="7.7828830394782861E-2"/>
          <c:w val="0.72844125955808425"/>
          <c:h val="0.74162361283594025"/>
        </c:manualLayout>
      </c:layout>
      <c:scatterChart>
        <c:scatterStyle val="lineMarker"/>
        <c:varyColors val="0"/>
        <c:ser>
          <c:idx val="0"/>
          <c:order val="0"/>
          <c:tx>
            <c:v>5</c:v>
          </c:tx>
          <c:spPr>
            <a:ln w="15875">
              <a:solidFill>
                <a:srgbClr val="1F497D"/>
              </a:solidFill>
            </a:ln>
          </c:spPr>
          <c:marker>
            <c:symbol val="circle"/>
            <c:size val="4"/>
            <c:spPr>
              <a:solidFill>
                <a:srgbClr val="1F497D"/>
              </a:solidFill>
              <a:ln w="952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K$75:$K$79</c:f>
                <c:numCache>
                  <c:formatCode>General</c:formatCode>
                  <c:ptCount val="5"/>
                  <c:pt idx="0">
                    <c:v>8.7355541329648521</c:v>
                  </c:pt>
                  <c:pt idx="1">
                    <c:v>0.46082779413793346</c:v>
                  </c:pt>
                  <c:pt idx="2">
                    <c:v>2.8204765283701518</c:v>
                  </c:pt>
                  <c:pt idx="3">
                    <c:v>3.34059299133378</c:v>
                  </c:pt>
                  <c:pt idx="4">
                    <c:v>3.4054262139566416</c:v>
                  </c:pt>
                </c:numCache>
              </c:numRef>
            </c:plus>
            <c:minus>
              <c:numRef>
                <c:f>MCA!$K$75:$K$79</c:f>
                <c:numCache>
                  <c:formatCode>General</c:formatCode>
                  <c:ptCount val="5"/>
                  <c:pt idx="0">
                    <c:v>8.7355541329648521</c:v>
                  </c:pt>
                  <c:pt idx="1">
                    <c:v>0.46082779413793346</c:v>
                  </c:pt>
                  <c:pt idx="2">
                    <c:v>2.8204765283701518</c:v>
                  </c:pt>
                  <c:pt idx="3">
                    <c:v>3.34059299133378</c:v>
                  </c:pt>
                  <c:pt idx="4">
                    <c:v>3.4054262139566416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K$42:$K$46</c:f>
              <c:numCache>
                <c:formatCode>0</c:formatCode>
                <c:ptCount val="5"/>
                <c:pt idx="0">
                  <c:v>81.374572165872479</c:v>
                </c:pt>
                <c:pt idx="1">
                  <c:v>71.936165689057873</c:v>
                </c:pt>
                <c:pt idx="2">
                  <c:v>69.785843224066269</c:v>
                </c:pt>
                <c:pt idx="3">
                  <c:v>64.558241721592026</c:v>
                </c:pt>
                <c:pt idx="4">
                  <c:v>59.88885692726507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6EF4-4A63-939B-7F598F13F467}"/>
            </c:ext>
          </c:extLst>
        </c:ser>
        <c:ser>
          <c:idx val="1"/>
          <c:order val="1"/>
          <c:tx>
            <c:v>6</c:v>
          </c:tx>
          <c:spPr>
            <a:ln w="1587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L$75:$L$79</c:f>
                <c:numCache>
                  <c:formatCode>General</c:formatCode>
                  <c:ptCount val="5"/>
                  <c:pt idx="0">
                    <c:v>7.690501449494473</c:v>
                  </c:pt>
                  <c:pt idx="1">
                    <c:v>0.45245998727212589</c:v>
                  </c:pt>
                  <c:pt idx="2">
                    <c:v>1.9790846958790016</c:v>
                  </c:pt>
                  <c:pt idx="3">
                    <c:v>3.4425916700962187</c:v>
                  </c:pt>
                  <c:pt idx="4">
                    <c:v>3.7575671418558048</c:v>
                  </c:pt>
                </c:numCache>
              </c:numRef>
            </c:plus>
            <c:minus>
              <c:numRef>
                <c:f>MCA!$L$75:$L$79</c:f>
                <c:numCache>
                  <c:formatCode>General</c:formatCode>
                  <c:ptCount val="5"/>
                  <c:pt idx="0">
                    <c:v>7.690501449494473</c:v>
                  </c:pt>
                  <c:pt idx="1">
                    <c:v>0.45245998727212589</c:v>
                  </c:pt>
                  <c:pt idx="2">
                    <c:v>1.9790846958790016</c:v>
                  </c:pt>
                  <c:pt idx="3">
                    <c:v>3.4425916700962187</c:v>
                  </c:pt>
                  <c:pt idx="4">
                    <c:v>3.7575671418558048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L$42:$L$46</c:f>
              <c:numCache>
                <c:formatCode>0</c:formatCode>
                <c:ptCount val="5"/>
                <c:pt idx="0">
                  <c:v>79.467377584399216</c:v>
                </c:pt>
                <c:pt idx="1">
                  <c:v>69.028812393274592</c:v>
                </c:pt>
                <c:pt idx="2">
                  <c:v>68.613097380743923</c:v>
                </c:pt>
                <c:pt idx="3">
                  <c:v>66.955057822321933</c:v>
                </c:pt>
                <c:pt idx="4">
                  <c:v>65.67898983452614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6EF4-4A63-939B-7F598F13F467}"/>
            </c:ext>
          </c:extLst>
        </c:ser>
        <c:ser>
          <c:idx val="2"/>
          <c:order val="2"/>
          <c:tx>
            <c:v>7</c:v>
          </c:tx>
          <c:spPr>
            <a:ln w="15875">
              <a:solidFill>
                <a:srgbClr val="C0504D"/>
              </a:solidFill>
            </a:ln>
          </c:spPr>
          <c:marker>
            <c:symbol val="circle"/>
            <c:size val="4"/>
            <c:spPr>
              <a:solidFill>
                <a:srgbClr val="C0504D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M$75:$M$79</c:f>
                <c:numCache>
                  <c:formatCode>General</c:formatCode>
                  <c:ptCount val="5"/>
                  <c:pt idx="0">
                    <c:v>10.101500447273736</c:v>
                  </c:pt>
                  <c:pt idx="1">
                    <c:v>3.8789659497411813</c:v>
                  </c:pt>
                  <c:pt idx="2">
                    <c:v>1.7197895675078647</c:v>
                  </c:pt>
                  <c:pt idx="3">
                    <c:v>3.8718713102970606</c:v>
                  </c:pt>
                  <c:pt idx="4">
                    <c:v>3.6431934007396674</c:v>
                  </c:pt>
                </c:numCache>
              </c:numRef>
            </c:plus>
            <c:minus>
              <c:numRef>
                <c:f>MCA!$M$75:$M$79</c:f>
                <c:numCache>
                  <c:formatCode>General</c:formatCode>
                  <c:ptCount val="5"/>
                  <c:pt idx="0">
                    <c:v>10.101500447273736</c:v>
                  </c:pt>
                  <c:pt idx="1">
                    <c:v>3.8789659497411813</c:v>
                  </c:pt>
                  <c:pt idx="2">
                    <c:v>1.7197895675078647</c:v>
                  </c:pt>
                  <c:pt idx="3">
                    <c:v>3.8718713102970606</c:v>
                  </c:pt>
                  <c:pt idx="4">
                    <c:v>3.6431934007396674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M$42:$M$46</c:f>
              <c:numCache>
                <c:formatCode>0</c:formatCode>
                <c:ptCount val="5"/>
                <c:pt idx="0">
                  <c:v>78.580857035332528</c:v>
                </c:pt>
                <c:pt idx="1">
                  <c:v>65.20089047495118</c:v>
                </c:pt>
                <c:pt idx="2">
                  <c:v>62.713514586301734</c:v>
                </c:pt>
                <c:pt idx="3">
                  <c:v>56.941154883850686</c:v>
                </c:pt>
                <c:pt idx="4">
                  <c:v>53.1040241753838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6EF4-4A63-939B-7F598F13F467}"/>
            </c:ext>
          </c:extLst>
        </c:ser>
        <c:ser>
          <c:idx val="3"/>
          <c:order val="3"/>
          <c:tx>
            <c:v>8</c:v>
          </c:tx>
          <c:spPr>
            <a:ln w="15875">
              <a:solidFill>
                <a:srgbClr val="F79646"/>
              </a:solidFill>
            </a:ln>
          </c:spPr>
          <c:marker>
            <c:symbol val="circle"/>
            <c:size val="4"/>
            <c:spPr>
              <a:solidFill>
                <a:srgbClr val="F79646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N$75:$N$79</c:f>
                <c:numCache>
                  <c:formatCode>General</c:formatCode>
                  <c:ptCount val="5"/>
                  <c:pt idx="0">
                    <c:v>6.3016362323648458</c:v>
                  </c:pt>
                  <c:pt idx="1">
                    <c:v>3.2675078384384713</c:v>
                  </c:pt>
                  <c:pt idx="2">
                    <c:v>2.4083289833232655</c:v>
                  </c:pt>
                  <c:pt idx="3">
                    <c:v>4.8398505139914008</c:v>
                  </c:pt>
                  <c:pt idx="4">
                    <c:v>3.1486579178455467</c:v>
                  </c:pt>
                </c:numCache>
              </c:numRef>
            </c:plus>
            <c:minus>
              <c:numRef>
                <c:f>MCA!$N$75:$N$79</c:f>
                <c:numCache>
                  <c:formatCode>General</c:formatCode>
                  <c:ptCount val="5"/>
                  <c:pt idx="0">
                    <c:v>6.3016362323648458</c:v>
                  </c:pt>
                  <c:pt idx="1">
                    <c:v>3.2675078384384713</c:v>
                  </c:pt>
                  <c:pt idx="2">
                    <c:v>2.4083289833232655</c:v>
                  </c:pt>
                  <c:pt idx="3">
                    <c:v>4.8398505139914008</c:v>
                  </c:pt>
                  <c:pt idx="4">
                    <c:v>3.1486579178455467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N$42:$N$46</c:f>
              <c:numCache>
                <c:formatCode>0</c:formatCode>
                <c:ptCount val="5"/>
                <c:pt idx="0">
                  <c:v>79.926761091716543</c:v>
                </c:pt>
                <c:pt idx="1">
                  <c:v>63.186129480500888</c:v>
                </c:pt>
                <c:pt idx="2">
                  <c:v>62.606409690164021</c:v>
                </c:pt>
                <c:pt idx="3">
                  <c:v>59.358607462442748</c:v>
                </c:pt>
                <c:pt idx="4">
                  <c:v>49.5338242145195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6EF4-4A63-939B-7F598F13F4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7551360"/>
        <c:axId val="147552896"/>
      </c:scatterChart>
      <c:valAx>
        <c:axId val="147551360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147552896"/>
        <c:crosses val="autoZero"/>
        <c:crossBetween val="midCat"/>
      </c:valAx>
      <c:valAx>
        <c:axId val="147552896"/>
        <c:scaling>
          <c:orientation val="minMax"/>
          <c:max val="150"/>
          <c:min val="0"/>
        </c:scaling>
        <c:delete val="0"/>
        <c:axPos val="l"/>
        <c:majorGridlines>
          <c:spPr>
            <a:ln w="9525">
              <a:solidFill>
                <a:sysClr val="windowText" lastClr="000000"/>
              </a:solidFill>
              <a:prstDash val="sysDot"/>
            </a:ln>
          </c:spPr>
        </c:majorGridlines>
        <c:minorGridlines>
          <c:spPr>
            <a:ln w="6350">
              <a:solidFill>
                <a:sysClr val="windowText" lastClr="000000"/>
              </a:solidFill>
              <a:prstDash val="sysDot"/>
            </a:ln>
          </c:spPr>
        </c:minorGridlines>
        <c:numFmt formatCode="0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47551360"/>
        <c:crossesAt val="0.1"/>
        <c:crossBetween val="midCat"/>
        <c:majorUnit val="50"/>
        <c:minorUnit val="50"/>
      </c:valAx>
      <c:spPr>
        <a:noFill/>
      </c:spPr>
    </c:plotArea>
    <c:legend>
      <c:legendPos val="r"/>
      <c:layout>
        <c:manualLayout>
          <c:xMode val="edge"/>
          <c:yMode val="edge"/>
          <c:x val="0.65498375325976843"/>
          <c:y val="8.5526388888888902E-2"/>
          <c:w val="0.2483263849675009"/>
          <c:h val="0.22849027777777778"/>
        </c:manualLayout>
      </c:layout>
      <c:overlay val="0"/>
      <c:spPr>
        <a:noFill/>
      </c:spPr>
      <c:txPr>
        <a:bodyPr/>
        <a:lstStyle/>
        <a:p>
          <a:pPr>
            <a:defRPr sz="600">
              <a:latin typeface="+mn-lt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676918889819596"/>
          <c:y val="7.7828830394782861E-2"/>
          <c:w val="0.72844125955808425"/>
          <c:h val="0.74162361283594025"/>
        </c:manualLayout>
      </c:layout>
      <c:scatterChart>
        <c:scatterStyle val="lineMarker"/>
        <c:varyColors val="0"/>
        <c:ser>
          <c:idx val="0"/>
          <c:order val="0"/>
          <c:tx>
            <c:v>9</c:v>
          </c:tx>
          <c:spPr>
            <a:ln w="15875">
              <a:solidFill>
                <a:srgbClr val="1F497D"/>
              </a:solidFill>
            </a:ln>
          </c:spPr>
          <c:marker>
            <c:symbol val="circle"/>
            <c:size val="4"/>
            <c:spPr>
              <a:solidFill>
                <a:srgbClr val="1F497D"/>
              </a:solidFill>
              <a:ln w="952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O$75:$O$79</c:f>
                <c:numCache>
                  <c:formatCode>General</c:formatCode>
                  <c:ptCount val="5"/>
                  <c:pt idx="0">
                    <c:v>10.257863287251636</c:v>
                  </c:pt>
                  <c:pt idx="1">
                    <c:v>4.2499716130682899</c:v>
                  </c:pt>
                  <c:pt idx="2">
                    <c:v>5.3120048914019584</c:v>
                  </c:pt>
                  <c:pt idx="3">
                    <c:v>5.4393486569336682</c:v>
                  </c:pt>
                  <c:pt idx="4">
                    <c:v>2.8072902270527975</c:v>
                  </c:pt>
                </c:numCache>
              </c:numRef>
            </c:plus>
            <c:minus>
              <c:numRef>
                <c:f>MCA!$O$75:$O$79</c:f>
                <c:numCache>
                  <c:formatCode>General</c:formatCode>
                  <c:ptCount val="5"/>
                  <c:pt idx="0">
                    <c:v>10.257863287251636</c:v>
                  </c:pt>
                  <c:pt idx="1">
                    <c:v>4.2499716130682899</c:v>
                  </c:pt>
                  <c:pt idx="2">
                    <c:v>5.3120048914019584</c:v>
                  </c:pt>
                  <c:pt idx="3">
                    <c:v>5.4393486569336682</c:v>
                  </c:pt>
                  <c:pt idx="4">
                    <c:v>2.8072902270527975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O$42:$O$46</c:f>
              <c:numCache>
                <c:formatCode>0</c:formatCode>
                <c:ptCount val="5"/>
                <c:pt idx="0">
                  <c:v>78.777984987558085</c:v>
                </c:pt>
                <c:pt idx="1">
                  <c:v>62.102202335061328</c:v>
                </c:pt>
                <c:pt idx="2">
                  <c:v>58.255442990242479</c:v>
                </c:pt>
                <c:pt idx="3">
                  <c:v>54.185917575309553</c:v>
                </c:pt>
                <c:pt idx="4">
                  <c:v>42.16177670252702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77F4-4745-97F2-93E49392E524}"/>
            </c:ext>
          </c:extLst>
        </c:ser>
        <c:ser>
          <c:idx val="1"/>
          <c:order val="1"/>
          <c:tx>
            <c:v>10</c:v>
          </c:tx>
          <c:spPr>
            <a:ln w="1587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P$75:$P$79</c:f>
                <c:numCache>
                  <c:formatCode>General</c:formatCode>
                  <c:ptCount val="5"/>
                  <c:pt idx="0">
                    <c:v>8.7138044738972962</c:v>
                  </c:pt>
                  <c:pt idx="1">
                    <c:v>5.0518871804347514</c:v>
                  </c:pt>
                  <c:pt idx="2">
                    <c:v>5.2573854588827329</c:v>
                  </c:pt>
                  <c:pt idx="3">
                    <c:v>4.2250306673718612</c:v>
                  </c:pt>
                  <c:pt idx="4">
                    <c:v>1.7986329520783428</c:v>
                  </c:pt>
                </c:numCache>
              </c:numRef>
            </c:plus>
            <c:minus>
              <c:numRef>
                <c:f>MCA!$P$75:$P$79</c:f>
                <c:numCache>
                  <c:formatCode>General</c:formatCode>
                  <c:ptCount val="5"/>
                  <c:pt idx="0">
                    <c:v>8.7138044738972962</c:v>
                  </c:pt>
                  <c:pt idx="1">
                    <c:v>5.0518871804347514</c:v>
                  </c:pt>
                  <c:pt idx="2">
                    <c:v>5.2573854588827329</c:v>
                  </c:pt>
                  <c:pt idx="3">
                    <c:v>4.2250306673718612</c:v>
                  </c:pt>
                  <c:pt idx="4">
                    <c:v>1.7986329520783428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P$42:$P$46</c:f>
              <c:numCache>
                <c:formatCode>0</c:formatCode>
                <c:ptCount val="5"/>
                <c:pt idx="0">
                  <c:v>80.063945767153385</c:v>
                </c:pt>
                <c:pt idx="1">
                  <c:v>61.460095016668859</c:v>
                </c:pt>
                <c:pt idx="2">
                  <c:v>57.249263875982251</c:v>
                </c:pt>
                <c:pt idx="3">
                  <c:v>51.797851621609112</c:v>
                </c:pt>
                <c:pt idx="4">
                  <c:v>36.80281845597319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77F4-4745-97F2-93E49392E524}"/>
            </c:ext>
          </c:extLst>
        </c:ser>
        <c:ser>
          <c:idx val="2"/>
          <c:order val="2"/>
          <c:tx>
            <c:v>11</c:v>
          </c:tx>
          <c:spPr>
            <a:ln w="15875">
              <a:solidFill>
                <a:srgbClr val="C0504D"/>
              </a:solidFill>
            </a:ln>
          </c:spPr>
          <c:marker>
            <c:symbol val="circle"/>
            <c:size val="4"/>
            <c:spPr>
              <a:solidFill>
                <a:srgbClr val="C0504D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Q$75:$Q$79</c:f>
                <c:numCache>
                  <c:formatCode>General</c:formatCode>
                  <c:ptCount val="5"/>
                  <c:pt idx="0">
                    <c:v>10.587201111962386</c:v>
                  </c:pt>
                  <c:pt idx="1">
                    <c:v>7.5015151177830148</c:v>
                  </c:pt>
                  <c:pt idx="2">
                    <c:v>4.8611359473952103</c:v>
                  </c:pt>
                  <c:pt idx="3">
                    <c:v>2.671107927650243</c:v>
                  </c:pt>
                  <c:pt idx="4">
                    <c:v>1.3512134841978987</c:v>
                  </c:pt>
                </c:numCache>
              </c:numRef>
            </c:plus>
            <c:minus>
              <c:numRef>
                <c:f>MCA!$Q$75:$Q$79</c:f>
                <c:numCache>
                  <c:formatCode>General</c:formatCode>
                  <c:ptCount val="5"/>
                  <c:pt idx="0">
                    <c:v>10.587201111962386</c:v>
                  </c:pt>
                  <c:pt idx="1">
                    <c:v>7.5015151177830148</c:v>
                  </c:pt>
                  <c:pt idx="2">
                    <c:v>4.8611359473952103</c:v>
                  </c:pt>
                  <c:pt idx="3">
                    <c:v>2.671107927650243</c:v>
                  </c:pt>
                  <c:pt idx="4">
                    <c:v>1.3512134841978987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Q$42:$Q$46</c:f>
              <c:numCache>
                <c:formatCode>0</c:formatCode>
                <c:ptCount val="5"/>
                <c:pt idx="0">
                  <c:v>82.809878007851836</c:v>
                </c:pt>
                <c:pt idx="1">
                  <c:v>63.384404049233943</c:v>
                </c:pt>
                <c:pt idx="2">
                  <c:v>55.281448295778276</c:v>
                </c:pt>
                <c:pt idx="3">
                  <c:v>49.084083263738762</c:v>
                </c:pt>
                <c:pt idx="4">
                  <c:v>34.42961060855584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77F4-4745-97F2-93E49392E524}"/>
            </c:ext>
          </c:extLst>
        </c:ser>
        <c:ser>
          <c:idx val="3"/>
          <c:order val="3"/>
          <c:tx>
            <c:v>12</c:v>
          </c:tx>
          <c:spPr>
            <a:ln w="15875">
              <a:solidFill>
                <a:srgbClr val="F79646"/>
              </a:solidFill>
            </a:ln>
          </c:spPr>
          <c:marker>
            <c:symbol val="circle"/>
            <c:size val="4"/>
            <c:spPr>
              <a:solidFill>
                <a:srgbClr val="F79646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R$75:$R$79</c:f>
                <c:numCache>
                  <c:formatCode>General</c:formatCode>
                  <c:ptCount val="5"/>
                  <c:pt idx="0">
                    <c:v>9.8048693882130475</c:v>
                  </c:pt>
                  <c:pt idx="1">
                    <c:v>6.0689651525177055</c:v>
                  </c:pt>
                  <c:pt idx="2">
                    <c:v>3.6855064619030324</c:v>
                  </c:pt>
                  <c:pt idx="3">
                    <c:v>0.76117453253809964</c:v>
                  </c:pt>
                  <c:pt idx="4">
                    <c:v>0.99381422340947922</c:v>
                  </c:pt>
                </c:numCache>
              </c:numRef>
            </c:plus>
            <c:minus>
              <c:numRef>
                <c:f>MCA!$R$75:$R$79</c:f>
                <c:numCache>
                  <c:formatCode>General</c:formatCode>
                  <c:ptCount val="5"/>
                  <c:pt idx="0">
                    <c:v>9.8048693882130475</c:v>
                  </c:pt>
                  <c:pt idx="1">
                    <c:v>6.0689651525177055</c:v>
                  </c:pt>
                  <c:pt idx="2">
                    <c:v>3.6855064619030324</c:v>
                  </c:pt>
                  <c:pt idx="3">
                    <c:v>0.76117453253809964</c:v>
                  </c:pt>
                  <c:pt idx="4">
                    <c:v>0.99381422340947922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R$42:$R$46</c:f>
              <c:numCache>
                <c:formatCode>0</c:formatCode>
                <c:ptCount val="5"/>
                <c:pt idx="0">
                  <c:v>86.330434479968346</c:v>
                </c:pt>
                <c:pt idx="1">
                  <c:v>65.001602417693022</c:v>
                </c:pt>
                <c:pt idx="2">
                  <c:v>55.507458855569233</c:v>
                </c:pt>
                <c:pt idx="3">
                  <c:v>47.561352295517729</c:v>
                </c:pt>
                <c:pt idx="4">
                  <c:v>33.86981697634657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77F4-4745-97F2-93E49392E5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5623424"/>
        <c:axId val="155624960"/>
      </c:scatterChart>
      <c:valAx>
        <c:axId val="155623424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155624960"/>
        <c:crosses val="autoZero"/>
        <c:crossBetween val="midCat"/>
      </c:valAx>
      <c:valAx>
        <c:axId val="155624960"/>
        <c:scaling>
          <c:orientation val="minMax"/>
          <c:max val="150"/>
          <c:min val="0"/>
        </c:scaling>
        <c:delete val="0"/>
        <c:axPos val="l"/>
        <c:majorGridlines>
          <c:spPr>
            <a:ln w="9525">
              <a:solidFill>
                <a:sysClr val="windowText" lastClr="000000"/>
              </a:solidFill>
              <a:prstDash val="sysDot"/>
            </a:ln>
          </c:spPr>
        </c:majorGridlines>
        <c:minorGridlines>
          <c:spPr>
            <a:ln w="6350">
              <a:solidFill>
                <a:sysClr val="windowText" lastClr="000000"/>
              </a:solidFill>
              <a:prstDash val="sysDot"/>
            </a:ln>
          </c:spPr>
        </c:minorGridlines>
        <c:numFmt formatCode="0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55623424"/>
        <c:crossesAt val="0.1"/>
        <c:crossBetween val="midCat"/>
        <c:majorUnit val="50"/>
        <c:minorUnit val="50"/>
      </c:valAx>
      <c:spPr>
        <a:noFill/>
      </c:spPr>
    </c:plotArea>
    <c:legend>
      <c:legendPos val="r"/>
      <c:layout>
        <c:manualLayout>
          <c:xMode val="edge"/>
          <c:yMode val="edge"/>
          <c:x val="0.63081620750826006"/>
          <c:y val="8.3355555555555558E-2"/>
          <c:w val="0.2791003694135259"/>
          <c:h val="0.23730972222222221"/>
        </c:manualLayout>
      </c:layout>
      <c:overlay val="0"/>
      <c:spPr>
        <a:noFill/>
      </c:spPr>
      <c:txPr>
        <a:bodyPr/>
        <a:lstStyle/>
        <a:p>
          <a:pPr>
            <a:defRPr sz="600">
              <a:latin typeface="+mn-lt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0553987297106563"/>
          <c:y val="6.0190277777777787E-2"/>
          <c:w val="0.72844125955808425"/>
          <c:h val="0.74162361283594025"/>
        </c:manualLayout>
      </c:layout>
      <c:scatterChart>
        <c:scatterStyle val="lineMarker"/>
        <c:varyColors val="0"/>
        <c:ser>
          <c:idx val="0"/>
          <c:order val="0"/>
          <c:tx>
            <c:v>13</c:v>
          </c:tx>
          <c:spPr>
            <a:ln w="15875">
              <a:solidFill>
                <a:srgbClr val="1F497D"/>
              </a:solidFill>
            </a:ln>
          </c:spPr>
          <c:marker>
            <c:symbol val="circle"/>
            <c:size val="4"/>
            <c:spPr>
              <a:solidFill>
                <a:srgbClr val="1F497D"/>
              </a:solidFill>
              <a:ln w="952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S$75:$S$79</c:f>
                <c:numCache>
                  <c:formatCode>General</c:formatCode>
                  <c:ptCount val="5"/>
                  <c:pt idx="0">
                    <c:v>4.7210365500689857</c:v>
                  </c:pt>
                  <c:pt idx="1">
                    <c:v>6.4978913047234306</c:v>
                  </c:pt>
                  <c:pt idx="2">
                    <c:v>4.7562548307401125</c:v>
                  </c:pt>
                  <c:pt idx="3">
                    <c:v>2.7861703619327618</c:v>
                  </c:pt>
                  <c:pt idx="4">
                    <c:v>1.6483417710646111</c:v>
                  </c:pt>
                </c:numCache>
              </c:numRef>
            </c:plus>
            <c:minus>
              <c:numRef>
                <c:f>MCA!$S$75:$S$79</c:f>
                <c:numCache>
                  <c:formatCode>General</c:formatCode>
                  <c:ptCount val="5"/>
                  <c:pt idx="0">
                    <c:v>4.7210365500689857</c:v>
                  </c:pt>
                  <c:pt idx="1">
                    <c:v>6.4978913047234306</c:v>
                  </c:pt>
                  <c:pt idx="2">
                    <c:v>4.7562548307401125</c:v>
                  </c:pt>
                  <c:pt idx="3">
                    <c:v>2.7861703619327618</c:v>
                  </c:pt>
                  <c:pt idx="4">
                    <c:v>1.6483417710646111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S$42:$S$46</c:f>
              <c:numCache>
                <c:formatCode>General</c:formatCode>
                <c:ptCount val="5"/>
                <c:pt idx="0">
                  <c:v>91.954966555782093</c:v>
                </c:pt>
                <c:pt idx="1">
                  <c:v>66.484720582799781</c:v>
                </c:pt>
                <c:pt idx="2">
                  <c:v>60.696068963050401</c:v>
                </c:pt>
                <c:pt idx="3">
                  <c:v>55.827341989483848</c:v>
                </c:pt>
                <c:pt idx="4">
                  <c:v>35.09317881031584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9A91-4161-9FA8-7CBE45E21850}"/>
            </c:ext>
          </c:extLst>
        </c:ser>
        <c:ser>
          <c:idx val="1"/>
          <c:order val="1"/>
          <c:tx>
            <c:v>14</c:v>
          </c:tx>
          <c:spPr>
            <a:ln w="1587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T$75:$T$79</c:f>
                <c:numCache>
                  <c:formatCode>General</c:formatCode>
                  <c:ptCount val="5"/>
                  <c:pt idx="0">
                    <c:v>7.4316168927429924</c:v>
                  </c:pt>
                  <c:pt idx="1">
                    <c:v>8.9716482465688348</c:v>
                  </c:pt>
                  <c:pt idx="2">
                    <c:v>4.9638005191457157</c:v>
                  </c:pt>
                  <c:pt idx="3">
                    <c:v>0.9502438137932776</c:v>
                  </c:pt>
                  <c:pt idx="4">
                    <c:v>1.5177860323649042</c:v>
                  </c:pt>
                </c:numCache>
              </c:numRef>
            </c:plus>
            <c:minus>
              <c:numRef>
                <c:f>MCA!$T$75:$T$79</c:f>
                <c:numCache>
                  <c:formatCode>General</c:formatCode>
                  <c:ptCount val="5"/>
                  <c:pt idx="0">
                    <c:v>7.4316168927429924</c:v>
                  </c:pt>
                  <c:pt idx="1">
                    <c:v>8.9716482465688348</c:v>
                  </c:pt>
                  <c:pt idx="2">
                    <c:v>4.9638005191457157</c:v>
                  </c:pt>
                  <c:pt idx="3">
                    <c:v>0.9502438137932776</c:v>
                  </c:pt>
                  <c:pt idx="4">
                    <c:v>1.5177860323649042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T$42:$T$46</c:f>
              <c:numCache>
                <c:formatCode>General</c:formatCode>
                <c:ptCount val="5"/>
                <c:pt idx="0">
                  <c:v>91.242469432980968</c:v>
                </c:pt>
                <c:pt idx="1">
                  <c:v>63.213349410256569</c:v>
                </c:pt>
                <c:pt idx="2">
                  <c:v>53.445227547764048</c:v>
                </c:pt>
                <c:pt idx="3">
                  <c:v>48.14313732811199</c:v>
                </c:pt>
                <c:pt idx="4">
                  <c:v>28.51435612142030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9A91-4161-9FA8-7CBE45E21850}"/>
            </c:ext>
          </c:extLst>
        </c:ser>
        <c:ser>
          <c:idx val="2"/>
          <c:order val="2"/>
          <c:tx>
            <c:v>15</c:v>
          </c:tx>
          <c:spPr>
            <a:ln w="15875">
              <a:solidFill>
                <a:srgbClr val="C0504D"/>
              </a:solidFill>
            </a:ln>
          </c:spPr>
          <c:marker>
            <c:symbol val="circle"/>
            <c:size val="4"/>
            <c:spPr>
              <a:solidFill>
                <a:srgbClr val="C0504D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U$75:$U$79</c:f>
                <c:numCache>
                  <c:formatCode>General</c:formatCode>
                  <c:ptCount val="5"/>
                  <c:pt idx="0">
                    <c:v>7.3892414670531572</c:v>
                  </c:pt>
                  <c:pt idx="1">
                    <c:v>7.8664302937216393</c:v>
                  </c:pt>
                  <c:pt idx="2">
                    <c:v>6.8035733453027198</c:v>
                  </c:pt>
                  <c:pt idx="3">
                    <c:v>2.8102268355579785</c:v>
                  </c:pt>
                  <c:pt idx="4">
                    <c:v>1.1464784982824163</c:v>
                  </c:pt>
                </c:numCache>
              </c:numRef>
            </c:plus>
            <c:minus>
              <c:numRef>
                <c:f>MCA!$U$75:$U$79</c:f>
                <c:numCache>
                  <c:formatCode>General</c:formatCode>
                  <c:ptCount val="5"/>
                  <c:pt idx="0">
                    <c:v>7.3892414670531572</c:v>
                  </c:pt>
                  <c:pt idx="1">
                    <c:v>7.8664302937216393</c:v>
                  </c:pt>
                  <c:pt idx="2">
                    <c:v>6.8035733453027198</c:v>
                  </c:pt>
                  <c:pt idx="3">
                    <c:v>2.8102268355579785</c:v>
                  </c:pt>
                  <c:pt idx="4">
                    <c:v>1.1464784982824163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U$42:$U$46</c:f>
              <c:numCache>
                <c:formatCode>General</c:formatCode>
                <c:ptCount val="5"/>
                <c:pt idx="0">
                  <c:v>90.367357884963667</c:v>
                </c:pt>
                <c:pt idx="1">
                  <c:v>63.721761013975431</c:v>
                </c:pt>
                <c:pt idx="2">
                  <c:v>53.541609734652965</c:v>
                </c:pt>
                <c:pt idx="3">
                  <c:v>47.439289963727582</c:v>
                </c:pt>
                <c:pt idx="4">
                  <c:v>23.40665328021753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9A91-4161-9FA8-7CBE45E21850}"/>
            </c:ext>
          </c:extLst>
        </c:ser>
        <c:ser>
          <c:idx val="3"/>
          <c:order val="3"/>
          <c:tx>
            <c:v>16</c:v>
          </c:tx>
          <c:spPr>
            <a:ln w="15875">
              <a:solidFill>
                <a:srgbClr val="F79646"/>
              </a:solidFill>
            </a:ln>
          </c:spPr>
          <c:marker>
            <c:symbol val="circle"/>
            <c:size val="4"/>
            <c:spPr>
              <a:solidFill>
                <a:srgbClr val="F79646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V$75:$V$79</c:f>
                <c:numCache>
                  <c:formatCode>General</c:formatCode>
                  <c:ptCount val="5"/>
                  <c:pt idx="0">
                    <c:v>10.033471560866648</c:v>
                  </c:pt>
                  <c:pt idx="1">
                    <c:v>10.778014411394457</c:v>
                  </c:pt>
                  <c:pt idx="2">
                    <c:v>7.1448628799059604</c:v>
                  </c:pt>
                  <c:pt idx="3">
                    <c:v>2.1751936979351743</c:v>
                  </c:pt>
                  <c:pt idx="4">
                    <c:v>1.3976349537170631</c:v>
                  </c:pt>
                </c:numCache>
              </c:numRef>
            </c:plus>
            <c:minus>
              <c:numRef>
                <c:f>MCA!$V$75:$V$79</c:f>
                <c:numCache>
                  <c:formatCode>General</c:formatCode>
                  <c:ptCount val="5"/>
                  <c:pt idx="0">
                    <c:v>10.033471560866648</c:v>
                  </c:pt>
                  <c:pt idx="1">
                    <c:v>10.778014411394457</c:v>
                  </c:pt>
                  <c:pt idx="2">
                    <c:v>7.1448628799059604</c:v>
                  </c:pt>
                  <c:pt idx="3">
                    <c:v>2.1751936979351743</c:v>
                  </c:pt>
                  <c:pt idx="4">
                    <c:v>1.3976349537170631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V$42:$V$46</c:f>
              <c:numCache>
                <c:formatCode>General</c:formatCode>
                <c:ptCount val="5"/>
                <c:pt idx="0">
                  <c:v>90.130045455750491</c:v>
                </c:pt>
                <c:pt idx="1">
                  <c:v>61.954413735018875</c:v>
                </c:pt>
                <c:pt idx="2">
                  <c:v>49.697267556748315</c:v>
                </c:pt>
                <c:pt idx="3">
                  <c:v>41.917584176749259</c:v>
                </c:pt>
                <c:pt idx="4">
                  <c:v>19.24273044474852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9A91-4161-9FA8-7CBE45E218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5691648"/>
        <c:axId val="155693440"/>
      </c:scatterChart>
      <c:valAx>
        <c:axId val="155691648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155693440"/>
        <c:crosses val="autoZero"/>
        <c:crossBetween val="midCat"/>
      </c:valAx>
      <c:valAx>
        <c:axId val="155693440"/>
        <c:scaling>
          <c:orientation val="minMax"/>
          <c:max val="150"/>
          <c:min val="0"/>
        </c:scaling>
        <c:delete val="0"/>
        <c:axPos val="l"/>
        <c:majorGridlines>
          <c:spPr>
            <a:ln w="6350">
              <a:solidFill>
                <a:sysClr val="windowText" lastClr="000000"/>
              </a:solidFill>
              <a:prstDash val="sysDot"/>
            </a:ln>
          </c:spPr>
        </c:majorGridlines>
        <c:minorGridlines>
          <c:spPr>
            <a:ln>
              <a:solidFill>
                <a:sysClr val="windowText" lastClr="000000"/>
              </a:solidFill>
              <a:prstDash val="sysDot"/>
            </a:ln>
          </c:spPr>
        </c:minorGridlines>
        <c:numFmt formatCode="General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55691648"/>
        <c:crossesAt val="0.1"/>
        <c:crossBetween val="midCat"/>
        <c:majorUnit val="50"/>
        <c:minorUnit val="50"/>
      </c:valAx>
      <c:spPr>
        <a:noFill/>
      </c:spPr>
    </c:plotArea>
    <c:legend>
      <c:legendPos val="r"/>
      <c:layout>
        <c:manualLayout>
          <c:xMode val="edge"/>
          <c:yMode val="edge"/>
          <c:x val="0.62854972883092775"/>
          <c:y val="6.5716666666666673E-2"/>
          <c:w val="0.2788431271250586"/>
          <c:h val="0.23730972222222221"/>
        </c:manualLayout>
      </c:layout>
      <c:overlay val="0"/>
      <c:spPr>
        <a:noFill/>
      </c:spPr>
      <c:txPr>
        <a:bodyPr/>
        <a:lstStyle/>
        <a:p>
          <a:pPr>
            <a:defRPr sz="600">
              <a:latin typeface="+mn-lt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676918889819596"/>
          <c:y val="7.7828830394782861E-2"/>
          <c:w val="0.72844125955808425"/>
          <c:h val="0.74162361283594025"/>
        </c:manualLayout>
      </c:layout>
      <c:scatterChart>
        <c:scatterStyle val="lineMarker"/>
        <c:varyColors val="0"/>
        <c:ser>
          <c:idx val="0"/>
          <c:order val="0"/>
          <c:tx>
            <c:v>17</c:v>
          </c:tx>
          <c:spPr>
            <a:ln w="15875">
              <a:solidFill>
                <a:srgbClr val="1F497D"/>
              </a:solidFill>
            </a:ln>
          </c:spPr>
          <c:marker>
            <c:symbol val="circle"/>
            <c:size val="4"/>
            <c:spPr>
              <a:solidFill>
                <a:srgbClr val="1F497D"/>
              </a:solidFill>
              <a:ln w="952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W$75:$W$79</c:f>
                <c:numCache>
                  <c:formatCode>General</c:formatCode>
                  <c:ptCount val="5"/>
                  <c:pt idx="0">
                    <c:v>15.545649971330128</c:v>
                  </c:pt>
                  <c:pt idx="1">
                    <c:v>11.683741878866048</c:v>
                  </c:pt>
                  <c:pt idx="2">
                    <c:v>7.52287500700794</c:v>
                  </c:pt>
                  <c:pt idx="3">
                    <c:v>1.9549382960441377</c:v>
                  </c:pt>
                  <c:pt idx="4">
                    <c:v>2.1492972050946628</c:v>
                  </c:pt>
                </c:numCache>
              </c:numRef>
            </c:plus>
            <c:minus>
              <c:numRef>
                <c:f>MCA!$W$75:$W$79</c:f>
                <c:numCache>
                  <c:formatCode>General</c:formatCode>
                  <c:ptCount val="5"/>
                  <c:pt idx="0">
                    <c:v>15.545649971330128</c:v>
                  </c:pt>
                  <c:pt idx="1">
                    <c:v>11.683741878866048</c:v>
                  </c:pt>
                  <c:pt idx="2">
                    <c:v>7.52287500700794</c:v>
                  </c:pt>
                  <c:pt idx="3">
                    <c:v>1.9549382960441377</c:v>
                  </c:pt>
                  <c:pt idx="4">
                    <c:v>2.1492972050946628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W$42:$W$46</c:f>
              <c:numCache>
                <c:formatCode>General</c:formatCode>
                <c:ptCount val="5"/>
                <c:pt idx="0">
                  <c:v>86.719807460129573</c:v>
                </c:pt>
                <c:pt idx="1">
                  <c:v>58.11105161204059</c:v>
                </c:pt>
                <c:pt idx="2">
                  <c:v>45.946170246820152</c:v>
                </c:pt>
                <c:pt idx="3">
                  <c:v>38.588594225779872</c:v>
                </c:pt>
                <c:pt idx="4">
                  <c:v>15.61402711445096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A468-4736-8652-D28F65F46479}"/>
            </c:ext>
          </c:extLst>
        </c:ser>
        <c:ser>
          <c:idx val="1"/>
          <c:order val="1"/>
          <c:tx>
            <c:v>18</c:v>
          </c:tx>
          <c:spPr>
            <a:ln w="1587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X$75:$X$79</c:f>
                <c:numCache>
                  <c:formatCode>General</c:formatCode>
                  <c:ptCount val="5"/>
                  <c:pt idx="0">
                    <c:v>17.094633134276073</c:v>
                  </c:pt>
                  <c:pt idx="1">
                    <c:v>13.770126309891424</c:v>
                  </c:pt>
                  <c:pt idx="2">
                    <c:v>5.5506040574281359</c:v>
                  </c:pt>
                  <c:pt idx="3">
                    <c:v>2.6598339343193951</c:v>
                  </c:pt>
                  <c:pt idx="4">
                    <c:v>2.3578854034049721</c:v>
                  </c:pt>
                </c:numCache>
              </c:numRef>
            </c:plus>
            <c:minus>
              <c:numRef>
                <c:f>MCA!$X$75:$X$79</c:f>
                <c:numCache>
                  <c:formatCode>General</c:formatCode>
                  <c:ptCount val="5"/>
                  <c:pt idx="0">
                    <c:v>17.094633134276073</c:v>
                  </c:pt>
                  <c:pt idx="1">
                    <c:v>13.770126309891424</c:v>
                  </c:pt>
                  <c:pt idx="2">
                    <c:v>5.5506040574281359</c:v>
                  </c:pt>
                  <c:pt idx="3">
                    <c:v>2.6598339343193951</c:v>
                  </c:pt>
                  <c:pt idx="4">
                    <c:v>2.3578854034049721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X$42:$X$46</c:f>
              <c:numCache>
                <c:formatCode>General</c:formatCode>
                <c:ptCount val="5"/>
                <c:pt idx="0">
                  <c:v>85.705808291628486</c:v>
                </c:pt>
                <c:pt idx="1">
                  <c:v>57.927679526347376</c:v>
                </c:pt>
                <c:pt idx="2">
                  <c:v>43.790529655184862</c:v>
                </c:pt>
                <c:pt idx="3">
                  <c:v>35.011755574308317</c:v>
                </c:pt>
                <c:pt idx="4">
                  <c:v>13.38713971759545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A468-4736-8652-D28F65F46479}"/>
            </c:ext>
          </c:extLst>
        </c:ser>
        <c:ser>
          <c:idx val="2"/>
          <c:order val="2"/>
          <c:tx>
            <c:v>19</c:v>
          </c:tx>
          <c:spPr>
            <a:ln w="15875">
              <a:solidFill>
                <a:srgbClr val="C0504D"/>
              </a:solidFill>
            </a:ln>
          </c:spPr>
          <c:marker>
            <c:symbol val="circle"/>
            <c:size val="4"/>
            <c:spPr>
              <a:solidFill>
                <a:srgbClr val="C0504D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Y$75:$Y$79</c:f>
                <c:numCache>
                  <c:formatCode>General</c:formatCode>
                  <c:ptCount val="5"/>
                  <c:pt idx="0">
                    <c:v>19.614174658609322</c:v>
                  </c:pt>
                  <c:pt idx="1">
                    <c:v>16.536028224466143</c:v>
                  </c:pt>
                  <c:pt idx="2">
                    <c:v>5.8980673898589187</c:v>
                  </c:pt>
                  <c:pt idx="3">
                    <c:v>2.7022967297948242</c:v>
                  </c:pt>
                  <c:pt idx="4">
                    <c:v>1.8287716718390838</c:v>
                  </c:pt>
                </c:numCache>
              </c:numRef>
            </c:plus>
            <c:minus>
              <c:numRef>
                <c:f>MCA!$Y$75:$Y$79</c:f>
                <c:numCache>
                  <c:formatCode>General</c:formatCode>
                  <c:ptCount val="5"/>
                  <c:pt idx="0">
                    <c:v>19.614174658609322</c:v>
                  </c:pt>
                  <c:pt idx="1">
                    <c:v>16.536028224466143</c:v>
                  </c:pt>
                  <c:pt idx="2">
                    <c:v>5.8980673898589187</c:v>
                  </c:pt>
                  <c:pt idx="3">
                    <c:v>2.7022967297948242</c:v>
                  </c:pt>
                  <c:pt idx="4">
                    <c:v>1.8287716718390838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Y$42:$Y$46</c:f>
              <c:numCache>
                <c:formatCode>General</c:formatCode>
                <c:ptCount val="5"/>
                <c:pt idx="0">
                  <c:v>84.038786294056749</c:v>
                </c:pt>
                <c:pt idx="1">
                  <c:v>56.220317243360228</c:v>
                </c:pt>
                <c:pt idx="2">
                  <c:v>40.036745952745292</c:v>
                </c:pt>
                <c:pt idx="3">
                  <c:v>31.858790553021631</c:v>
                </c:pt>
                <c:pt idx="4">
                  <c:v>11.70076314707790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A468-4736-8652-D28F65F46479}"/>
            </c:ext>
          </c:extLst>
        </c:ser>
        <c:ser>
          <c:idx val="3"/>
          <c:order val="3"/>
          <c:tx>
            <c:v>20</c:v>
          </c:tx>
          <c:spPr>
            <a:ln w="15875">
              <a:solidFill>
                <a:srgbClr val="F79646"/>
              </a:solidFill>
            </a:ln>
          </c:spPr>
          <c:marker>
            <c:symbol val="circle"/>
            <c:size val="4"/>
            <c:spPr>
              <a:solidFill>
                <a:srgbClr val="F79646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Z$75:$Z$79</c:f>
                <c:numCache>
                  <c:formatCode>General</c:formatCode>
                  <c:ptCount val="5"/>
                  <c:pt idx="0">
                    <c:v>18.715638928432412</c:v>
                  </c:pt>
                  <c:pt idx="1">
                    <c:v>18.937548364912733</c:v>
                  </c:pt>
                  <c:pt idx="2">
                    <c:v>7.8880975242859401</c:v>
                  </c:pt>
                  <c:pt idx="3">
                    <c:v>1.8985628528012857</c:v>
                  </c:pt>
                  <c:pt idx="4">
                    <c:v>1.7586247770645489</c:v>
                  </c:pt>
                </c:numCache>
              </c:numRef>
            </c:plus>
            <c:minus>
              <c:numRef>
                <c:f>MCA!$Z$75:$Z$79</c:f>
                <c:numCache>
                  <c:formatCode>General</c:formatCode>
                  <c:ptCount val="5"/>
                  <c:pt idx="0">
                    <c:v>18.715638928432412</c:v>
                  </c:pt>
                  <c:pt idx="1">
                    <c:v>18.937548364912733</c:v>
                  </c:pt>
                  <c:pt idx="2">
                    <c:v>7.8880975242859401</c:v>
                  </c:pt>
                  <c:pt idx="3">
                    <c:v>1.8985628528012857</c:v>
                  </c:pt>
                  <c:pt idx="4">
                    <c:v>1.7586247770645489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Z$42:$Z$46</c:f>
              <c:numCache>
                <c:formatCode>General</c:formatCode>
                <c:ptCount val="5"/>
                <c:pt idx="0">
                  <c:v>81.680950408403746</c:v>
                </c:pt>
                <c:pt idx="1">
                  <c:v>52.575162242125174</c:v>
                </c:pt>
                <c:pt idx="2">
                  <c:v>38.854257573868587</c:v>
                </c:pt>
                <c:pt idx="3">
                  <c:v>32.697837531318996</c:v>
                </c:pt>
                <c:pt idx="4">
                  <c:v>10.39549408608853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A468-4736-8652-D28F65F464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5805184"/>
        <c:axId val="155806720"/>
      </c:scatterChart>
      <c:valAx>
        <c:axId val="155805184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155806720"/>
        <c:crosses val="autoZero"/>
        <c:crossBetween val="midCat"/>
      </c:valAx>
      <c:valAx>
        <c:axId val="155806720"/>
        <c:scaling>
          <c:orientation val="minMax"/>
          <c:max val="150"/>
          <c:min val="0"/>
        </c:scaling>
        <c:delete val="0"/>
        <c:axPos val="l"/>
        <c:majorGridlines>
          <c:spPr>
            <a:ln w="9525">
              <a:solidFill>
                <a:sysClr val="windowText" lastClr="000000"/>
              </a:solidFill>
              <a:prstDash val="sysDot"/>
            </a:ln>
          </c:spPr>
        </c:majorGridlines>
        <c:minorGridlines>
          <c:spPr>
            <a:ln w="6350">
              <a:solidFill>
                <a:sysClr val="windowText" lastClr="000000"/>
              </a:solidFill>
              <a:prstDash val="sysDot"/>
            </a:ln>
          </c:spPr>
        </c:minorGridlines>
        <c:numFmt formatCode="General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55805184"/>
        <c:crossesAt val="0.1"/>
        <c:crossBetween val="midCat"/>
        <c:majorUnit val="50"/>
        <c:minorUnit val="50"/>
      </c:valAx>
      <c:spPr>
        <a:noFill/>
      </c:spPr>
    </c:plotArea>
    <c:legend>
      <c:legendPos val="r"/>
      <c:layout>
        <c:manualLayout>
          <c:xMode val="edge"/>
          <c:yMode val="edge"/>
          <c:x val="0.64529309675131641"/>
          <c:y val="8.5526388888888902E-2"/>
          <c:w val="0.26358475604627973"/>
          <c:h val="0.22849027777777778"/>
        </c:manualLayout>
      </c:layout>
      <c:overlay val="0"/>
      <c:spPr>
        <a:noFill/>
      </c:spPr>
      <c:txPr>
        <a:bodyPr/>
        <a:lstStyle/>
        <a:p>
          <a:pPr>
            <a:defRPr sz="600">
              <a:latin typeface="+mn-lt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676918889819596"/>
          <c:y val="7.7828830394782861E-2"/>
          <c:w val="0.72844125955808425"/>
          <c:h val="0.74162361283594025"/>
        </c:manualLayout>
      </c:layout>
      <c:scatterChart>
        <c:scatterStyle val="lineMarker"/>
        <c:varyColors val="0"/>
        <c:ser>
          <c:idx val="0"/>
          <c:order val="0"/>
          <c:tx>
            <c:v>21</c:v>
          </c:tx>
          <c:spPr>
            <a:ln w="15875">
              <a:solidFill>
                <a:srgbClr val="1F497D"/>
              </a:solidFill>
            </a:ln>
          </c:spPr>
          <c:marker>
            <c:symbol val="circle"/>
            <c:size val="4"/>
            <c:spPr>
              <a:solidFill>
                <a:srgbClr val="1F497D"/>
              </a:solidFill>
              <a:ln w="952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AA$75:$AA$79</c:f>
                <c:numCache>
                  <c:formatCode>General</c:formatCode>
                  <c:ptCount val="5"/>
                  <c:pt idx="0">
                    <c:v>21.66452842822882</c:v>
                  </c:pt>
                  <c:pt idx="1">
                    <c:v>18.780477471998051</c:v>
                  </c:pt>
                  <c:pt idx="2">
                    <c:v>10.221933080039241</c:v>
                  </c:pt>
                  <c:pt idx="3">
                    <c:v>3.0623726130559765</c:v>
                  </c:pt>
                  <c:pt idx="4">
                    <c:v>1.6282972417289499</c:v>
                  </c:pt>
                </c:numCache>
              </c:numRef>
            </c:plus>
            <c:minus>
              <c:numRef>
                <c:f>MCA!$AA$75:$AA$79</c:f>
                <c:numCache>
                  <c:formatCode>General</c:formatCode>
                  <c:ptCount val="5"/>
                  <c:pt idx="0">
                    <c:v>21.66452842822882</c:v>
                  </c:pt>
                  <c:pt idx="1">
                    <c:v>18.780477471998051</c:v>
                  </c:pt>
                  <c:pt idx="2">
                    <c:v>10.221933080039241</c:v>
                  </c:pt>
                  <c:pt idx="3">
                    <c:v>3.0623726130559765</c:v>
                  </c:pt>
                  <c:pt idx="4">
                    <c:v>1.6282972417289499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AA$42:$AA$46</c:f>
              <c:numCache>
                <c:formatCode>General</c:formatCode>
                <c:ptCount val="5"/>
                <c:pt idx="0">
                  <c:v>83.9301978310599</c:v>
                </c:pt>
                <c:pt idx="1">
                  <c:v>52.3037928210342</c:v>
                </c:pt>
                <c:pt idx="2">
                  <c:v>35.617533677878505</c:v>
                </c:pt>
                <c:pt idx="3">
                  <c:v>30.533021265779887</c:v>
                </c:pt>
                <c:pt idx="4">
                  <c:v>9.619376429721256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7A0F-4C03-AA03-E40A53343245}"/>
            </c:ext>
          </c:extLst>
        </c:ser>
        <c:ser>
          <c:idx val="1"/>
          <c:order val="1"/>
          <c:tx>
            <c:v>22</c:v>
          </c:tx>
          <c:spPr>
            <a:ln w="1587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AB$75:$AB$79</c:f>
                <c:numCache>
                  <c:formatCode>General</c:formatCode>
                  <c:ptCount val="5"/>
                  <c:pt idx="0">
                    <c:v>23.495874767601393</c:v>
                  </c:pt>
                  <c:pt idx="1">
                    <c:v>18.612138197445859</c:v>
                  </c:pt>
                  <c:pt idx="2">
                    <c:v>11.491405711951556</c:v>
                  </c:pt>
                  <c:pt idx="3">
                    <c:v>3.4080139612491092</c:v>
                  </c:pt>
                  <c:pt idx="4">
                    <c:v>1.4275199611113858</c:v>
                  </c:pt>
                </c:numCache>
              </c:numRef>
            </c:plus>
            <c:minus>
              <c:numRef>
                <c:f>MCA!$AB$75:$AB$79</c:f>
                <c:numCache>
                  <c:formatCode>General</c:formatCode>
                  <c:ptCount val="5"/>
                  <c:pt idx="0">
                    <c:v>23.495874767601393</c:v>
                  </c:pt>
                  <c:pt idx="1">
                    <c:v>18.612138197445859</c:v>
                  </c:pt>
                  <c:pt idx="2">
                    <c:v>11.491405711951556</c:v>
                  </c:pt>
                  <c:pt idx="3">
                    <c:v>3.4080139612491092</c:v>
                  </c:pt>
                  <c:pt idx="4">
                    <c:v>1.4275199611113858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AB$42:$AB$46</c:f>
              <c:numCache>
                <c:formatCode>General</c:formatCode>
                <c:ptCount val="5"/>
                <c:pt idx="0">
                  <c:v>81.567106641043054</c:v>
                </c:pt>
                <c:pt idx="1">
                  <c:v>49.125613259838055</c:v>
                </c:pt>
                <c:pt idx="2">
                  <c:v>32.170680905418934</c:v>
                </c:pt>
                <c:pt idx="3">
                  <c:v>25.661687706417798</c:v>
                </c:pt>
                <c:pt idx="4">
                  <c:v>7.928169484113740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7A0F-4C03-AA03-E40A53343245}"/>
            </c:ext>
          </c:extLst>
        </c:ser>
        <c:ser>
          <c:idx val="2"/>
          <c:order val="2"/>
          <c:tx>
            <c:v>23</c:v>
          </c:tx>
          <c:spPr>
            <a:ln w="15875">
              <a:solidFill>
                <a:srgbClr val="C0504D"/>
              </a:solidFill>
            </a:ln>
          </c:spPr>
          <c:marker>
            <c:symbol val="circle"/>
            <c:size val="4"/>
            <c:spPr>
              <a:solidFill>
                <a:srgbClr val="C0504D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AC$75:$AC$79</c:f>
                <c:numCache>
                  <c:formatCode>General</c:formatCode>
                  <c:ptCount val="5"/>
                  <c:pt idx="0">
                    <c:v>22.859532195252228</c:v>
                  </c:pt>
                  <c:pt idx="1">
                    <c:v>19.704208371736101</c:v>
                  </c:pt>
                  <c:pt idx="2">
                    <c:v>11.623966447555169</c:v>
                  </c:pt>
                  <c:pt idx="3">
                    <c:v>2.9393275450117762</c:v>
                  </c:pt>
                  <c:pt idx="4">
                    <c:v>1.7847073259461237</c:v>
                  </c:pt>
                </c:numCache>
              </c:numRef>
            </c:plus>
            <c:minus>
              <c:numRef>
                <c:f>MCA!$AC$75:$AC$79</c:f>
                <c:numCache>
                  <c:formatCode>General</c:formatCode>
                  <c:ptCount val="5"/>
                  <c:pt idx="0">
                    <c:v>22.859532195252228</c:v>
                  </c:pt>
                  <c:pt idx="1">
                    <c:v>19.704208371736101</c:v>
                  </c:pt>
                  <c:pt idx="2">
                    <c:v>11.623966447555169</c:v>
                  </c:pt>
                  <c:pt idx="3">
                    <c:v>2.9393275450117762</c:v>
                  </c:pt>
                  <c:pt idx="4">
                    <c:v>1.7847073259461237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AC$42:$AC$46</c:f>
              <c:numCache>
                <c:formatCode>General</c:formatCode>
                <c:ptCount val="5"/>
                <c:pt idx="0">
                  <c:v>73.481128551776919</c:v>
                </c:pt>
                <c:pt idx="1">
                  <c:v>43.320974045495539</c:v>
                </c:pt>
                <c:pt idx="2">
                  <c:v>29.573695669997907</c:v>
                </c:pt>
                <c:pt idx="3">
                  <c:v>24.43699951716787</c:v>
                </c:pt>
                <c:pt idx="4">
                  <c:v>6.889923384562125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7A0F-4C03-AA03-E40A53343245}"/>
            </c:ext>
          </c:extLst>
        </c:ser>
        <c:ser>
          <c:idx val="3"/>
          <c:order val="3"/>
          <c:tx>
            <c:v>24</c:v>
          </c:tx>
          <c:spPr>
            <a:ln w="15875">
              <a:solidFill>
                <a:srgbClr val="F79646"/>
              </a:solidFill>
            </a:ln>
          </c:spPr>
          <c:marker>
            <c:symbol val="circle"/>
            <c:size val="4"/>
            <c:spPr>
              <a:solidFill>
                <a:srgbClr val="F79646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AD$75:$AD$79</c:f>
                <c:numCache>
                  <c:formatCode>General</c:formatCode>
                  <c:ptCount val="5"/>
                  <c:pt idx="0">
                    <c:v>19.437734182750237</c:v>
                  </c:pt>
                  <c:pt idx="1">
                    <c:v>21.285911214436407</c:v>
                  </c:pt>
                  <c:pt idx="2">
                    <c:v>12.5642816995309</c:v>
                  </c:pt>
                  <c:pt idx="3">
                    <c:v>4.168339727612417</c:v>
                  </c:pt>
                  <c:pt idx="4">
                    <c:v>1.6534171036850493</c:v>
                  </c:pt>
                </c:numCache>
              </c:numRef>
            </c:plus>
            <c:minus>
              <c:numRef>
                <c:f>MCA!$AD$75:$AD$79</c:f>
                <c:numCache>
                  <c:formatCode>General</c:formatCode>
                  <c:ptCount val="5"/>
                  <c:pt idx="0">
                    <c:v>19.437734182750237</c:v>
                  </c:pt>
                  <c:pt idx="1">
                    <c:v>21.285911214436407</c:v>
                  </c:pt>
                  <c:pt idx="2">
                    <c:v>12.5642816995309</c:v>
                  </c:pt>
                  <c:pt idx="3">
                    <c:v>4.168339727612417</c:v>
                  </c:pt>
                  <c:pt idx="4">
                    <c:v>1.6534171036850493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AD$42:$AD$46</c:f>
              <c:numCache>
                <c:formatCode>General</c:formatCode>
                <c:ptCount val="5"/>
                <c:pt idx="0">
                  <c:v>75.571148776566176</c:v>
                </c:pt>
                <c:pt idx="1">
                  <c:v>45.950666377389624</c:v>
                </c:pt>
                <c:pt idx="2">
                  <c:v>28.060664960724697</c:v>
                </c:pt>
                <c:pt idx="3">
                  <c:v>22.713993182176175</c:v>
                </c:pt>
                <c:pt idx="4">
                  <c:v>6.008244395505110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7A0F-4C03-AA03-E40A533432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5865472"/>
        <c:axId val="155867008"/>
      </c:scatterChart>
      <c:valAx>
        <c:axId val="155865472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155867008"/>
        <c:crosses val="autoZero"/>
        <c:crossBetween val="midCat"/>
      </c:valAx>
      <c:valAx>
        <c:axId val="155867008"/>
        <c:scaling>
          <c:orientation val="minMax"/>
          <c:max val="150"/>
          <c:min val="0"/>
        </c:scaling>
        <c:delete val="0"/>
        <c:axPos val="l"/>
        <c:majorGridlines>
          <c:spPr>
            <a:ln w="9525">
              <a:solidFill>
                <a:sysClr val="windowText" lastClr="000000"/>
              </a:solidFill>
              <a:prstDash val="sysDot"/>
            </a:ln>
          </c:spPr>
        </c:majorGridlines>
        <c:minorGridlines>
          <c:spPr>
            <a:ln w="6350">
              <a:solidFill>
                <a:sysClr val="windowText" lastClr="000000"/>
              </a:solidFill>
              <a:prstDash val="sysDot"/>
            </a:ln>
          </c:spPr>
        </c:minorGridlines>
        <c:numFmt formatCode="General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55865472"/>
        <c:crossesAt val="0.1"/>
        <c:crossBetween val="midCat"/>
        <c:majorUnit val="50"/>
        <c:minorUnit val="50"/>
      </c:valAx>
      <c:spPr>
        <a:noFill/>
      </c:spPr>
    </c:plotArea>
    <c:legend>
      <c:legendPos val="r"/>
      <c:layout>
        <c:manualLayout>
          <c:xMode val="edge"/>
          <c:yMode val="edge"/>
          <c:x val="0.63750992761248415"/>
          <c:y val="8.3355555555555558E-2"/>
          <c:w val="0.26358475604627973"/>
          <c:h val="0.23730972222222221"/>
        </c:manualLayout>
      </c:layout>
      <c:overlay val="0"/>
      <c:spPr>
        <a:noFill/>
      </c:spPr>
      <c:txPr>
        <a:bodyPr/>
        <a:lstStyle/>
        <a:p>
          <a:pPr>
            <a:defRPr sz="600">
              <a:latin typeface="+mn-lt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676918889819596"/>
          <c:y val="7.7828830394782861E-2"/>
          <c:w val="0.72844125955808425"/>
          <c:h val="0.74162361283594025"/>
        </c:manualLayout>
      </c:layout>
      <c:scatterChart>
        <c:scatterStyle val="lineMarker"/>
        <c:varyColors val="0"/>
        <c:ser>
          <c:idx val="0"/>
          <c:order val="0"/>
          <c:tx>
            <c:v>25</c:v>
          </c:tx>
          <c:spPr>
            <a:ln w="15875">
              <a:solidFill>
                <a:srgbClr val="1F497D"/>
              </a:solidFill>
            </a:ln>
          </c:spPr>
          <c:marker>
            <c:symbol val="circle"/>
            <c:size val="4"/>
            <c:spPr>
              <a:solidFill>
                <a:srgbClr val="1F497D"/>
              </a:solidFill>
              <a:ln w="952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AE$75:$AE$79</c:f>
                <c:numCache>
                  <c:formatCode>General</c:formatCode>
                  <c:ptCount val="5"/>
                  <c:pt idx="0">
                    <c:v>18.549413771350522</c:v>
                  </c:pt>
                  <c:pt idx="1">
                    <c:v>19.329216157624373</c:v>
                  </c:pt>
                  <c:pt idx="2">
                    <c:v>12.519973585603106</c:v>
                  </c:pt>
                  <c:pt idx="3">
                    <c:v>3.6379174405983092</c:v>
                  </c:pt>
                  <c:pt idx="4">
                    <c:v>1.4115899875933937</c:v>
                  </c:pt>
                </c:numCache>
              </c:numRef>
            </c:plus>
            <c:minus>
              <c:numRef>
                <c:f>MCA!$AE$75:$AE$79</c:f>
                <c:numCache>
                  <c:formatCode>General</c:formatCode>
                  <c:ptCount val="5"/>
                  <c:pt idx="0">
                    <c:v>18.549413771350522</c:v>
                  </c:pt>
                  <c:pt idx="1">
                    <c:v>19.329216157624373</c:v>
                  </c:pt>
                  <c:pt idx="2">
                    <c:v>12.519973585603106</c:v>
                  </c:pt>
                  <c:pt idx="3">
                    <c:v>3.6379174405983092</c:v>
                  </c:pt>
                  <c:pt idx="4">
                    <c:v>1.4115899875933937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AE$42:$AE$46</c:f>
              <c:numCache>
                <c:formatCode>General</c:formatCode>
                <c:ptCount val="5"/>
                <c:pt idx="0">
                  <c:v>75.75735057343141</c:v>
                </c:pt>
                <c:pt idx="1">
                  <c:v>44.799897616275715</c:v>
                </c:pt>
                <c:pt idx="2">
                  <c:v>26.894924574570855</c:v>
                </c:pt>
                <c:pt idx="3">
                  <c:v>20.770478809046097</c:v>
                </c:pt>
                <c:pt idx="4">
                  <c:v>5.200824849520695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2580-400A-BD4E-5364675E00E4}"/>
            </c:ext>
          </c:extLst>
        </c:ser>
        <c:ser>
          <c:idx val="1"/>
          <c:order val="1"/>
          <c:tx>
            <c:v>26</c:v>
          </c:tx>
          <c:spPr>
            <a:ln w="1587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AF$75:$AF$79</c:f>
                <c:numCache>
                  <c:formatCode>General</c:formatCode>
                  <c:ptCount val="5"/>
                  <c:pt idx="0">
                    <c:v>17.436632069632061</c:v>
                  </c:pt>
                  <c:pt idx="1">
                    <c:v>16.136522708527107</c:v>
                  </c:pt>
                  <c:pt idx="2">
                    <c:v>12.931553253971151</c:v>
                  </c:pt>
                  <c:pt idx="3">
                    <c:v>3.5260406004007909</c:v>
                  </c:pt>
                  <c:pt idx="4">
                    <c:v>1.3736896409215358</c:v>
                  </c:pt>
                </c:numCache>
              </c:numRef>
            </c:plus>
            <c:minus>
              <c:numRef>
                <c:f>MCA!$AF$75:$AF$79</c:f>
                <c:numCache>
                  <c:formatCode>General</c:formatCode>
                  <c:ptCount val="5"/>
                  <c:pt idx="0">
                    <c:v>17.436632069632061</c:v>
                  </c:pt>
                  <c:pt idx="1">
                    <c:v>16.136522708527107</c:v>
                  </c:pt>
                  <c:pt idx="2">
                    <c:v>12.931553253971151</c:v>
                  </c:pt>
                  <c:pt idx="3">
                    <c:v>3.5260406004007909</c:v>
                  </c:pt>
                  <c:pt idx="4">
                    <c:v>1.3736896409215358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AF$42:$AF$46</c:f>
              <c:numCache>
                <c:formatCode>General</c:formatCode>
                <c:ptCount val="5"/>
                <c:pt idx="0">
                  <c:v>81.321003472415654</c:v>
                </c:pt>
                <c:pt idx="1">
                  <c:v>44.546450522719248</c:v>
                </c:pt>
                <c:pt idx="2">
                  <c:v>28.073087850259036</c:v>
                </c:pt>
                <c:pt idx="3">
                  <c:v>20.612779232354743</c:v>
                </c:pt>
                <c:pt idx="4">
                  <c:v>5.125805433309194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2580-400A-BD4E-5364675E00E4}"/>
            </c:ext>
          </c:extLst>
        </c:ser>
        <c:ser>
          <c:idx val="2"/>
          <c:order val="2"/>
          <c:tx>
            <c:v>27</c:v>
          </c:tx>
          <c:spPr>
            <a:ln w="15875">
              <a:solidFill>
                <a:srgbClr val="C0504D"/>
              </a:solidFill>
            </a:ln>
          </c:spPr>
          <c:marker>
            <c:symbol val="circle"/>
            <c:size val="4"/>
            <c:spPr>
              <a:solidFill>
                <a:srgbClr val="C0504D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AG$75:$AG$79</c:f>
                <c:numCache>
                  <c:formatCode>General</c:formatCode>
                  <c:ptCount val="5"/>
                  <c:pt idx="0">
                    <c:v>17.127376554476662</c:v>
                  </c:pt>
                  <c:pt idx="1">
                    <c:v>15.873777776334803</c:v>
                  </c:pt>
                  <c:pt idx="2">
                    <c:v>14.005534806406709</c:v>
                  </c:pt>
                  <c:pt idx="3">
                    <c:v>3.0721221096803037</c:v>
                  </c:pt>
                  <c:pt idx="4">
                    <c:v>1.4321016322725568</c:v>
                  </c:pt>
                </c:numCache>
              </c:numRef>
            </c:plus>
            <c:minus>
              <c:numRef>
                <c:f>MCA!$AG$75:$AG$79</c:f>
                <c:numCache>
                  <c:formatCode>General</c:formatCode>
                  <c:ptCount val="5"/>
                  <c:pt idx="0">
                    <c:v>17.127376554476662</c:v>
                  </c:pt>
                  <c:pt idx="1">
                    <c:v>15.873777776334803</c:v>
                  </c:pt>
                  <c:pt idx="2">
                    <c:v>14.005534806406709</c:v>
                  </c:pt>
                  <c:pt idx="3">
                    <c:v>3.0721221096803037</c:v>
                  </c:pt>
                  <c:pt idx="4">
                    <c:v>1.4321016322725568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AG$42:$AG$46</c:f>
              <c:numCache>
                <c:formatCode>General</c:formatCode>
                <c:ptCount val="5"/>
                <c:pt idx="0">
                  <c:v>95.255879092023108</c:v>
                </c:pt>
                <c:pt idx="1">
                  <c:v>50.229080794523981</c:v>
                </c:pt>
                <c:pt idx="2">
                  <c:v>32.194029929923026</c:v>
                </c:pt>
                <c:pt idx="3">
                  <c:v>22.710031988202033</c:v>
                </c:pt>
                <c:pt idx="4">
                  <c:v>5.782278642172440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2580-400A-BD4E-5364675E00E4}"/>
            </c:ext>
          </c:extLst>
        </c:ser>
        <c:ser>
          <c:idx val="3"/>
          <c:order val="3"/>
          <c:tx>
            <c:v>28</c:v>
          </c:tx>
          <c:spPr>
            <a:ln w="15875">
              <a:solidFill>
                <a:srgbClr val="F79646"/>
              </a:solidFill>
            </a:ln>
          </c:spPr>
          <c:marker>
            <c:symbol val="circle"/>
            <c:size val="4"/>
            <c:spPr>
              <a:solidFill>
                <a:srgbClr val="F79646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MCA!$AH$75:$AH$79</c:f>
                <c:numCache>
                  <c:formatCode>General</c:formatCode>
                  <c:ptCount val="5"/>
                  <c:pt idx="0">
                    <c:v>19.725883263951896</c:v>
                  </c:pt>
                  <c:pt idx="1">
                    <c:v>15.876291335769599</c:v>
                  </c:pt>
                  <c:pt idx="2">
                    <c:v>17.100032013394216</c:v>
                  </c:pt>
                  <c:pt idx="3">
                    <c:v>3.4458652767512175</c:v>
                  </c:pt>
                  <c:pt idx="4">
                    <c:v>2.1459060794713141</c:v>
                  </c:pt>
                </c:numCache>
              </c:numRef>
            </c:plus>
            <c:minus>
              <c:numRef>
                <c:f>MCA!$AH$75:$AH$79</c:f>
                <c:numCache>
                  <c:formatCode>General</c:formatCode>
                  <c:ptCount val="5"/>
                  <c:pt idx="0">
                    <c:v>19.725883263951896</c:v>
                  </c:pt>
                  <c:pt idx="1">
                    <c:v>15.876291335769599</c:v>
                  </c:pt>
                  <c:pt idx="2">
                    <c:v>17.100032013394216</c:v>
                  </c:pt>
                  <c:pt idx="3">
                    <c:v>3.4458652767512175</c:v>
                  </c:pt>
                  <c:pt idx="4">
                    <c:v>2.1459060794713141</c:v>
                  </c:pt>
                </c:numCache>
              </c:numRef>
            </c:minus>
          </c:errBars>
          <c:xVal>
            <c:numRef>
              <c:f>MCA!$A$42:$A$46</c:f>
              <c:numCache>
                <c:formatCode>General</c:formatCode>
                <c:ptCount val="5"/>
                <c:pt idx="0">
                  <c:v>0.23125000000000001</c:v>
                </c:pt>
                <c:pt idx="1">
                  <c:v>0.46250000000000002</c:v>
                </c:pt>
                <c:pt idx="2">
                  <c:v>0.92500000000000004</c:v>
                </c:pt>
                <c:pt idx="3">
                  <c:v>1.85</c:v>
                </c:pt>
                <c:pt idx="4">
                  <c:v>3.7</c:v>
                </c:pt>
              </c:numCache>
            </c:numRef>
          </c:xVal>
          <c:yVal>
            <c:numRef>
              <c:f>MCA!$AH$42:$AH$46</c:f>
              <c:numCache>
                <c:formatCode>General</c:formatCode>
                <c:ptCount val="5"/>
                <c:pt idx="0">
                  <c:v>121.65649057605521</c:v>
                </c:pt>
                <c:pt idx="1">
                  <c:v>61.660282907960109</c:v>
                </c:pt>
                <c:pt idx="2">
                  <c:v>38.76369979900641</c:v>
                </c:pt>
                <c:pt idx="3">
                  <c:v>27.299480450529028</c:v>
                </c:pt>
                <c:pt idx="4">
                  <c:v>6.795858773559861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2580-400A-BD4E-5364675E00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5900928"/>
        <c:axId val="155906816"/>
      </c:scatterChart>
      <c:valAx>
        <c:axId val="155900928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155906816"/>
        <c:crosses val="autoZero"/>
        <c:crossBetween val="midCat"/>
      </c:valAx>
      <c:valAx>
        <c:axId val="155906816"/>
        <c:scaling>
          <c:orientation val="minMax"/>
          <c:max val="150"/>
          <c:min val="0"/>
        </c:scaling>
        <c:delete val="0"/>
        <c:axPos val="l"/>
        <c:majorGridlines>
          <c:spPr>
            <a:ln w="6350">
              <a:solidFill>
                <a:sysClr val="windowText" lastClr="000000"/>
              </a:solidFill>
              <a:prstDash val="sysDot"/>
            </a:ln>
          </c:spPr>
        </c:majorGridlines>
        <c:minorGridlines>
          <c:spPr>
            <a:ln>
              <a:solidFill>
                <a:sysClr val="windowText" lastClr="000000"/>
              </a:solidFill>
              <a:prstDash val="sysDot"/>
            </a:ln>
          </c:spPr>
        </c:minorGridlines>
        <c:numFmt formatCode="General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55900928"/>
        <c:crossesAt val="0.1"/>
        <c:crossBetween val="midCat"/>
        <c:majorUnit val="50"/>
        <c:minorUnit val="50"/>
      </c:valAx>
      <c:spPr>
        <a:noFill/>
      </c:spPr>
    </c:plotArea>
    <c:legend>
      <c:legendPos val="r"/>
      <c:layout>
        <c:manualLayout>
          <c:xMode val="edge"/>
          <c:yMode val="edge"/>
          <c:x val="0.62571118707889839"/>
          <c:y val="8.3355555555555558E-2"/>
          <c:w val="0.27121394158566914"/>
          <c:h val="0.23730972222222221"/>
        </c:manualLayout>
      </c:layout>
      <c:overlay val="0"/>
      <c:spPr>
        <a:noFill/>
      </c:spPr>
      <c:txPr>
        <a:bodyPr/>
        <a:lstStyle/>
        <a:p>
          <a:pPr>
            <a:defRPr sz="600">
              <a:latin typeface="+mn-lt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676918889819596"/>
          <c:y val="7.7828830394782861E-2"/>
          <c:w val="0.72844125955808425"/>
          <c:h val="0.74162361283594025"/>
        </c:manualLayout>
      </c:layout>
      <c:scatterChart>
        <c:scatterStyle val="lineMarker"/>
        <c:varyColors val="0"/>
        <c:ser>
          <c:idx val="0"/>
          <c:order val="0"/>
          <c:tx>
            <c:v>13</c:v>
          </c:tx>
          <c:spPr>
            <a:ln w="15875">
              <a:solidFill>
                <a:srgbClr val="1F497D"/>
              </a:solidFill>
            </a:ln>
          </c:spPr>
          <c:marker>
            <c:symbol val="circle"/>
            <c:size val="4"/>
            <c:spPr>
              <a:solidFill>
                <a:srgbClr val="1F497D"/>
              </a:solidFill>
              <a:ln w="952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S$75:$S$79</c:f>
                <c:numCache>
                  <c:formatCode>General</c:formatCode>
                  <c:ptCount val="5"/>
                  <c:pt idx="0">
                    <c:v>28.259857049778578</c:v>
                  </c:pt>
                  <c:pt idx="1">
                    <c:v>23.672598007915546</c:v>
                  </c:pt>
                  <c:pt idx="2">
                    <c:v>15.99944135985478</c:v>
                  </c:pt>
                  <c:pt idx="3">
                    <c:v>19.041166261322715</c:v>
                  </c:pt>
                  <c:pt idx="4">
                    <c:v>6.3223945991574473</c:v>
                  </c:pt>
                </c:numCache>
              </c:numRef>
            </c:plus>
            <c:minus>
              <c:numRef>
                <c:f>APAP!$S$75:$S$79</c:f>
                <c:numCache>
                  <c:formatCode>General</c:formatCode>
                  <c:ptCount val="5"/>
                  <c:pt idx="0">
                    <c:v>28.259857049778578</c:v>
                  </c:pt>
                  <c:pt idx="1">
                    <c:v>23.672598007915546</c:v>
                  </c:pt>
                  <c:pt idx="2">
                    <c:v>15.99944135985478</c:v>
                  </c:pt>
                  <c:pt idx="3">
                    <c:v>19.041166261322715</c:v>
                  </c:pt>
                  <c:pt idx="4">
                    <c:v>6.3223945991574473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S$42:$S$46</c:f>
              <c:numCache>
                <c:formatCode>General</c:formatCode>
                <c:ptCount val="5"/>
                <c:pt idx="0">
                  <c:v>136.19714440280859</c:v>
                </c:pt>
                <c:pt idx="1">
                  <c:v>129.51501298642444</c:v>
                </c:pt>
                <c:pt idx="2">
                  <c:v>133.92813139938991</c:v>
                </c:pt>
                <c:pt idx="3">
                  <c:v>96.458402372394573</c:v>
                </c:pt>
                <c:pt idx="4">
                  <c:v>8.608144201710185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82D-4BA1-BF42-34CA668B5551}"/>
            </c:ext>
          </c:extLst>
        </c:ser>
        <c:ser>
          <c:idx val="1"/>
          <c:order val="1"/>
          <c:tx>
            <c:v>14</c:v>
          </c:tx>
          <c:spPr>
            <a:ln w="1587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T$75:$T$79</c:f>
                <c:numCache>
                  <c:formatCode>General</c:formatCode>
                  <c:ptCount val="5"/>
                  <c:pt idx="0">
                    <c:v>31.945574136830579</c:v>
                  </c:pt>
                  <c:pt idx="1">
                    <c:v>19.335040733903167</c:v>
                  </c:pt>
                  <c:pt idx="2">
                    <c:v>15.927645909346724</c:v>
                  </c:pt>
                  <c:pt idx="3">
                    <c:v>14.617668776232522</c:v>
                  </c:pt>
                  <c:pt idx="4">
                    <c:v>5.4083234433536713</c:v>
                  </c:pt>
                </c:numCache>
              </c:numRef>
            </c:plus>
            <c:minus>
              <c:numRef>
                <c:f>APAP!$T$75:$T$79</c:f>
                <c:numCache>
                  <c:formatCode>General</c:formatCode>
                  <c:ptCount val="5"/>
                  <c:pt idx="0">
                    <c:v>31.945574136830579</c:v>
                  </c:pt>
                  <c:pt idx="1">
                    <c:v>19.335040733903167</c:v>
                  </c:pt>
                  <c:pt idx="2">
                    <c:v>15.927645909346724</c:v>
                  </c:pt>
                  <c:pt idx="3">
                    <c:v>14.617668776232522</c:v>
                  </c:pt>
                  <c:pt idx="4">
                    <c:v>5.4083234433536713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T$42:$T$46</c:f>
              <c:numCache>
                <c:formatCode>General</c:formatCode>
                <c:ptCount val="5"/>
                <c:pt idx="0">
                  <c:v>127.13127197887925</c:v>
                </c:pt>
                <c:pt idx="1">
                  <c:v>106.28749338223177</c:v>
                </c:pt>
                <c:pt idx="2">
                  <c:v>104.09653001048325</c:v>
                </c:pt>
                <c:pt idx="3">
                  <c:v>73.772951822647329</c:v>
                </c:pt>
                <c:pt idx="4">
                  <c:v>6.66124389499924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E82D-4BA1-BF42-34CA668B5551}"/>
            </c:ext>
          </c:extLst>
        </c:ser>
        <c:ser>
          <c:idx val="2"/>
          <c:order val="2"/>
          <c:tx>
            <c:v>15</c:v>
          </c:tx>
          <c:spPr>
            <a:ln w="15875">
              <a:solidFill>
                <a:srgbClr val="C0504D"/>
              </a:solidFill>
            </a:ln>
          </c:spPr>
          <c:marker>
            <c:symbol val="circle"/>
            <c:size val="4"/>
            <c:spPr>
              <a:solidFill>
                <a:srgbClr val="C0504D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U$75:$U$79</c:f>
                <c:numCache>
                  <c:formatCode>General</c:formatCode>
                  <c:ptCount val="5"/>
                  <c:pt idx="0">
                    <c:v>30.444722538080939</c:v>
                  </c:pt>
                  <c:pt idx="1">
                    <c:v>27.326826114342449</c:v>
                  </c:pt>
                  <c:pt idx="2">
                    <c:v>23.988284848819855</c:v>
                  </c:pt>
                  <c:pt idx="3">
                    <c:v>15.903734175112556</c:v>
                  </c:pt>
                  <c:pt idx="4">
                    <c:v>3.4422243365875365</c:v>
                  </c:pt>
                </c:numCache>
              </c:numRef>
            </c:plus>
            <c:minus>
              <c:numRef>
                <c:f>APAP!$U$75:$U$79</c:f>
                <c:numCache>
                  <c:formatCode>General</c:formatCode>
                  <c:ptCount val="5"/>
                  <c:pt idx="0">
                    <c:v>30.444722538080939</c:v>
                  </c:pt>
                  <c:pt idx="1">
                    <c:v>27.326826114342449</c:v>
                  </c:pt>
                  <c:pt idx="2">
                    <c:v>23.988284848819855</c:v>
                  </c:pt>
                  <c:pt idx="3">
                    <c:v>15.903734175112556</c:v>
                  </c:pt>
                  <c:pt idx="4">
                    <c:v>3.4422243365875365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U$42:$U$46</c:f>
              <c:numCache>
                <c:formatCode>General</c:formatCode>
                <c:ptCount val="5"/>
                <c:pt idx="0">
                  <c:v>143.8675843549872</c:v>
                </c:pt>
                <c:pt idx="1">
                  <c:v>130.15809186410146</c:v>
                </c:pt>
                <c:pt idx="2">
                  <c:v>116.92982077161591</c:v>
                </c:pt>
                <c:pt idx="3">
                  <c:v>66.331118872984803</c:v>
                </c:pt>
                <c:pt idx="4">
                  <c:v>4.255552490686305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E82D-4BA1-BF42-34CA668B5551}"/>
            </c:ext>
          </c:extLst>
        </c:ser>
        <c:ser>
          <c:idx val="3"/>
          <c:order val="3"/>
          <c:tx>
            <c:v>16</c:v>
          </c:tx>
          <c:spPr>
            <a:ln w="15875">
              <a:solidFill>
                <a:srgbClr val="F79646"/>
              </a:solidFill>
            </a:ln>
          </c:spPr>
          <c:marker>
            <c:symbol val="circle"/>
            <c:size val="4"/>
            <c:spPr>
              <a:solidFill>
                <a:srgbClr val="F79646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V$75:$V$79</c:f>
                <c:numCache>
                  <c:formatCode>General</c:formatCode>
                  <c:ptCount val="5"/>
                  <c:pt idx="0">
                    <c:v>33.288992267005568</c:v>
                  </c:pt>
                  <c:pt idx="1">
                    <c:v>23.854087746329562</c:v>
                  </c:pt>
                  <c:pt idx="2">
                    <c:v>19.108611829917987</c:v>
                  </c:pt>
                  <c:pt idx="3">
                    <c:v>11.600223382930418</c:v>
                  </c:pt>
                  <c:pt idx="4">
                    <c:v>2.5763857397959127</c:v>
                  </c:pt>
                </c:numCache>
              </c:numRef>
            </c:plus>
            <c:minus>
              <c:numRef>
                <c:f>APAP!$V$75:$V$79</c:f>
                <c:numCache>
                  <c:formatCode>General</c:formatCode>
                  <c:ptCount val="5"/>
                  <c:pt idx="0">
                    <c:v>33.288992267005568</c:v>
                  </c:pt>
                  <c:pt idx="1">
                    <c:v>23.854087746329562</c:v>
                  </c:pt>
                  <c:pt idx="2">
                    <c:v>19.108611829917987</c:v>
                  </c:pt>
                  <c:pt idx="3">
                    <c:v>11.600223382930418</c:v>
                  </c:pt>
                  <c:pt idx="4">
                    <c:v>2.5763857397959127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V$42:$V$46</c:f>
              <c:numCache>
                <c:formatCode>General</c:formatCode>
                <c:ptCount val="5"/>
                <c:pt idx="0">
                  <c:v>132.72504488952936</c:v>
                </c:pt>
                <c:pt idx="1">
                  <c:v>104.43231121352004</c:v>
                </c:pt>
                <c:pt idx="2">
                  <c:v>86.982421799742596</c:v>
                </c:pt>
                <c:pt idx="3">
                  <c:v>47.549378482310054</c:v>
                </c:pt>
                <c:pt idx="4">
                  <c:v>3.608501653013570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E82D-4BA1-BF42-34CA668B55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153536"/>
        <c:axId val="31163520"/>
      </c:scatterChart>
      <c:valAx>
        <c:axId val="31153536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31163520"/>
        <c:crosses val="autoZero"/>
        <c:crossBetween val="midCat"/>
      </c:valAx>
      <c:valAx>
        <c:axId val="31163520"/>
        <c:scaling>
          <c:orientation val="minMax"/>
          <c:max val="200"/>
          <c:min val="0"/>
        </c:scaling>
        <c:delete val="0"/>
        <c:axPos val="l"/>
        <c:majorGridlines>
          <c:spPr>
            <a:ln w="6350">
              <a:solidFill>
                <a:sysClr val="windowText" lastClr="000000"/>
              </a:solidFill>
              <a:prstDash val="sysDot"/>
            </a:ln>
          </c:spPr>
        </c:majorGridlines>
        <c:minorGridlines>
          <c:spPr>
            <a:ln>
              <a:solidFill>
                <a:sysClr val="windowText" lastClr="000000"/>
              </a:solidFill>
              <a:prstDash val="sysDot"/>
            </a:ln>
          </c:spPr>
        </c:minorGridlines>
        <c:numFmt formatCode="General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31153536"/>
        <c:crossesAt val="0.1"/>
        <c:crossBetween val="midCat"/>
        <c:majorUnit val="100"/>
        <c:minorUnit val="50"/>
      </c:valAx>
      <c:spPr>
        <a:noFill/>
      </c:spPr>
    </c:plotArea>
    <c:legend>
      <c:legendPos val="r"/>
      <c:layout>
        <c:manualLayout>
          <c:xMode val="edge"/>
          <c:yMode val="edge"/>
          <c:x val="0.62861229502623273"/>
          <c:y val="8.3355555555555558E-2"/>
          <c:w val="0.2788431271250586"/>
          <c:h val="0.23730972222222221"/>
        </c:manualLayout>
      </c:layout>
      <c:overlay val="0"/>
      <c:spPr>
        <a:noFill/>
      </c:spPr>
      <c:txPr>
        <a:bodyPr/>
        <a:lstStyle/>
        <a:p>
          <a:pPr>
            <a:defRPr sz="600">
              <a:latin typeface="+mn-lt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676918889819596"/>
          <c:y val="7.7828830394782861E-2"/>
          <c:w val="0.72844125955808425"/>
          <c:h val="0.74162361283594025"/>
        </c:manualLayout>
      </c:layout>
      <c:scatterChart>
        <c:scatterStyle val="lineMarker"/>
        <c:varyColors val="0"/>
        <c:ser>
          <c:idx val="0"/>
          <c:order val="0"/>
          <c:tx>
            <c:v>17</c:v>
          </c:tx>
          <c:spPr>
            <a:ln w="15875">
              <a:solidFill>
                <a:srgbClr val="1F497D"/>
              </a:solidFill>
            </a:ln>
          </c:spPr>
          <c:marker>
            <c:symbol val="circle"/>
            <c:size val="4"/>
            <c:spPr>
              <a:solidFill>
                <a:srgbClr val="1F497D"/>
              </a:solidFill>
              <a:ln w="952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W$75:$W$79</c:f>
                <c:numCache>
                  <c:formatCode>General</c:formatCode>
                  <c:ptCount val="5"/>
                  <c:pt idx="0">
                    <c:v>29.892038546524816</c:v>
                  </c:pt>
                  <c:pt idx="1">
                    <c:v>25.152739327122887</c:v>
                  </c:pt>
                  <c:pt idx="2">
                    <c:v>21.676371492960094</c:v>
                  </c:pt>
                  <c:pt idx="3">
                    <c:v>12.08532058095814</c:v>
                  </c:pt>
                  <c:pt idx="4">
                    <c:v>1.9754807878552405</c:v>
                  </c:pt>
                </c:numCache>
              </c:numRef>
            </c:plus>
            <c:minus>
              <c:numRef>
                <c:f>APAP!$W$75:$W$79</c:f>
                <c:numCache>
                  <c:formatCode>General</c:formatCode>
                  <c:ptCount val="5"/>
                  <c:pt idx="0">
                    <c:v>29.892038546524816</c:v>
                  </c:pt>
                  <c:pt idx="1">
                    <c:v>25.152739327122887</c:v>
                  </c:pt>
                  <c:pt idx="2">
                    <c:v>21.676371492960094</c:v>
                  </c:pt>
                  <c:pt idx="3">
                    <c:v>12.08532058095814</c:v>
                  </c:pt>
                  <c:pt idx="4">
                    <c:v>1.9754807878552405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W$42:$W$46</c:f>
              <c:numCache>
                <c:formatCode>General</c:formatCode>
                <c:ptCount val="5"/>
                <c:pt idx="0">
                  <c:v>128.10163577869409</c:v>
                </c:pt>
                <c:pt idx="1">
                  <c:v>104.38926397510838</c:v>
                </c:pt>
                <c:pt idx="2">
                  <c:v>85.203981452112316</c:v>
                </c:pt>
                <c:pt idx="3">
                  <c:v>42.00273384989503</c:v>
                </c:pt>
                <c:pt idx="4">
                  <c:v>3.083888410591025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762F-4658-A92E-95D1E9EF025A}"/>
            </c:ext>
          </c:extLst>
        </c:ser>
        <c:ser>
          <c:idx val="1"/>
          <c:order val="1"/>
          <c:tx>
            <c:v>18</c:v>
          </c:tx>
          <c:spPr>
            <a:ln w="1587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X$75:$X$79</c:f>
                <c:numCache>
                  <c:formatCode>General</c:formatCode>
                  <c:ptCount val="5"/>
                  <c:pt idx="0">
                    <c:v>34.825617686867893</c:v>
                  </c:pt>
                  <c:pt idx="1">
                    <c:v>30.031615401585292</c:v>
                  </c:pt>
                  <c:pt idx="2">
                    <c:v>17.514570527765105</c:v>
                  </c:pt>
                  <c:pt idx="3">
                    <c:v>10.192995309329275</c:v>
                  </c:pt>
                  <c:pt idx="4">
                    <c:v>2.5848275565183787</c:v>
                  </c:pt>
                </c:numCache>
              </c:numRef>
            </c:plus>
            <c:minus>
              <c:numRef>
                <c:f>APAP!$X$75:$X$79</c:f>
                <c:numCache>
                  <c:formatCode>General</c:formatCode>
                  <c:ptCount val="5"/>
                  <c:pt idx="0">
                    <c:v>34.825617686867893</c:v>
                  </c:pt>
                  <c:pt idx="1">
                    <c:v>30.031615401585292</c:v>
                  </c:pt>
                  <c:pt idx="2">
                    <c:v>17.514570527765105</c:v>
                  </c:pt>
                  <c:pt idx="3">
                    <c:v>10.192995309329275</c:v>
                  </c:pt>
                  <c:pt idx="4">
                    <c:v>2.5848275565183787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X$42:$X$46</c:f>
              <c:numCache>
                <c:formatCode>General</c:formatCode>
                <c:ptCount val="5"/>
                <c:pt idx="0">
                  <c:v>129.2584927972479</c:v>
                </c:pt>
                <c:pt idx="1">
                  <c:v>93.11304020640722</c:v>
                </c:pt>
                <c:pt idx="2">
                  <c:v>69.436680283809935</c:v>
                </c:pt>
                <c:pt idx="3">
                  <c:v>35.044434888554434</c:v>
                </c:pt>
                <c:pt idx="4">
                  <c:v>2.88692395900523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762F-4658-A92E-95D1E9EF025A}"/>
            </c:ext>
          </c:extLst>
        </c:ser>
        <c:ser>
          <c:idx val="2"/>
          <c:order val="2"/>
          <c:tx>
            <c:v>19</c:v>
          </c:tx>
          <c:spPr>
            <a:ln w="15875">
              <a:solidFill>
                <a:srgbClr val="C0504D"/>
              </a:solidFill>
            </a:ln>
          </c:spPr>
          <c:marker>
            <c:symbol val="circle"/>
            <c:size val="4"/>
            <c:spPr>
              <a:solidFill>
                <a:srgbClr val="C0504D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Y$75:$Y$79</c:f>
                <c:numCache>
                  <c:formatCode>General</c:formatCode>
                  <c:ptCount val="5"/>
                  <c:pt idx="0">
                    <c:v>35.868193868547912</c:v>
                  </c:pt>
                  <c:pt idx="1">
                    <c:v>26.135656745255037</c:v>
                  </c:pt>
                  <c:pt idx="2">
                    <c:v>12.522776892761611</c:v>
                  </c:pt>
                  <c:pt idx="3">
                    <c:v>7.7234225810160613</c:v>
                  </c:pt>
                  <c:pt idx="4">
                    <c:v>2.1413500534700884</c:v>
                  </c:pt>
                </c:numCache>
              </c:numRef>
            </c:plus>
            <c:minus>
              <c:numRef>
                <c:f>APAP!$Y$75:$Y$79</c:f>
                <c:numCache>
                  <c:formatCode>General</c:formatCode>
                  <c:ptCount val="5"/>
                  <c:pt idx="0">
                    <c:v>35.868193868547912</c:v>
                  </c:pt>
                  <c:pt idx="1">
                    <c:v>26.135656745255037</c:v>
                  </c:pt>
                  <c:pt idx="2">
                    <c:v>12.522776892761611</c:v>
                  </c:pt>
                  <c:pt idx="3">
                    <c:v>7.7234225810160613</c:v>
                  </c:pt>
                  <c:pt idx="4">
                    <c:v>2.1413500534700884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Y$42:$Y$46</c:f>
              <c:numCache>
                <c:formatCode>General</c:formatCode>
                <c:ptCount val="5"/>
                <c:pt idx="0">
                  <c:v>117.90336807618225</c:v>
                </c:pt>
                <c:pt idx="1">
                  <c:v>75.812316609962011</c:v>
                </c:pt>
                <c:pt idx="2">
                  <c:v>55.194775971629674</c:v>
                </c:pt>
                <c:pt idx="3">
                  <c:v>27.564760310345449</c:v>
                </c:pt>
                <c:pt idx="4">
                  <c:v>2.502205180824827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762F-4658-A92E-95D1E9EF025A}"/>
            </c:ext>
          </c:extLst>
        </c:ser>
        <c:ser>
          <c:idx val="3"/>
          <c:order val="3"/>
          <c:tx>
            <c:v>20</c:v>
          </c:tx>
          <c:spPr>
            <a:ln w="15875">
              <a:solidFill>
                <a:srgbClr val="F79646"/>
              </a:solidFill>
            </a:ln>
          </c:spPr>
          <c:marker>
            <c:symbol val="circle"/>
            <c:size val="4"/>
            <c:spPr>
              <a:solidFill>
                <a:srgbClr val="F79646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Z$75:$Z$79</c:f>
                <c:numCache>
                  <c:formatCode>General</c:formatCode>
                  <c:ptCount val="5"/>
                  <c:pt idx="0">
                    <c:v>53.223187282969874</c:v>
                  </c:pt>
                  <c:pt idx="1">
                    <c:v>40.520081138715902</c:v>
                  </c:pt>
                  <c:pt idx="2">
                    <c:v>22.437040802626704</c:v>
                  </c:pt>
                  <c:pt idx="3">
                    <c:v>11.0867958272261</c:v>
                  </c:pt>
                  <c:pt idx="4">
                    <c:v>1.8476941286703497</c:v>
                  </c:pt>
                </c:numCache>
              </c:numRef>
            </c:plus>
            <c:minus>
              <c:numRef>
                <c:f>APAP!$Z$75:$Z$79</c:f>
                <c:numCache>
                  <c:formatCode>General</c:formatCode>
                  <c:ptCount val="5"/>
                  <c:pt idx="0">
                    <c:v>53.223187282969874</c:v>
                  </c:pt>
                  <c:pt idx="1">
                    <c:v>40.520081138715902</c:v>
                  </c:pt>
                  <c:pt idx="2">
                    <c:v>22.437040802626704</c:v>
                  </c:pt>
                  <c:pt idx="3">
                    <c:v>11.0867958272261</c:v>
                  </c:pt>
                  <c:pt idx="4">
                    <c:v>1.8476941286703497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Z$42:$Z$46</c:f>
              <c:numCache>
                <c:formatCode>General</c:formatCode>
                <c:ptCount val="5"/>
                <c:pt idx="0">
                  <c:v>149.80696052005709</c:v>
                </c:pt>
                <c:pt idx="1">
                  <c:v>104.10456635484383</c:v>
                </c:pt>
                <c:pt idx="2">
                  <c:v>73.358173458062481</c:v>
                </c:pt>
                <c:pt idx="3">
                  <c:v>31.854685270334553</c:v>
                </c:pt>
                <c:pt idx="4">
                  <c:v>2.014824797843665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762F-4658-A92E-95D1E9EF02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189248"/>
        <c:axId val="31191040"/>
      </c:scatterChart>
      <c:valAx>
        <c:axId val="31189248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31191040"/>
        <c:crosses val="autoZero"/>
        <c:crossBetween val="midCat"/>
      </c:valAx>
      <c:valAx>
        <c:axId val="31191040"/>
        <c:scaling>
          <c:orientation val="minMax"/>
          <c:max val="200"/>
          <c:min val="0"/>
        </c:scaling>
        <c:delete val="0"/>
        <c:axPos val="l"/>
        <c:majorGridlines>
          <c:spPr>
            <a:ln w="9525">
              <a:solidFill>
                <a:sysClr val="windowText" lastClr="000000"/>
              </a:solidFill>
              <a:prstDash val="sysDot"/>
            </a:ln>
          </c:spPr>
        </c:majorGridlines>
        <c:minorGridlines>
          <c:spPr>
            <a:ln w="6350">
              <a:solidFill>
                <a:sysClr val="windowText" lastClr="000000"/>
              </a:solidFill>
              <a:prstDash val="sysDot"/>
            </a:ln>
          </c:spPr>
        </c:minorGridlines>
        <c:numFmt formatCode="General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31189248"/>
        <c:crossesAt val="0.1"/>
        <c:crossBetween val="midCat"/>
        <c:majorUnit val="100"/>
        <c:minorUnit val="50"/>
      </c:valAx>
      <c:spPr>
        <a:noFill/>
      </c:spPr>
    </c:plotArea>
    <c:legend>
      <c:legendPos val="r"/>
      <c:layout>
        <c:manualLayout>
          <c:xMode val="edge"/>
          <c:yMode val="edge"/>
          <c:x val="0.6453096176718528"/>
          <c:y val="8.5526388888888902E-2"/>
          <c:w val="0.26358475604627973"/>
          <c:h val="0.22849027777777778"/>
        </c:manualLayout>
      </c:layout>
      <c:overlay val="0"/>
      <c:spPr>
        <a:noFill/>
      </c:spPr>
      <c:txPr>
        <a:bodyPr/>
        <a:lstStyle/>
        <a:p>
          <a:pPr>
            <a:defRPr sz="600">
              <a:latin typeface="+mn-lt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0469847321583839"/>
          <c:y val="8.6648611111111107E-2"/>
          <c:w val="0.72844125955808425"/>
          <c:h val="0.74162361283594025"/>
        </c:manualLayout>
      </c:layout>
      <c:scatterChart>
        <c:scatterStyle val="lineMarker"/>
        <c:varyColors val="0"/>
        <c:ser>
          <c:idx val="0"/>
          <c:order val="0"/>
          <c:tx>
            <c:v>1</c:v>
          </c:tx>
          <c:spPr>
            <a:ln w="15875">
              <a:solidFill>
                <a:srgbClr val="1F497D"/>
              </a:solidFill>
            </a:ln>
          </c:spPr>
          <c:marker>
            <c:symbol val="circle"/>
            <c:size val="4"/>
            <c:spPr>
              <a:solidFill>
                <a:srgbClr val="1F497D"/>
              </a:solidFill>
              <a:ln w="952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G$75:$G$79</c:f>
                <c:numCache>
                  <c:formatCode>General</c:formatCode>
                  <c:ptCount val="5"/>
                  <c:pt idx="0">
                    <c:v>22.777575928020703</c:v>
                  </c:pt>
                  <c:pt idx="1">
                    <c:v>16.066749982676821</c:v>
                  </c:pt>
                  <c:pt idx="2">
                    <c:v>17.435573768900152</c:v>
                  </c:pt>
                  <c:pt idx="3">
                    <c:v>15.008469040851297</c:v>
                  </c:pt>
                  <c:pt idx="4">
                    <c:v>10.358566325467992</c:v>
                  </c:pt>
                </c:numCache>
              </c:numRef>
            </c:plus>
            <c:minus>
              <c:numRef>
                <c:f>APAP!$G$75:$G$79</c:f>
                <c:numCache>
                  <c:formatCode>General</c:formatCode>
                  <c:ptCount val="5"/>
                  <c:pt idx="0">
                    <c:v>22.777575928020703</c:v>
                  </c:pt>
                  <c:pt idx="1">
                    <c:v>16.066749982676821</c:v>
                  </c:pt>
                  <c:pt idx="2">
                    <c:v>17.435573768900152</c:v>
                  </c:pt>
                  <c:pt idx="3">
                    <c:v>15.008469040851297</c:v>
                  </c:pt>
                  <c:pt idx="4">
                    <c:v>10.358566325467992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G$42:$G$46</c:f>
              <c:numCache>
                <c:formatCode>0</c:formatCode>
                <c:ptCount val="5"/>
                <c:pt idx="0">
                  <c:v>106.43515217604049</c:v>
                </c:pt>
                <c:pt idx="1">
                  <c:v>105.27841854352779</c:v>
                </c:pt>
                <c:pt idx="2">
                  <c:v>110.39885920395925</c:v>
                </c:pt>
                <c:pt idx="3">
                  <c:v>109.7739378433922</c:v>
                </c:pt>
                <c:pt idx="4">
                  <c:v>104.5718519761215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1E12-4C1A-85C2-05FA60F5F3EE}"/>
            </c:ext>
          </c:extLst>
        </c:ser>
        <c:ser>
          <c:idx val="1"/>
          <c:order val="1"/>
          <c:tx>
            <c:v>2</c:v>
          </c:tx>
          <c:spPr>
            <a:ln w="1587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H$75:$H$79</c:f>
                <c:numCache>
                  <c:formatCode>General</c:formatCode>
                  <c:ptCount val="5"/>
                  <c:pt idx="0">
                    <c:v>15.659395092760446</c:v>
                  </c:pt>
                  <c:pt idx="1">
                    <c:v>10.116658656900574</c:v>
                  </c:pt>
                  <c:pt idx="2">
                    <c:v>8.6389468106757796</c:v>
                  </c:pt>
                  <c:pt idx="3">
                    <c:v>12.14741946751267</c:v>
                  </c:pt>
                  <c:pt idx="4">
                    <c:v>8.9034818005730667</c:v>
                  </c:pt>
                </c:numCache>
              </c:numRef>
            </c:plus>
            <c:minus>
              <c:numRef>
                <c:f>APAP!$H$75:$H$79</c:f>
                <c:numCache>
                  <c:formatCode>General</c:formatCode>
                  <c:ptCount val="5"/>
                  <c:pt idx="0">
                    <c:v>15.659395092760446</c:v>
                  </c:pt>
                  <c:pt idx="1">
                    <c:v>10.116658656900574</c:v>
                  </c:pt>
                  <c:pt idx="2">
                    <c:v>8.6389468106757796</c:v>
                  </c:pt>
                  <c:pt idx="3">
                    <c:v>12.14741946751267</c:v>
                  </c:pt>
                  <c:pt idx="4">
                    <c:v>8.9034818005730667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H$42:$H$46</c:f>
              <c:numCache>
                <c:formatCode>0</c:formatCode>
                <c:ptCount val="5"/>
                <c:pt idx="0">
                  <c:v>103.67141248158951</c:v>
                </c:pt>
                <c:pt idx="1">
                  <c:v>96.865451815057611</c:v>
                </c:pt>
                <c:pt idx="2">
                  <c:v>98.371502007104297</c:v>
                </c:pt>
                <c:pt idx="3">
                  <c:v>98.549686660698299</c:v>
                </c:pt>
                <c:pt idx="4">
                  <c:v>95.10728622173448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1E12-4C1A-85C2-05FA60F5F3EE}"/>
            </c:ext>
          </c:extLst>
        </c:ser>
        <c:ser>
          <c:idx val="2"/>
          <c:order val="2"/>
          <c:tx>
            <c:v>3</c:v>
          </c:tx>
          <c:spPr>
            <a:ln w="15875">
              <a:solidFill>
                <a:srgbClr val="C0504D"/>
              </a:solidFill>
            </a:ln>
          </c:spPr>
          <c:marker>
            <c:symbol val="circle"/>
            <c:size val="4"/>
            <c:spPr>
              <a:solidFill>
                <a:srgbClr val="C0504D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I$75:$I$79</c:f>
                <c:numCache>
                  <c:formatCode>General</c:formatCode>
                  <c:ptCount val="5"/>
                  <c:pt idx="0">
                    <c:v>20.565259017311572</c:v>
                  </c:pt>
                  <c:pt idx="1">
                    <c:v>15.639531386846425</c:v>
                  </c:pt>
                  <c:pt idx="2">
                    <c:v>11.810098079569809</c:v>
                  </c:pt>
                  <c:pt idx="3">
                    <c:v>12.850506918283733</c:v>
                  </c:pt>
                  <c:pt idx="4">
                    <c:v>11.641369249052049</c:v>
                  </c:pt>
                </c:numCache>
              </c:numRef>
            </c:plus>
            <c:minus>
              <c:numRef>
                <c:f>APAP!$I$75:$I$79</c:f>
                <c:numCache>
                  <c:formatCode>General</c:formatCode>
                  <c:ptCount val="5"/>
                  <c:pt idx="0">
                    <c:v>20.565259017311572</c:v>
                  </c:pt>
                  <c:pt idx="1">
                    <c:v>15.639531386846425</c:v>
                  </c:pt>
                  <c:pt idx="2">
                    <c:v>11.810098079569809</c:v>
                  </c:pt>
                  <c:pt idx="3">
                    <c:v>12.850506918283733</c:v>
                  </c:pt>
                  <c:pt idx="4">
                    <c:v>11.641369249052049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I$42:$I$46</c:f>
              <c:numCache>
                <c:formatCode>0</c:formatCode>
                <c:ptCount val="5"/>
                <c:pt idx="0">
                  <c:v>109.25701111179143</c:v>
                </c:pt>
                <c:pt idx="1">
                  <c:v>107.57303527355104</c:v>
                </c:pt>
                <c:pt idx="2">
                  <c:v>115.87151450148951</c:v>
                </c:pt>
                <c:pt idx="3">
                  <c:v>109.17065879009628</c:v>
                </c:pt>
                <c:pt idx="4">
                  <c:v>82.98922601717335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1E12-4C1A-85C2-05FA60F5F3EE}"/>
            </c:ext>
          </c:extLst>
        </c:ser>
        <c:ser>
          <c:idx val="3"/>
          <c:order val="3"/>
          <c:tx>
            <c:v>4</c:v>
          </c:tx>
          <c:spPr>
            <a:ln w="15875">
              <a:solidFill>
                <a:srgbClr val="F79646"/>
              </a:solidFill>
            </a:ln>
          </c:spPr>
          <c:marker>
            <c:symbol val="circle"/>
            <c:size val="4"/>
            <c:spPr>
              <a:solidFill>
                <a:srgbClr val="F79646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J$75:$J$79</c:f>
                <c:numCache>
                  <c:formatCode>General</c:formatCode>
                  <c:ptCount val="5"/>
                  <c:pt idx="0">
                    <c:v>16.607518367373686</c:v>
                  </c:pt>
                  <c:pt idx="1">
                    <c:v>11.710487183130901</c:v>
                  </c:pt>
                  <c:pt idx="2">
                    <c:v>7.6955113540477891</c:v>
                  </c:pt>
                  <c:pt idx="3">
                    <c:v>10.415217407722517</c:v>
                  </c:pt>
                  <c:pt idx="4">
                    <c:v>9.461707179873347</c:v>
                  </c:pt>
                </c:numCache>
              </c:numRef>
            </c:plus>
            <c:minus>
              <c:numRef>
                <c:f>APAP!$J$75:$J$79</c:f>
                <c:numCache>
                  <c:formatCode>General</c:formatCode>
                  <c:ptCount val="5"/>
                  <c:pt idx="0">
                    <c:v>16.607518367373686</c:v>
                  </c:pt>
                  <c:pt idx="1">
                    <c:v>11.710487183130901</c:v>
                  </c:pt>
                  <c:pt idx="2">
                    <c:v>7.6955113540477891</c:v>
                  </c:pt>
                  <c:pt idx="3">
                    <c:v>10.415217407722517</c:v>
                  </c:pt>
                  <c:pt idx="4">
                    <c:v>9.461707179873347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J$42:$J$46</c:f>
              <c:numCache>
                <c:formatCode>0</c:formatCode>
                <c:ptCount val="5"/>
                <c:pt idx="0">
                  <c:v>104.56180037313432</c:v>
                </c:pt>
                <c:pt idx="1">
                  <c:v>96.894589552238799</c:v>
                </c:pt>
                <c:pt idx="2">
                  <c:v>99.678638059701484</c:v>
                </c:pt>
                <c:pt idx="3">
                  <c:v>92.452891791044763</c:v>
                </c:pt>
                <c:pt idx="4">
                  <c:v>59.9001865671641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1E12-4C1A-85C2-05FA60F5F3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224960"/>
        <c:axId val="31226496"/>
      </c:scatterChart>
      <c:valAx>
        <c:axId val="31224960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31226496"/>
        <c:crosses val="autoZero"/>
        <c:crossBetween val="midCat"/>
      </c:valAx>
      <c:valAx>
        <c:axId val="31226496"/>
        <c:scaling>
          <c:orientation val="minMax"/>
          <c:max val="200"/>
          <c:min val="0"/>
        </c:scaling>
        <c:delete val="0"/>
        <c:axPos val="l"/>
        <c:majorGridlines>
          <c:spPr>
            <a:ln w="9525">
              <a:solidFill>
                <a:sysClr val="windowText" lastClr="000000"/>
              </a:solidFill>
              <a:prstDash val="sysDot"/>
            </a:ln>
          </c:spPr>
        </c:majorGridlines>
        <c:minorGridlines>
          <c:spPr>
            <a:ln w="6350">
              <a:solidFill>
                <a:sysClr val="windowText" lastClr="000000"/>
              </a:solidFill>
              <a:prstDash val="sysDot"/>
            </a:ln>
          </c:spPr>
        </c:minorGridlines>
        <c:numFmt formatCode="0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31224960"/>
        <c:crossesAt val="0.1"/>
        <c:crossBetween val="midCat"/>
        <c:majorUnit val="100"/>
        <c:minorUnit val="50"/>
      </c:valAx>
      <c:spPr>
        <a:noFill/>
      </c:spPr>
    </c:plotArea>
    <c:legend>
      <c:legendPos val="r"/>
      <c:layout>
        <c:manualLayout>
          <c:xMode val="edge"/>
          <c:yMode val="edge"/>
          <c:x val="0.66982758465068337"/>
          <c:y val="9.4345833333333337E-2"/>
          <c:w val="0.24069719942811149"/>
          <c:h val="0.23730972222222221"/>
        </c:manualLayout>
      </c:layout>
      <c:overlay val="0"/>
      <c:spPr>
        <a:noFill/>
      </c:spPr>
      <c:txPr>
        <a:bodyPr/>
        <a:lstStyle/>
        <a:p>
          <a:pPr>
            <a:defRPr sz="600">
              <a:latin typeface="+mn-lt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676918889819596"/>
          <c:y val="6.9009722222222236E-2"/>
          <c:w val="0.72844125955808425"/>
          <c:h val="0.75044305555555557"/>
        </c:manualLayout>
      </c:layout>
      <c:scatterChart>
        <c:scatterStyle val="lineMarker"/>
        <c:varyColors val="0"/>
        <c:ser>
          <c:idx val="0"/>
          <c:order val="0"/>
          <c:tx>
            <c:v>5</c:v>
          </c:tx>
          <c:spPr>
            <a:ln w="15875">
              <a:solidFill>
                <a:srgbClr val="1F497D"/>
              </a:solidFill>
            </a:ln>
          </c:spPr>
          <c:marker>
            <c:symbol val="circle"/>
            <c:size val="4"/>
            <c:spPr>
              <a:solidFill>
                <a:srgbClr val="1F497D"/>
              </a:solidFill>
              <a:ln w="952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K$75:$K$79</c:f>
                <c:numCache>
                  <c:formatCode>General</c:formatCode>
                  <c:ptCount val="5"/>
                  <c:pt idx="0">
                    <c:v>14.999105521591023</c:v>
                  </c:pt>
                  <c:pt idx="1">
                    <c:v>8.7002020967051514</c:v>
                  </c:pt>
                  <c:pt idx="2">
                    <c:v>5.398969461588198</c:v>
                  </c:pt>
                  <c:pt idx="3">
                    <c:v>9.9533521806779337</c:v>
                  </c:pt>
                  <c:pt idx="4">
                    <c:v>8.7156245849083192</c:v>
                  </c:pt>
                </c:numCache>
              </c:numRef>
            </c:plus>
            <c:minus>
              <c:numRef>
                <c:f>APAP!$K$75:$K$79</c:f>
                <c:numCache>
                  <c:formatCode>General</c:formatCode>
                  <c:ptCount val="5"/>
                  <c:pt idx="0">
                    <c:v>14.999105521591023</c:v>
                  </c:pt>
                  <c:pt idx="1">
                    <c:v>8.7002020967051514</c:v>
                  </c:pt>
                  <c:pt idx="2">
                    <c:v>5.398969461588198</c:v>
                  </c:pt>
                  <c:pt idx="3">
                    <c:v>9.9533521806779337</c:v>
                  </c:pt>
                  <c:pt idx="4">
                    <c:v>8.7156245849083192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K$42:$K$46</c:f>
              <c:numCache>
                <c:formatCode>0</c:formatCode>
                <c:ptCount val="5"/>
                <c:pt idx="0">
                  <c:v>98.876478003880109</c:v>
                </c:pt>
                <c:pt idx="1">
                  <c:v>89.934601709565158</c:v>
                </c:pt>
                <c:pt idx="2">
                  <c:v>86.867499893057811</c:v>
                </c:pt>
                <c:pt idx="3">
                  <c:v>81.005558477243952</c:v>
                </c:pt>
                <c:pt idx="4">
                  <c:v>38.27573972537246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F855-4A09-B275-B3DA0382CAD7}"/>
            </c:ext>
          </c:extLst>
        </c:ser>
        <c:ser>
          <c:idx val="1"/>
          <c:order val="1"/>
          <c:tx>
            <c:v>6</c:v>
          </c:tx>
          <c:spPr>
            <a:ln w="1587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L$75:$L$79</c:f>
                <c:numCache>
                  <c:formatCode>General</c:formatCode>
                  <c:ptCount val="5"/>
                  <c:pt idx="0">
                    <c:v>19.511377353295735</c:v>
                  </c:pt>
                  <c:pt idx="1">
                    <c:v>14.724517547170427</c:v>
                  </c:pt>
                  <c:pt idx="2">
                    <c:v>7.6558930224350963</c:v>
                  </c:pt>
                  <c:pt idx="3">
                    <c:v>10.108750211320892</c:v>
                  </c:pt>
                  <c:pt idx="4">
                    <c:v>8.6857294199811772</c:v>
                  </c:pt>
                </c:numCache>
              </c:numRef>
            </c:plus>
            <c:minus>
              <c:numRef>
                <c:f>APAP!$L$75:$L$79</c:f>
                <c:numCache>
                  <c:formatCode>General</c:formatCode>
                  <c:ptCount val="5"/>
                  <c:pt idx="0">
                    <c:v>19.511377353295735</c:v>
                  </c:pt>
                  <c:pt idx="1">
                    <c:v>14.724517547170427</c:v>
                  </c:pt>
                  <c:pt idx="2">
                    <c:v>7.6558930224350963</c:v>
                  </c:pt>
                  <c:pt idx="3">
                    <c:v>10.108750211320892</c:v>
                  </c:pt>
                  <c:pt idx="4">
                    <c:v>8.6857294199811772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L$42:$L$46</c:f>
              <c:numCache>
                <c:formatCode>0</c:formatCode>
                <c:ptCount val="5"/>
                <c:pt idx="0">
                  <c:v>106.16065693856859</c:v>
                </c:pt>
                <c:pt idx="1">
                  <c:v>109.02158123174213</c:v>
                </c:pt>
                <c:pt idx="2">
                  <c:v>129.02257208931164</c:v>
                </c:pt>
                <c:pt idx="3">
                  <c:v>124.05501382777126</c:v>
                </c:pt>
                <c:pt idx="4">
                  <c:v>29.39396673903465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F855-4A09-B275-B3DA0382CAD7}"/>
            </c:ext>
          </c:extLst>
        </c:ser>
        <c:ser>
          <c:idx val="2"/>
          <c:order val="2"/>
          <c:tx>
            <c:v>7</c:v>
          </c:tx>
          <c:spPr>
            <a:ln w="15875">
              <a:solidFill>
                <a:srgbClr val="C0504D"/>
              </a:solidFill>
            </a:ln>
          </c:spPr>
          <c:marker>
            <c:symbol val="circle"/>
            <c:size val="4"/>
            <c:spPr>
              <a:solidFill>
                <a:srgbClr val="C0504D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M$75:$M$79</c:f>
                <c:numCache>
                  <c:formatCode>General</c:formatCode>
                  <c:ptCount val="5"/>
                  <c:pt idx="0">
                    <c:v>17.285418631196048</c:v>
                  </c:pt>
                  <c:pt idx="1">
                    <c:v>12.72547886988562</c:v>
                  </c:pt>
                  <c:pt idx="2">
                    <c:v>6.169945347902166</c:v>
                  </c:pt>
                  <c:pt idx="3">
                    <c:v>10.332320487859825</c:v>
                  </c:pt>
                  <c:pt idx="4">
                    <c:v>8.4609277513490611</c:v>
                  </c:pt>
                </c:numCache>
              </c:numRef>
            </c:plus>
            <c:minus>
              <c:numRef>
                <c:f>APAP!$M$75:$M$79</c:f>
                <c:numCache>
                  <c:formatCode>General</c:formatCode>
                  <c:ptCount val="5"/>
                  <c:pt idx="0">
                    <c:v>17.285418631196048</c:v>
                  </c:pt>
                  <c:pt idx="1">
                    <c:v>12.72547886988562</c:v>
                  </c:pt>
                  <c:pt idx="2">
                    <c:v>6.169945347902166</c:v>
                  </c:pt>
                  <c:pt idx="3">
                    <c:v>10.332320487859825</c:v>
                  </c:pt>
                  <c:pt idx="4">
                    <c:v>8.4609277513490611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M$42:$M$46</c:f>
              <c:numCache>
                <c:formatCode>0</c:formatCode>
                <c:ptCount val="5"/>
                <c:pt idx="0">
                  <c:v>100.98551178159232</c:v>
                </c:pt>
                <c:pt idx="1">
                  <c:v>96.155526145942673</c:v>
                </c:pt>
                <c:pt idx="2">
                  <c:v>106.00238609026722</c:v>
                </c:pt>
                <c:pt idx="3">
                  <c:v>95.576823196795957</c:v>
                </c:pt>
                <c:pt idx="4">
                  <c:v>27.81555391846872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F855-4A09-B275-B3DA0382CAD7}"/>
            </c:ext>
          </c:extLst>
        </c:ser>
        <c:ser>
          <c:idx val="3"/>
          <c:order val="3"/>
          <c:tx>
            <c:v>8</c:v>
          </c:tx>
          <c:spPr>
            <a:ln w="15875">
              <a:solidFill>
                <a:srgbClr val="F79646"/>
              </a:solidFill>
            </a:ln>
          </c:spPr>
          <c:marker>
            <c:symbol val="circle"/>
            <c:size val="4"/>
            <c:spPr>
              <a:solidFill>
                <a:srgbClr val="F79646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N$75:$N$79</c:f>
                <c:numCache>
                  <c:formatCode>General</c:formatCode>
                  <c:ptCount val="5"/>
                  <c:pt idx="0">
                    <c:v>22.255053576451125</c:v>
                  </c:pt>
                  <c:pt idx="1">
                    <c:v>19.74163917524826</c:v>
                  </c:pt>
                  <c:pt idx="2">
                    <c:v>10.595783651500254</c:v>
                  </c:pt>
                  <c:pt idx="3">
                    <c:v>15.919492277790882</c:v>
                  </c:pt>
                  <c:pt idx="4">
                    <c:v>7.1807319206322058</c:v>
                  </c:pt>
                </c:numCache>
              </c:numRef>
            </c:plus>
            <c:minus>
              <c:numRef>
                <c:f>APAP!$N$75:$N$79</c:f>
                <c:numCache>
                  <c:formatCode>General</c:formatCode>
                  <c:ptCount val="5"/>
                  <c:pt idx="0">
                    <c:v>22.255053576451125</c:v>
                  </c:pt>
                  <c:pt idx="1">
                    <c:v>19.74163917524826</c:v>
                  </c:pt>
                  <c:pt idx="2">
                    <c:v>10.595783651500254</c:v>
                  </c:pt>
                  <c:pt idx="3">
                    <c:v>15.919492277790882</c:v>
                  </c:pt>
                  <c:pt idx="4">
                    <c:v>7.1807319206322058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N$42:$N$46</c:f>
              <c:numCache>
                <c:formatCode>0</c:formatCode>
                <c:ptCount val="5"/>
                <c:pt idx="0">
                  <c:v>108.5222869621513</c:v>
                </c:pt>
                <c:pt idx="1">
                  <c:v>106.12285126242863</c:v>
                </c:pt>
                <c:pt idx="2">
                  <c:v>127.38498999913035</c:v>
                </c:pt>
                <c:pt idx="3">
                  <c:v>108.81603231198849</c:v>
                </c:pt>
                <c:pt idx="4">
                  <c:v>21.30426800398102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F855-4A09-B275-B3DA0382CA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8837248"/>
        <c:axId val="118838784"/>
      </c:scatterChart>
      <c:valAx>
        <c:axId val="118837248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118838784"/>
        <c:crosses val="autoZero"/>
        <c:crossBetween val="midCat"/>
      </c:valAx>
      <c:valAx>
        <c:axId val="118838784"/>
        <c:scaling>
          <c:orientation val="minMax"/>
          <c:max val="200"/>
          <c:min val="0"/>
        </c:scaling>
        <c:delete val="0"/>
        <c:axPos val="l"/>
        <c:majorGridlines>
          <c:spPr>
            <a:ln w="9525">
              <a:solidFill>
                <a:sysClr val="windowText" lastClr="000000"/>
              </a:solidFill>
              <a:prstDash val="sysDot"/>
            </a:ln>
          </c:spPr>
        </c:majorGridlines>
        <c:minorGridlines>
          <c:spPr>
            <a:ln w="6350">
              <a:solidFill>
                <a:sysClr val="windowText" lastClr="000000"/>
              </a:solidFill>
              <a:prstDash val="sysDot"/>
            </a:ln>
          </c:spPr>
        </c:minorGridlines>
        <c:numFmt formatCode="0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18837248"/>
        <c:crossesAt val="0.1"/>
        <c:crossBetween val="midCat"/>
        <c:majorUnit val="100"/>
        <c:minorUnit val="50"/>
      </c:valAx>
      <c:spPr>
        <a:noFill/>
      </c:spPr>
    </c:plotArea>
    <c:legend>
      <c:legendPos val="r"/>
      <c:layout>
        <c:manualLayout>
          <c:xMode val="edge"/>
          <c:yMode val="edge"/>
          <c:x val="0.67035202381864711"/>
          <c:y val="7.6706944444444453E-2"/>
          <c:w val="0.2483263849675009"/>
          <c:h val="0.22849027777777778"/>
        </c:manualLayout>
      </c:layout>
      <c:overlay val="0"/>
      <c:spPr>
        <a:noFill/>
      </c:spPr>
      <c:txPr>
        <a:bodyPr/>
        <a:lstStyle/>
        <a:p>
          <a:pPr>
            <a:defRPr sz="600">
              <a:latin typeface="+mn-lt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676918889819596"/>
          <c:y val="6.9009722222222236E-2"/>
          <c:w val="0.70471195299567668"/>
          <c:h val="0.75044305555555557"/>
        </c:manualLayout>
      </c:layout>
      <c:scatterChart>
        <c:scatterStyle val="lineMarker"/>
        <c:varyColors val="0"/>
        <c:ser>
          <c:idx val="0"/>
          <c:order val="0"/>
          <c:tx>
            <c:v>9</c:v>
          </c:tx>
          <c:spPr>
            <a:ln w="15875">
              <a:solidFill>
                <a:srgbClr val="1F497D"/>
              </a:solidFill>
            </a:ln>
          </c:spPr>
          <c:marker>
            <c:symbol val="circle"/>
            <c:size val="4"/>
            <c:spPr>
              <a:solidFill>
                <a:srgbClr val="1F497D"/>
              </a:solidFill>
              <a:ln w="952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O$75:$O$79</c:f>
                <c:numCache>
                  <c:formatCode>General</c:formatCode>
                  <c:ptCount val="5"/>
                  <c:pt idx="0">
                    <c:v>21.268054849070886</c:v>
                  </c:pt>
                  <c:pt idx="1">
                    <c:v>17.555229888410064</c:v>
                  </c:pt>
                  <c:pt idx="2">
                    <c:v>10.914156751366844</c:v>
                  </c:pt>
                  <c:pt idx="3">
                    <c:v>14.448043873284215</c:v>
                  </c:pt>
                  <c:pt idx="4">
                    <c:v>7.5460739893414086</c:v>
                  </c:pt>
                </c:numCache>
              </c:numRef>
            </c:plus>
            <c:minus>
              <c:numRef>
                <c:f>APAP!$O$75:$O$79</c:f>
                <c:numCache>
                  <c:formatCode>General</c:formatCode>
                  <c:ptCount val="5"/>
                  <c:pt idx="0">
                    <c:v>21.268054849070886</c:v>
                  </c:pt>
                  <c:pt idx="1">
                    <c:v>17.555229888410064</c:v>
                  </c:pt>
                  <c:pt idx="2">
                    <c:v>10.914156751366844</c:v>
                  </c:pt>
                  <c:pt idx="3">
                    <c:v>14.448043873284215</c:v>
                  </c:pt>
                  <c:pt idx="4">
                    <c:v>7.5460739893414086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O$42:$O$46</c:f>
              <c:numCache>
                <c:formatCode>0</c:formatCode>
                <c:ptCount val="5"/>
                <c:pt idx="0">
                  <c:v>106.04423760072285</c:v>
                </c:pt>
                <c:pt idx="1">
                  <c:v>96.964018269361702</c:v>
                </c:pt>
                <c:pt idx="2">
                  <c:v>112.08847520144572</c:v>
                </c:pt>
                <c:pt idx="3">
                  <c:v>90.318723620205233</c:v>
                </c:pt>
                <c:pt idx="4">
                  <c:v>19.3476996200071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56AE-4F86-A9C6-C5F330B0A219}"/>
            </c:ext>
          </c:extLst>
        </c:ser>
        <c:ser>
          <c:idx val="1"/>
          <c:order val="1"/>
          <c:tx>
            <c:v>10</c:v>
          </c:tx>
          <c:spPr>
            <a:ln w="1587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P$75:$P$79</c:f>
                <c:numCache>
                  <c:formatCode>General</c:formatCode>
                  <c:ptCount val="5"/>
                  <c:pt idx="0">
                    <c:v>22.064726202190649</c:v>
                  </c:pt>
                  <c:pt idx="1">
                    <c:v>19.160744446092675</c:v>
                  </c:pt>
                  <c:pt idx="2">
                    <c:v>8.8187574245839304</c:v>
                  </c:pt>
                  <c:pt idx="3">
                    <c:v>14.12050722199918</c:v>
                  </c:pt>
                  <c:pt idx="4">
                    <c:v>6.975166154329715</c:v>
                  </c:pt>
                </c:numCache>
              </c:numRef>
            </c:plus>
            <c:minus>
              <c:numRef>
                <c:f>APAP!$P$75:$P$79</c:f>
                <c:numCache>
                  <c:formatCode>General</c:formatCode>
                  <c:ptCount val="5"/>
                  <c:pt idx="0">
                    <c:v>22.064726202190649</c:v>
                  </c:pt>
                  <c:pt idx="1">
                    <c:v>19.160744446092675</c:v>
                  </c:pt>
                  <c:pt idx="2">
                    <c:v>8.8187574245839304</c:v>
                  </c:pt>
                  <c:pt idx="3">
                    <c:v>14.12050722199918</c:v>
                  </c:pt>
                  <c:pt idx="4">
                    <c:v>6.975166154329715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P$42:$P$46</c:f>
              <c:numCache>
                <c:formatCode>0</c:formatCode>
                <c:ptCount val="5"/>
                <c:pt idx="0">
                  <c:v>114.89946250243297</c:v>
                </c:pt>
                <c:pt idx="1">
                  <c:v>105.17934052991171</c:v>
                </c:pt>
                <c:pt idx="2">
                  <c:v>117.20616051064765</c:v>
                </c:pt>
                <c:pt idx="3">
                  <c:v>96.18311848402729</c:v>
                </c:pt>
                <c:pt idx="4">
                  <c:v>13.22458614683615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56AE-4F86-A9C6-C5F330B0A219}"/>
            </c:ext>
          </c:extLst>
        </c:ser>
        <c:ser>
          <c:idx val="2"/>
          <c:order val="2"/>
          <c:tx>
            <c:v>11</c:v>
          </c:tx>
          <c:spPr>
            <a:ln w="15875">
              <a:solidFill>
                <a:srgbClr val="C0504D"/>
              </a:solidFill>
            </a:ln>
          </c:spPr>
          <c:marker>
            <c:symbol val="circle"/>
            <c:size val="4"/>
            <c:spPr>
              <a:solidFill>
                <a:srgbClr val="C0504D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Q$75:$Q$79</c:f>
                <c:numCache>
                  <c:formatCode>General</c:formatCode>
                  <c:ptCount val="5"/>
                  <c:pt idx="0">
                    <c:v>18.713263147284987</c:v>
                  </c:pt>
                  <c:pt idx="1">
                    <c:v>17.531239628639618</c:v>
                  </c:pt>
                  <c:pt idx="2">
                    <c:v>10.729252307151913</c:v>
                  </c:pt>
                  <c:pt idx="3">
                    <c:v>13.870902233619306</c:v>
                  </c:pt>
                  <c:pt idx="4">
                    <c:v>7.6009773487785814</c:v>
                  </c:pt>
                </c:numCache>
              </c:numRef>
            </c:plus>
            <c:minus>
              <c:numRef>
                <c:f>APAP!$Q$75:$Q$79</c:f>
                <c:numCache>
                  <c:formatCode>General</c:formatCode>
                  <c:ptCount val="5"/>
                  <c:pt idx="0">
                    <c:v>18.713263147284987</c:v>
                  </c:pt>
                  <c:pt idx="1">
                    <c:v>17.531239628639618</c:v>
                  </c:pt>
                  <c:pt idx="2">
                    <c:v>10.729252307151913</c:v>
                  </c:pt>
                  <c:pt idx="3">
                    <c:v>13.870902233619306</c:v>
                  </c:pt>
                  <c:pt idx="4">
                    <c:v>7.6009773487785814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Q$42:$Q$46</c:f>
              <c:numCache>
                <c:formatCode>0</c:formatCode>
                <c:ptCount val="5"/>
                <c:pt idx="0">
                  <c:v>109.03699977643639</c:v>
                </c:pt>
                <c:pt idx="1">
                  <c:v>95.990107310529851</c:v>
                </c:pt>
                <c:pt idx="2">
                  <c:v>101.34557344064386</c:v>
                </c:pt>
                <c:pt idx="3">
                  <c:v>80.212385423653018</c:v>
                </c:pt>
                <c:pt idx="4">
                  <c:v>12.53241672255756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56AE-4F86-A9C6-C5F330B0A219}"/>
            </c:ext>
          </c:extLst>
        </c:ser>
        <c:ser>
          <c:idx val="3"/>
          <c:order val="3"/>
          <c:tx>
            <c:v>12</c:v>
          </c:tx>
          <c:spPr>
            <a:ln w="15875">
              <a:solidFill>
                <a:srgbClr val="F79646"/>
              </a:solidFill>
            </a:ln>
          </c:spPr>
          <c:marker>
            <c:symbol val="circle"/>
            <c:size val="4"/>
            <c:spPr>
              <a:solidFill>
                <a:srgbClr val="F79646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R$75:$R$79</c:f>
                <c:numCache>
                  <c:formatCode>General</c:formatCode>
                  <c:ptCount val="5"/>
                  <c:pt idx="0">
                    <c:v>21.222465046452314</c:v>
                  </c:pt>
                  <c:pt idx="1">
                    <c:v>17.224962913448749</c:v>
                  </c:pt>
                  <c:pt idx="2">
                    <c:v>11.81359446096757</c:v>
                  </c:pt>
                  <c:pt idx="3">
                    <c:v>14.968858175193168</c:v>
                  </c:pt>
                  <c:pt idx="4">
                    <c:v>8.041861361955208</c:v>
                  </c:pt>
                </c:numCache>
              </c:numRef>
            </c:plus>
            <c:minus>
              <c:numRef>
                <c:f>APAP!$R$75:$R$79</c:f>
                <c:numCache>
                  <c:formatCode>General</c:formatCode>
                  <c:ptCount val="5"/>
                  <c:pt idx="0">
                    <c:v>21.222465046452314</c:v>
                  </c:pt>
                  <c:pt idx="1">
                    <c:v>17.224962913448749</c:v>
                  </c:pt>
                  <c:pt idx="2">
                    <c:v>11.81359446096757</c:v>
                  </c:pt>
                  <c:pt idx="3">
                    <c:v>14.968858175193168</c:v>
                  </c:pt>
                  <c:pt idx="4">
                    <c:v>8.041861361955208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R$42:$R$46</c:f>
              <c:numCache>
                <c:formatCode>0</c:formatCode>
                <c:ptCount val="5"/>
                <c:pt idx="0">
                  <c:v>109.61548362088025</c:v>
                </c:pt>
                <c:pt idx="1">
                  <c:v>93.150962880859581</c:v>
                </c:pt>
                <c:pt idx="2">
                  <c:v>93.82993092211855</c:v>
                </c:pt>
                <c:pt idx="3">
                  <c:v>75.064126441898566</c:v>
                </c:pt>
                <c:pt idx="4">
                  <c:v>11.77867216624723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56AE-4F86-A9C6-C5F330B0A2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9093888"/>
        <c:axId val="119095680"/>
      </c:scatterChart>
      <c:valAx>
        <c:axId val="119093888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119095680"/>
        <c:crosses val="autoZero"/>
        <c:crossBetween val="midCat"/>
      </c:valAx>
      <c:valAx>
        <c:axId val="119095680"/>
        <c:scaling>
          <c:orientation val="minMax"/>
          <c:max val="200"/>
          <c:min val="0"/>
        </c:scaling>
        <c:delete val="0"/>
        <c:axPos val="l"/>
        <c:majorGridlines>
          <c:spPr>
            <a:ln w="9525">
              <a:solidFill>
                <a:sysClr val="windowText" lastClr="000000"/>
              </a:solidFill>
              <a:prstDash val="sysDot"/>
            </a:ln>
          </c:spPr>
        </c:majorGridlines>
        <c:minorGridlines>
          <c:spPr>
            <a:ln w="6350">
              <a:solidFill>
                <a:sysClr val="windowText" lastClr="000000"/>
              </a:solidFill>
              <a:prstDash val="sysDot"/>
            </a:ln>
          </c:spPr>
        </c:minorGridlines>
        <c:numFmt formatCode="0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19093888"/>
        <c:crossesAt val="0.1"/>
        <c:crossBetween val="midCat"/>
        <c:majorUnit val="100"/>
        <c:minorUnit val="50"/>
      </c:valAx>
      <c:spPr>
        <a:noFill/>
      </c:spPr>
    </c:plotArea>
    <c:legend>
      <c:legendPos val="r"/>
      <c:layout>
        <c:manualLayout>
          <c:xMode val="edge"/>
          <c:yMode val="edge"/>
          <c:x val="0.62329550637864717"/>
          <c:y val="7.4536111111111109E-2"/>
          <c:w val="0.2791003694135259"/>
          <c:h val="0.23730972222222221"/>
        </c:manualLayout>
      </c:layout>
      <c:overlay val="0"/>
      <c:spPr>
        <a:noFill/>
      </c:spPr>
      <c:txPr>
        <a:bodyPr/>
        <a:lstStyle/>
        <a:p>
          <a:pPr>
            <a:defRPr sz="600">
              <a:latin typeface="+mn-lt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676918889819596"/>
          <c:y val="7.7828830394782861E-2"/>
          <c:w val="0.72844125955808425"/>
          <c:h val="0.74162361283594025"/>
        </c:manualLayout>
      </c:layout>
      <c:scatterChart>
        <c:scatterStyle val="lineMarker"/>
        <c:varyColors val="0"/>
        <c:ser>
          <c:idx val="0"/>
          <c:order val="0"/>
          <c:tx>
            <c:v>21</c:v>
          </c:tx>
          <c:spPr>
            <a:ln w="15875">
              <a:solidFill>
                <a:srgbClr val="1F497D"/>
              </a:solidFill>
            </a:ln>
          </c:spPr>
          <c:marker>
            <c:symbol val="circle"/>
            <c:size val="4"/>
            <c:spPr>
              <a:solidFill>
                <a:srgbClr val="1F497D"/>
              </a:solidFill>
              <a:ln w="952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AA$75:$AA$79</c:f>
                <c:numCache>
                  <c:formatCode>General</c:formatCode>
                  <c:ptCount val="5"/>
                  <c:pt idx="0">
                    <c:v>44.588780765717736</c:v>
                  </c:pt>
                  <c:pt idx="1">
                    <c:v>39.300527660435783</c:v>
                  </c:pt>
                  <c:pt idx="2">
                    <c:v>16.10608308243803</c:v>
                  </c:pt>
                  <c:pt idx="3">
                    <c:v>7.9231204795290449</c:v>
                  </c:pt>
                  <c:pt idx="4">
                    <c:v>1.2848258358879638</c:v>
                  </c:pt>
                </c:numCache>
              </c:numRef>
            </c:plus>
            <c:minus>
              <c:numRef>
                <c:f>APAP!$AA$75:$AA$79</c:f>
                <c:numCache>
                  <c:formatCode>General</c:formatCode>
                  <c:ptCount val="5"/>
                  <c:pt idx="0">
                    <c:v>44.588780765717736</c:v>
                  </c:pt>
                  <c:pt idx="1">
                    <c:v>39.300527660435783</c:v>
                  </c:pt>
                  <c:pt idx="2">
                    <c:v>16.10608308243803</c:v>
                  </c:pt>
                  <c:pt idx="3">
                    <c:v>7.9231204795290449</c:v>
                  </c:pt>
                  <c:pt idx="4">
                    <c:v>1.2848258358879638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AA$42:$AA$46</c:f>
              <c:numCache>
                <c:formatCode>General</c:formatCode>
                <c:ptCount val="5"/>
                <c:pt idx="0">
                  <c:v>139.91497641330176</c:v>
                </c:pt>
                <c:pt idx="1">
                  <c:v>83.403172930273556</c:v>
                </c:pt>
                <c:pt idx="2">
                  <c:v>55.996493663766664</c:v>
                </c:pt>
                <c:pt idx="3">
                  <c:v>25.566359439999591</c:v>
                </c:pt>
                <c:pt idx="4">
                  <c:v>1.266233272698713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589E-45F7-9E8B-FC1A161EE985}"/>
            </c:ext>
          </c:extLst>
        </c:ser>
        <c:ser>
          <c:idx val="1"/>
          <c:order val="1"/>
          <c:tx>
            <c:v>22</c:v>
          </c:tx>
          <c:spPr>
            <a:ln w="1587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AB$75:$AB$79</c:f>
                <c:numCache>
                  <c:formatCode>General</c:formatCode>
                  <c:ptCount val="5"/>
                  <c:pt idx="0">
                    <c:v>41.946550345797768</c:v>
                  </c:pt>
                  <c:pt idx="1">
                    <c:v>32.670619261626371</c:v>
                  </c:pt>
                  <c:pt idx="2">
                    <c:v>9.9924056742795635</c:v>
                  </c:pt>
                  <c:pt idx="3">
                    <c:v>6.1465612175621454</c:v>
                  </c:pt>
                  <c:pt idx="4">
                    <c:v>0.82631572822466648</c:v>
                  </c:pt>
                </c:numCache>
              </c:numRef>
            </c:plus>
            <c:minus>
              <c:numRef>
                <c:f>APAP!$AB$75:$AB$79</c:f>
                <c:numCache>
                  <c:formatCode>General</c:formatCode>
                  <c:ptCount val="5"/>
                  <c:pt idx="0">
                    <c:v>41.946550345797768</c:v>
                  </c:pt>
                  <c:pt idx="1">
                    <c:v>32.670619261626371</c:v>
                  </c:pt>
                  <c:pt idx="2">
                    <c:v>9.9924056742795635</c:v>
                  </c:pt>
                  <c:pt idx="3">
                    <c:v>6.1465612175621454</c:v>
                  </c:pt>
                  <c:pt idx="4">
                    <c:v>0.82631572822466648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AB$42:$AB$46</c:f>
              <c:numCache>
                <c:formatCode>General</c:formatCode>
                <c:ptCount val="5"/>
                <c:pt idx="0">
                  <c:v>127.93964649134031</c:v>
                </c:pt>
                <c:pt idx="1">
                  <c:v>68.672144919634377</c:v>
                </c:pt>
                <c:pt idx="2">
                  <c:v>43.972159941248798</c:v>
                </c:pt>
                <c:pt idx="3">
                  <c:v>20.085011210575214</c:v>
                </c:pt>
                <c:pt idx="4">
                  <c:v>1.029815122871242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589E-45F7-9E8B-FC1A161EE985}"/>
            </c:ext>
          </c:extLst>
        </c:ser>
        <c:ser>
          <c:idx val="2"/>
          <c:order val="2"/>
          <c:tx>
            <c:v>23</c:v>
          </c:tx>
          <c:spPr>
            <a:ln w="15875">
              <a:solidFill>
                <a:srgbClr val="C0504D"/>
              </a:solidFill>
            </a:ln>
          </c:spPr>
          <c:marker>
            <c:symbol val="circle"/>
            <c:size val="4"/>
            <c:spPr>
              <a:solidFill>
                <a:srgbClr val="C0504D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AC$75:$AC$79</c:f>
                <c:numCache>
                  <c:formatCode>General</c:formatCode>
                  <c:ptCount val="5"/>
                  <c:pt idx="0">
                    <c:v>41.895949692209747</c:v>
                  </c:pt>
                  <c:pt idx="1">
                    <c:v>38.357168454678551</c:v>
                  </c:pt>
                  <c:pt idx="2">
                    <c:v>14.256664926526225</c:v>
                  </c:pt>
                  <c:pt idx="3">
                    <c:v>7.679043117966919</c:v>
                  </c:pt>
                  <c:pt idx="4">
                    <c:v>0.41448125769143496</c:v>
                  </c:pt>
                </c:numCache>
              </c:numRef>
            </c:plus>
            <c:minus>
              <c:numRef>
                <c:f>APAP!$AC$75:$AC$79</c:f>
                <c:numCache>
                  <c:formatCode>General</c:formatCode>
                  <c:ptCount val="5"/>
                  <c:pt idx="0">
                    <c:v>41.895949692209747</c:v>
                  </c:pt>
                  <c:pt idx="1">
                    <c:v>38.357168454678551</c:v>
                  </c:pt>
                  <c:pt idx="2">
                    <c:v>14.256664926526225</c:v>
                  </c:pt>
                  <c:pt idx="3">
                    <c:v>7.679043117966919</c:v>
                  </c:pt>
                  <c:pt idx="4">
                    <c:v>0.41448125769143496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AC$42:$AC$46</c:f>
              <c:numCache>
                <c:formatCode>General</c:formatCode>
                <c:ptCount val="5"/>
                <c:pt idx="0">
                  <c:v>146.31452251091071</c:v>
                </c:pt>
                <c:pt idx="1">
                  <c:v>73.253692585449528</c:v>
                </c:pt>
                <c:pt idx="2">
                  <c:v>44.927996360724251</c:v>
                </c:pt>
                <c:pt idx="3">
                  <c:v>15.869706346460946</c:v>
                </c:pt>
                <c:pt idx="4">
                  <c:v>0.4767072136321203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589E-45F7-9E8B-FC1A161EE985}"/>
            </c:ext>
          </c:extLst>
        </c:ser>
        <c:ser>
          <c:idx val="3"/>
          <c:order val="3"/>
          <c:tx>
            <c:v>24</c:v>
          </c:tx>
          <c:spPr>
            <a:ln w="15875">
              <a:solidFill>
                <a:srgbClr val="F79646"/>
              </a:solidFill>
            </a:ln>
          </c:spPr>
          <c:marker>
            <c:symbol val="circle"/>
            <c:size val="4"/>
            <c:spPr>
              <a:solidFill>
                <a:srgbClr val="F79646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PAP!$AD$75:$AD$79</c:f>
                <c:numCache>
                  <c:formatCode>General</c:formatCode>
                  <c:ptCount val="5"/>
                  <c:pt idx="0">
                    <c:v>44.048434951710114</c:v>
                  </c:pt>
                  <c:pt idx="1">
                    <c:v>32.033896476095563</c:v>
                  </c:pt>
                  <c:pt idx="2">
                    <c:v>10.859144631238298</c:v>
                  </c:pt>
                  <c:pt idx="3">
                    <c:v>7.0397507936491071</c:v>
                  </c:pt>
                  <c:pt idx="4">
                    <c:v>0.36379544105475964</c:v>
                  </c:pt>
                </c:numCache>
              </c:numRef>
            </c:plus>
            <c:minus>
              <c:numRef>
                <c:f>APAP!$AD$75:$AD$79</c:f>
                <c:numCache>
                  <c:formatCode>General</c:formatCode>
                  <c:ptCount val="5"/>
                  <c:pt idx="0">
                    <c:v>44.048434951710114</c:v>
                  </c:pt>
                  <c:pt idx="1">
                    <c:v>32.033896476095563</c:v>
                  </c:pt>
                  <c:pt idx="2">
                    <c:v>10.859144631238298</c:v>
                  </c:pt>
                  <c:pt idx="3">
                    <c:v>7.0397507936491071</c:v>
                  </c:pt>
                  <c:pt idx="4">
                    <c:v>0.36379544105475964</c:v>
                  </c:pt>
                </c:numCache>
              </c:numRef>
            </c:minus>
          </c:errBars>
          <c:xVal>
            <c:numRef>
              <c:f>APAP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APAP!$AD$42:$AD$46</c:f>
              <c:numCache>
                <c:formatCode>General</c:formatCode>
                <c:ptCount val="5"/>
                <c:pt idx="0">
                  <c:v>134.70444106054055</c:v>
                </c:pt>
                <c:pt idx="1">
                  <c:v>56.91789019858502</c:v>
                </c:pt>
                <c:pt idx="2">
                  <c:v>33.352759448298329</c:v>
                </c:pt>
                <c:pt idx="3">
                  <c:v>12.759197638787059</c:v>
                </c:pt>
                <c:pt idx="4">
                  <c:v>0.5295182950137550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589E-45F7-9E8B-FC1A161EE9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8196480"/>
        <c:axId val="138198016"/>
      </c:scatterChart>
      <c:valAx>
        <c:axId val="138196480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138198016"/>
        <c:crosses val="autoZero"/>
        <c:crossBetween val="midCat"/>
      </c:valAx>
      <c:valAx>
        <c:axId val="138198016"/>
        <c:scaling>
          <c:orientation val="minMax"/>
          <c:max val="200"/>
          <c:min val="0"/>
        </c:scaling>
        <c:delete val="0"/>
        <c:axPos val="l"/>
        <c:majorGridlines>
          <c:spPr>
            <a:ln w="9525">
              <a:solidFill>
                <a:sysClr val="windowText" lastClr="000000"/>
              </a:solidFill>
              <a:prstDash val="sysDot"/>
            </a:ln>
          </c:spPr>
        </c:majorGridlines>
        <c:minorGridlines>
          <c:spPr>
            <a:ln w="6350">
              <a:solidFill>
                <a:sysClr val="windowText" lastClr="000000"/>
              </a:solidFill>
              <a:prstDash val="sysDot"/>
            </a:ln>
          </c:spPr>
        </c:minorGridlines>
        <c:numFmt formatCode="General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38196480"/>
        <c:crossesAt val="0.1"/>
        <c:crossBetween val="midCat"/>
        <c:majorUnit val="100"/>
        <c:minorUnit val="50"/>
      </c:valAx>
      <c:spPr>
        <a:noFill/>
      </c:spPr>
    </c:plotArea>
    <c:legend>
      <c:legendPos val="r"/>
      <c:layout>
        <c:manualLayout>
          <c:xMode val="edge"/>
          <c:yMode val="edge"/>
          <c:x val="0.64523379938329339"/>
          <c:y val="9.2175000000000007E-2"/>
          <c:w val="0.26358475604627973"/>
          <c:h val="0.23730972222222221"/>
        </c:manualLayout>
      </c:layout>
      <c:overlay val="0"/>
      <c:spPr>
        <a:noFill/>
      </c:spPr>
      <c:txPr>
        <a:bodyPr/>
        <a:lstStyle/>
        <a:p>
          <a:pPr>
            <a:defRPr sz="600">
              <a:latin typeface="+mn-lt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0469847321583839"/>
          <c:y val="8.6648611111111107E-2"/>
          <c:w val="0.72844125955808425"/>
          <c:h val="0.74162361283594025"/>
        </c:manualLayout>
      </c:layout>
      <c:scatterChart>
        <c:scatterStyle val="lineMarker"/>
        <c:varyColors val="0"/>
        <c:ser>
          <c:idx val="0"/>
          <c:order val="0"/>
          <c:tx>
            <c:v>1</c:v>
          </c:tx>
          <c:spPr>
            <a:ln w="15875">
              <a:solidFill>
                <a:srgbClr val="1F497D"/>
              </a:solidFill>
            </a:ln>
          </c:spPr>
          <c:marker>
            <c:symbol val="circle"/>
            <c:size val="4"/>
            <c:spPr>
              <a:solidFill>
                <a:srgbClr val="1F497D"/>
              </a:solidFill>
              <a:ln w="952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FB1'!$G$75:$G$79</c:f>
                <c:numCache>
                  <c:formatCode>General</c:formatCode>
                  <c:ptCount val="5"/>
                  <c:pt idx="0">
                    <c:v>9.7978760185412277</c:v>
                  </c:pt>
                  <c:pt idx="1">
                    <c:v>8.9380886285590222</c:v>
                  </c:pt>
                  <c:pt idx="2">
                    <c:v>7.3005454049335219</c:v>
                  </c:pt>
                  <c:pt idx="3">
                    <c:v>8.0058400125769644</c:v>
                  </c:pt>
                  <c:pt idx="4">
                    <c:v>5.7007629952920365</c:v>
                  </c:pt>
                </c:numCache>
              </c:numRef>
            </c:plus>
            <c:minus>
              <c:numRef>
                <c:f>'AFB1'!$G$75:$G$79</c:f>
                <c:numCache>
                  <c:formatCode>General</c:formatCode>
                  <c:ptCount val="5"/>
                  <c:pt idx="0">
                    <c:v>9.7978760185412277</c:v>
                  </c:pt>
                  <c:pt idx="1">
                    <c:v>8.9380886285590222</c:v>
                  </c:pt>
                  <c:pt idx="2">
                    <c:v>7.3005454049335219</c:v>
                  </c:pt>
                  <c:pt idx="3">
                    <c:v>8.0058400125769644</c:v>
                  </c:pt>
                  <c:pt idx="4">
                    <c:v>5.7007629952920365</c:v>
                  </c:pt>
                </c:numCache>
              </c:numRef>
            </c:minus>
          </c:errBars>
          <c:xVal>
            <c:numRef>
              <c:f>'AFB1'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'AFB1'!$G$42:$G$46</c:f>
              <c:numCache>
                <c:formatCode>0</c:formatCode>
                <c:ptCount val="5"/>
                <c:pt idx="0">
                  <c:v>78.03933374755259</c:v>
                </c:pt>
                <c:pt idx="1">
                  <c:v>73.027067306357836</c:v>
                </c:pt>
                <c:pt idx="2">
                  <c:v>77.285412009369054</c:v>
                </c:pt>
                <c:pt idx="3">
                  <c:v>76.306018349485754</c:v>
                </c:pt>
                <c:pt idx="4">
                  <c:v>60.94851937969599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6FC5-4571-8A95-6B8EF092B70F}"/>
            </c:ext>
          </c:extLst>
        </c:ser>
        <c:ser>
          <c:idx val="1"/>
          <c:order val="1"/>
          <c:tx>
            <c:v>2</c:v>
          </c:tx>
          <c:spPr>
            <a:ln w="1587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FB1'!$H$75:$H$79</c:f>
                <c:numCache>
                  <c:formatCode>General</c:formatCode>
                  <c:ptCount val="5"/>
                  <c:pt idx="0">
                    <c:v>2.076799024439993</c:v>
                  </c:pt>
                  <c:pt idx="1">
                    <c:v>1.0769687585448213</c:v>
                  </c:pt>
                  <c:pt idx="2">
                    <c:v>1.2421797395092462</c:v>
                  </c:pt>
                  <c:pt idx="3">
                    <c:v>2.0535423655897467</c:v>
                  </c:pt>
                  <c:pt idx="4">
                    <c:v>2.6174054940391609</c:v>
                  </c:pt>
                </c:numCache>
              </c:numRef>
            </c:plus>
            <c:minus>
              <c:numRef>
                <c:f>'AFB1'!$H$75:$H$79</c:f>
                <c:numCache>
                  <c:formatCode>General</c:formatCode>
                  <c:ptCount val="5"/>
                  <c:pt idx="0">
                    <c:v>2.076799024439993</c:v>
                  </c:pt>
                  <c:pt idx="1">
                    <c:v>1.0769687585448213</c:v>
                  </c:pt>
                  <c:pt idx="2">
                    <c:v>1.2421797395092462</c:v>
                  </c:pt>
                  <c:pt idx="3">
                    <c:v>2.0535423655897467</c:v>
                  </c:pt>
                  <c:pt idx="4">
                    <c:v>2.6174054940391609</c:v>
                  </c:pt>
                </c:numCache>
              </c:numRef>
            </c:minus>
          </c:errBars>
          <c:xVal>
            <c:numRef>
              <c:f>'AFB1'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'AFB1'!$H$42:$H$46</c:f>
              <c:numCache>
                <c:formatCode>0</c:formatCode>
                <c:ptCount val="5"/>
                <c:pt idx="0">
                  <c:v>63.219951805886367</c:v>
                </c:pt>
                <c:pt idx="1">
                  <c:v>55.740578236504021</c:v>
                </c:pt>
                <c:pt idx="2">
                  <c:v>54.255521661814754</c:v>
                </c:pt>
                <c:pt idx="3">
                  <c:v>50.936952999131755</c:v>
                </c:pt>
                <c:pt idx="4">
                  <c:v>28.12089386616151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6FC5-4571-8A95-6B8EF092B70F}"/>
            </c:ext>
          </c:extLst>
        </c:ser>
        <c:ser>
          <c:idx val="2"/>
          <c:order val="2"/>
          <c:tx>
            <c:v>3</c:v>
          </c:tx>
          <c:spPr>
            <a:ln w="15875">
              <a:solidFill>
                <a:srgbClr val="C0504D"/>
              </a:solidFill>
            </a:ln>
          </c:spPr>
          <c:marker>
            <c:symbol val="circle"/>
            <c:size val="4"/>
            <c:spPr>
              <a:solidFill>
                <a:srgbClr val="C0504D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FB1'!$I$75:$I$79</c:f>
                <c:numCache>
                  <c:formatCode>General</c:formatCode>
                  <c:ptCount val="5"/>
                  <c:pt idx="0">
                    <c:v>3.7336515866316717</c:v>
                  </c:pt>
                  <c:pt idx="1">
                    <c:v>1.4104964982113404</c:v>
                  </c:pt>
                  <c:pt idx="2">
                    <c:v>1.0622090670086455</c:v>
                  </c:pt>
                  <c:pt idx="3">
                    <c:v>1.084730553707304</c:v>
                  </c:pt>
                  <c:pt idx="4">
                    <c:v>1.0443836917813636</c:v>
                  </c:pt>
                </c:numCache>
              </c:numRef>
            </c:plus>
            <c:minus>
              <c:numRef>
                <c:f>'AFB1'!$I$75:$I$79</c:f>
                <c:numCache>
                  <c:formatCode>General</c:formatCode>
                  <c:ptCount val="5"/>
                  <c:pt idx="0">
                    <c:v>3.7336515866316717</c:v>
                  </c:pt>
                  <c:pt idx="1">
                    <c:v>1.4104964982113404</c:v>
                  </c:pt>
                  <c:pt idx="2">
                    <c:v>1.0622090670086455</c:v>
                  </c:pt>
                  <c:pt idx="3">
                    <c:v>1.084730553707304</c:v>
                  </c:pt>
                  <c:pt idx="4">
                    <c:v>1.0443836917813636</c:v>
                  </c:pt>
                </c:numCache>
              </c:numRef>
            </c:minus>
          </c:errBars>
          <c:xVal>
            <c:numRef>
              <c:f>'AFB1'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'AFB1'!$I$42:$I$46</c:f>
              <c:numCache>
                <c:formatCode>0</c:formatCode>
                <c:ptCount val="5"/>
                <c:pt idx="0">
                  <c:v>41.462553196207089</c:v>
                </c:pt>
                <c:pt idx="1">
                  <c:v>29.607579479528468</c:v>
                </c:pt>
                <c:pt idx="2">
                  <c:v>25.506145973401502</c:v>
                </c:pt>
                <c:pt idx="3">
                  <c:v>21.595086388898128</c:v>
                </c:pt>
                <c:pt idx="4">
                  <c:v>7.389263987811000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6FC5-4571-8A95-6B8EF092B70F}"/>
            </c:ext>
          </c:extLst>
        </c:ser>
        <c:ser>
          <c:idx val="3"/>
          <c:order val="3"/>
          <c:tx>
            <c:v>4</c:v>
          </c:tx>
          <c:spPr>
            <a:ln w="15875">
              <a:solidFill>
                <a:srgbClr val="F79646"/>
              </a:solidFill>
            </a:ln>
          </c:spPr>
          <c:marker>
            <c:symbol val="circle"/>
            <c:size val="4"/>
            <c:spPr>
              <a:solidFill>
                <a:srgbClr val="F79646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FB1'!$J$75:$J$79</c:f>
                <c:numCache>
                  <c:formatCode>General</c:formatCode>
                  <c:ptCount val="5"/>
                  <c:pt idx="0">
                    <c:v>3.1820949803894929</c:v>
                  </c:pt>
                  <c:pt idx="1">
                    <c:v>2.0771575604518326</c:v>
                  </c:pt>
                  <c:pt idx="2">
                    <c:v>0.56855530692456135</c:v>
                  </c:pt>
                  <c:pt idx="3">
                    <c:v>0.3745146869541634</c:v>
                  </c:pt>
                  <c:pt idx="4">
                    <c:v>0.55712441239320487</c:v>
                  </c:pt>
                </c:numCache>
              </c:numRef>
            </c:plus>
            <c:minus>
              <c:numRef>
                <c:f>'AFB1'!$J$75:$J$79</c:f>
                <c:numCache>
                  <c:formatCode>General</c:formatCode>
                  <c:ptCount val="5"/>
                  <c:pt idx="0">
                    <c:v>3.1820949803894929</c:v>
                  </c:pt>
                  <c:pt idx="1">
                    <c:v>2.0771575604518326</c:v>
                  </c:pt>
                  <c:pt idx="2">
                    <c:v>0.56855530692456135</c:v>
                  </c:pt>
                  <c:pt idx="3">
                    <c:v>0.3745146869541634</c:v>
                  </c:pt>
                  <c:pt idx="4">
                    <c:v>0.55712441239320487</c:v>
                  </c:pt>
                </c:numCache>
              </c:numRef>
            </c:minus>
          </c:errBars>
          <c:xVal>
            <c:numRef>
              <c:f>'AFB1'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'AFB1'!$J$42:$J$46</c:f>
              <c:numCache>
                <c:formatCode>0</c:formatCode>
                <c:ptCount val="5"/>
                <c:pt idx="0">
                  <c:v>36.438999240204062</c:v>
                </c:pt>
                <c:pt idx="1">
                  <c:v>25.007801476174972</c:v>
                </c:pt>
                <c:pt idx="2">
                  <c:v>20.573001465320743</c:v>
                </c:pt>
                <c:pt idx="3">
                  <c:v>15.980815152501899</c:v>
                </c:pt>
                <c:pt idx="4">
                  <c:v>4.602701345924238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6FC5-4571-8A95-6B8EF092B7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1100928"/>
        <c:axId val="141102464"/>
      </c:scatterChart>
      <c:valAx>
        <c:axId val="141100928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141102464"/>
        <c:crosses val="autoZero"/>
        <c:crossBetween val="midCat"/>
      </c:valAx>
      <c:valAx>
        <c:axId val="141102464"/>
        <c:scaling>
          <c:orientation val="minMax"/>
          <c:max val="100"/>
          <c:min val="0"/>
        </c:scaling>
        <c:delete val="0"/>
        <c:axPos val="l"/>
        <c:majorGridlines>
          <c:spPr>
            <a:ln w="9525">
              <a:solidFill>
                <a:sysClr val="windowText" lastClr="000000"/>
              </a:solidFill>
              <a:prstDash val="sysDot"/>
            </a:ln>
          </c:spPr>
        </c:majorGridlines>
        <c:minorGridlines>
          <c:spPr>
            <a:ln w="6350">
              <a:solidFill>
                <a:sysClr val="windowText" lastClr="000000"/>
              </a:solidFill>
              <a:prstDash val="sysDot"/>
            </a:ln>
          </c:spPr>
        </c:minorGridlines>
        <c:numFmt formatCode="0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41100928"/>
        <c:crossesAt val="0.1"/>
        <c:crossBetween val="midCat"/>
        <c:majorUnit val="50"/>
        <c:minorUnit val="50"/>
      </c:valAx>
      <c:spPr>
        <a:noFill/>
      </c:spPr>
    </c:plotArea>
    <c:legend>
      <c:legendPos val="r"/>
      <c:layout>
        <c:manualLayout>
          <c:xMode val="edge"/>
          <c:yMode val="edge"/>
          <c:x val="0.74648693906103325"/>
          <c:y val="6.1513888888888859E-3"/>
          <c:w val="0.24069719942811149"/>
          <c:h val="0.23730972222222221"/>
        </c:manualLayout>
      </c:layout>
      <c:overlay val="0"/>
      <c:spPr>
        <a:solidFill>
          <a:sysClr val="window" lastClr="FFFFFF"/>
        </a:solidFill>
      </c:spPr>
      <c:txPr>
        <a:bodyPr/>
        <a:lstStyle/>
        <a:p>
          <a:pPr>
            <a:defRPr sz="600">
              <a:latin typeface="+mn-lt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676918889819596"/>
          <c:y val="7.7828830394782861E-2"/>
          <c:w val="0.72844125955808425"/>
          <c:h val="0.74162361283594025"/>
        </c:manualLayout>
      </c:layout>
      <c:scatterChart>
        <c:scatterStyle val="lineMarker"/>
        <c:varyColors val="0"/>
        <c:ser>
          <c:idx val="0"/>
          <c:order val="0"/>
          <c:tx>
            <c:v>5</c:v>
          </c:tx>
          <c:spPr>
            <a:ln w="15875">
              <a:solidFill>
                <a:srgbClr val="1F497D"/>
              </a:solidFill>
            </a:ln>
          </c:spPr>
          <c:marker>
            <c:symbol val="circle"/>
            <c:size val="4"/>
            <c:spPr>
              <a:solidFill>
                <a:srgbClr val="1F497D"/>
              </a:solidFill>
              <a:ln w="952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FB1'!$K$75:$K$79</c:f>
                <c:numCache>
                  <c:formatCode>General</c:formatCode>
                  <c:ptCount val="5"/>
                  <c:pt idx="0">
                    <c:v>3.0051427896315097</c:v>
                  </c:pt>
                  <c:pt idx="1">
                    <c:v>1.9342044726150176</c:v>
                  </c:pt>
                  <c:pt idx="2">
                    <c:v>0.72973868530297292</c:v>
                  </c:pt>
                  <c:pt idx="3">
                    <c:v>0.4016633555866948</c:v>
                  </c:pt>
                  <c:pt idx="4">
                    <c:v>0.27935324499448738</c:v>
                  </c:pt>
                </c:numCache>
              </c:numRef>
            </c:plus>
            <c:minus>
              <c:numRef>
                <c:f>'AFB1'!$K$75:$K$79</c:f>
                <c:numCache>
                  <c:formatCode>General</c:formatCode>
                  <c:ptCount val="5"/>
                  <c:pt idx="0">
                    <c:v>3.0051427896315097</c:v>
                  </c:pt>
                  <c:pt idx="1">
                    <c:v>1.9342044726150176</c:v>
                  </c:pt>
                  <c:pt idx="2">
                    <c:v>0.72973868530297292</c:v>
                  </c:pt>
                  <c:pt idx="3">
                    <c:v>0.4016633555866948</c:v>
                  </c:pt>
                  <c:pt idx="4">
                    <c:v>0.27935324499448738</c:v>
                  </c:pt>
                </c:numCache>
              </c:numRef>
            </c:minus>
          </c:errBars>
          <c:xVal>
            <c:numRef>
              <c:f>'AFB1'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'AFB1'!$K$42:$K$46</c:f>
              <c:numCache>
                <c:formatCode>0</c:formatCode>
                <c:ptCount val="5"/>
                <c:pt idx="0">
                  <c:v>34.867432859745549</c:v>
                </c:pt>
                <c:pt idx="1">
                  <c:v>22.135771139637644</c:v>
                </c:pt>
                <c:pt idx="2">
                  <c:v>18.20054408973483</c:v>
                </c:pt>
                <c:pt idx="3">
                  <c:v>12.429537714099691</c:v>
                </c:pt>
                <c:pt idx="4">
                  <c:v>2.990018675718329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507F-4731-9E3B-03E99647269B}"/>
            </c:ext>
          </c:extLst>
        </c:ser>
        <c:ser>
          <c:idx val="1"/>
          <c:order val="1"/>
          <c:tx>
            <c:v>6</c:v>
          </c:tx>
          <c:spPr>
            <a:ln w="1587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FB1'!$L$75:$L$79</c:f>
                <c:numCache>
                  <c:formatCode>General</c:formatCode>
                  <c:ptCount val="5"/>
                  <c:pt idx="0">
                    <c:v>2.8612705396874389</c:v>
                  </c:pt>
                  <c:pt idx="1">
                    <c:v>2.0696819321351931</c:v>
                  </c:pt>
                  <c:pt idx="2">
                    <c:v>1.372185004974404</c:v>
                  </c:pt>
                  <c:pt idx="3">
                    <c:v>0.57395149602185902</c:v>
                  </c:pt>
                  <c:pt idx="4">
                    <c:v>9.6014081034022855E-2</c:v>
                  </c:pt>
                </c:numCache>
              </c:numRef>
            </c:plus>
            <c:minus>
              <c:numRef>
                <c:f>'AFB1'!$L$75:$L$79</c:f>
                <c:numCache>
                  <c:formatCode>General</c:formatCode>
                  <c:ptCount val="5"/>
                  <c:pt idx="0">
                    <c:v>2.8612705396874389</c:v>
                  </c:pt>
                  <c:pt idx="1">
                    <c:v>2.0696819321351931</c:v>
                  </c:pt>
                  <c:pt idx="2">
                    <c:v>1.372185004974404</c:v>
                  </c:pt>
                  <c:pt idx="3">
                    <c:v>0.57395149602185902</c:v>
                  </c:pt>
                  <c:pt idx="4">
                    <c:v>9.6014081034022855E-2</c:v>
                  </c:pt>
                </c:numCache>
              </c:numRef>
            </c:minus>
          </c:errBars>
          <c:xVal>
            <c:numRef>
              <c:f>'AFB1'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'AFB1'!$L$42:$L$46</c:f>
              <c:numCache>
                <c:formatCode>0</c:formatCode>
                <c:ptCount val="5"/>
                <c:pt idx="0">
                  <c:v>29.350069687059982</c:v>
                </c:pt>
                <c:pt idx="1">
                  <c:v>15.434143937798749</c:v>
                </c:pt>
                <c:pt idx="2">
                  <c:v>12.939733942969772</c:v>
                </c:pt>
                <c:pt idx="3">
                  <c:v>7.359612445407028</c:v>
                </c:pt>
                <c:pt idx="4">
                  <c:v>1.006272551606383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507F-4731-9E3B-03E99647269B}"/>
            </c:ext>
          </c:extLst>
        </c:ser>
        <c:ser>
          <c:idx val="2"/>
          <c:order val="2"/>
          <c:tx>
            <c:v>7</c:v>
          </c:tx>
          <c:spPr>
            <a:ln w="15875">
              <a:solidFill>
                <a:srgbClr val="C0504D"/>
              </a:solidFill>
            </a:ln>
          </c:spPr>
          <c:marker>
            <c:symbol val="circle"/>
            <c:size val="4"/>
            <c:spPr>
              <a:solidFill>
                <a:srgbClr val="C0504D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FB1'!$M$75:$M$79</c:f>
                <c:numCache>
                  <c:formatCode>General</c:formatCode>
                  <c:ptCount val="5"/>
                  <c:pt idx="0">
                    <c:v>2.9143291585456814</c:v>
                  </c:pt>
                  <c:pt idx="1">
                    <c:v>1.3649030197823873</c:v>
                  </c:pt>
                  <c:pt idx="2">
                    <c:v>1.4146272281650514</c:v>
                  </c:pt>
                  <c:pt idx="3">
                    <c:v>0.14460017081541129</c:v>
                  </c:pt>
                  <c:pt idx="4">
                    <c:v>5.5778896432850472E-2</c:v>
                  </c:pt>
                </c:numCache>
              </c:numRef>
            </c:plus>
            <c:minus>
              <c:numRef>
                <c:f>'AFB1'!$M$75:$M$79</c:f>
                <c:numCache>
                  <c:formatCode>General</c:formatCode>
                  <c:ptCount val="5"/>
                  <c:pt idx="0">
                    <c:v>2.9143291585456814</c:v>
                  </c:pt>
                  <c:pt idx="1">
                    <c:v>1.3649030197823873</c:v>
                  </c:pt>
                  <c:pt idx="2">
                    <c:v>1.4146272281650514</c:v>
                  </c:pt>
                  <c:pt idx="3">
                    <c:v>0.14460017081541129</c:v>
                  </c:pt>
                  <c:pt idx="4">
                    <c:v>5.5778896432850472E-2</c:v>
                  </c:pt>
                </c:numCache>
              </c:numRef>
            </c:minus>
          </c:errBars>
          <c:xVal>
            <c:numRef>
              <c:f>'AFB1'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'AFB1'!$M$42:$M$46</c:f>
              <c:numCache>
                <c:formatCode>0</c:formatCode>
                <c:ptCount val="5"/>
                <c:pt idx="0">
                  <c:v>22.995106712466679</c:v>
                </c:pt>
                <c:pt idx="1">
                  <c:v>11.53568286948</c:v>
                </c:pt>
                <c:pt idx="2">
                  <c:v>9.1413835661797922</c:v>
                </c:pt>
                <c:pt idx="3">
                  <c:v>4.8531512035881885</c:v>
                </c:pt>
                <c:pt idx="4">
                  <c:v>0.5309701954304788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507F-4731-9E3B-03E99647269B}"/>
            </c:ext>
          </c:extLst>
        </c:ser>
        <c:ser>
          <c:idx val="3"/>
          <c:order val="3"/>
          <c:tx>
            <c:v>8</c:v>
          </c:tx>
          <c:spPr>
            <a:ln w="15875">
              <a:solidFill>
                <a:srgbClr val="F79646"/>
              </a:solidFill>
            </a:ln>
          </c:spPr>
          <c:marker>
            <c:symbol val="circle"/>
            <c:size val="4"/>
            <c:spPr>
              <a:solidFill>
                <a:srgbClr val="F79646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FB1'!$N$75:$N$79</c:f>
                <c:numCache>
                  <c:formatCode>General</c:formatCode>
                  <c:ptCount val="5"/>
                  <c:pt idx="0">
                    <c:v>2.6596175923778649</c:v>
                  </c:pt>
                  <c:pt idx="1">
                    <c:v>1.2465006651886985</c:v>
                  </c:pt>
                  <c:pt idx="2">
                    <c:v>0.77965279152091149</c:v>
                  </c:pt>
                  <c:pt idx="3">
                    <c:v>0.46178116443644285</c:v>
                  </c:pt>
                  <c:pt idx="4">
                    <c:v>5.1292279223034351E-2</c:v>
                  </c:pt>
                </c:numCache>
              </c:numRef>
            </c:plus>
            <c:minus>
              <c:numRef>
                <c:f>'AFB1'!$N$75:$N$79</c:f>
                <c:numCache>
                  <c:formatCode>General</c:formatCode>
                  <c:ptCount val="5"/>
                  <c:pt idx="0">
                    <c:v>2.6596175923778649</c:v>
                  </c:pt>
                  <c:pt idx="1">
                    <c:v>1.2465006651886985</c:v>
                  </c:pt>
                  <c:pt idx="2">
                    <c:v>0.77965279152091149</c:v>
                  </c:pt>
                  <c:pt idx="3">
                    <c:v>0.46178116443644285</c:v>
                  </c:pt>
                  <c:pt idx="4">
                    <c:v>5.1292279223034351E-2</c:v>
                  </c:pt>
                </c:numCache>
              </c:numRef>
            </c:minus>
          </c:errBars>
          <c:xVal>
            <c:numRef>
              <c:f>'AFB1'!$A$42:$A$46</c:f>
              <c:numCache>
                <c:formatCode>General</c:formatCode>
                <c:ptCount val="5"/>
                <c:pt idx="0">
                  <c:v>0.3125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xVal>
          <c:yVal>
            <c:numRef>
              <c:f>'AFB1'!$N$42:$N$46</c:f>
              <c:numCache>
                <c:formatCode>0</c:formatCode>
                <c:ptCount val="5"/>
                <c:pt idx="0">
                  <c:v>16.72267627343442</c:v>
                </c:pt>
                <c:pt idx="1">
                  <c:v>7.1725155632027349</c:v>
                </c:pt>
                <c:pt idx="2">
                  <c:v>4.8683550202530741</c:v>
                </c:pt>
                <c:pt idx="3">
                  <c:v>1.9619791853365358</c:v>
                </c:pt>
                <c:pt idx="4">
                  <c:v>0.2666057282145033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507F-4731-9E3B-03E9964726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1157120"/>
        <c:axId val="141158656"/>
      </c:scatterChart>
      <c:valAx>
        <c:axId val="141157120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141158656"/>
        <c:crosses val="autoZero"/>
        <c:crossBetween val="midCat"/>
      </c:valAx>
      <c:valAx>
        <c:axId val="141158656"/>
        <c:scaling>
          <c:orientation val="minMax"/>
          <c:max val="100"/>
          <c:min val="0"/>
        </c:scaling>
        <c:delete val="0"/>
        <c:axPos val="l"/>
        <c:majorGridlines>
          <c:spPr>
            <a:ln w="9525">
              <a:solidFill>
                <a:sysClr val="windowText" lastClr="000000"/>
              </a:solidFill>
              <a:prstDash val="sysDot"/>
            </a:ln>
          </c:spPr>
        </c:majorGridlines>
        <c:minorGridlines>
          <c:spPr>
            <a:ln w="6350">
              <a:solidFill>
                <a:sysClr val="windowText" lastClr="000000"/>
              </a:solidFill>
              <a:prstDash val="sysDot"/>
            </a:ln>
          </c:spPr>
        </c:minorGridlines>
        <c:numFmt formatCode="0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41157120"/>
        <c:crossesAt val="0.1"/>
        <c:crossBetween val="midCat"/>
        <c:majorUnit val="50"/>
        <c:minorUnit val="50"/>
      </c:valAx>
      <c:spPr>
        <a:noFill/>
      </c:spPr>
    </c:plotArea>
    <c:legend>
      <c:legendPos val="r"/>
      <c:layout>
        <c:manualLayout>
          <c:xMode val="edge"/>
          <c:yMode val="edge"/>
          <c:x val="0.69334290273660948"/>
          <c:y val="6.1513888888888937E-3"/>
          <c:w val="0.2483263849675009"/>
          <c:h val="0.22849027777777778"/>
        </c:manualLayout>
      </c:layout>
      <c:overlay val="0"/>
      <c:spPr>
        <a:solidFill>
          <a:sysClr val="window" lastClr="FFFFFF"/>
        </a:solidFill>
      </c:spPr>
      <c:txPr>
        <a:bodyPr/>
        <a:lstStyle/>
        <a:p>
          <a:pPr>
            <a:defRPr sz="600">
              <a:latin typeface="+mn-lt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C4F3E-6053-4AE8-9E07-7B60008F6C24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3BF253-178C-416B-B247-AADD4E0AFD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2286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C4F3E-6053-4AE8-9E07-7B60008F6C24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3BF253-178C-416B-B247-AADD4E0AFD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2283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C4F3E-6053-4AE8-9E07-7B60008F6C24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3BF253-178C-416B-B247-AADD4E0AFD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41104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C4F3E-6053-4AE8-9E07-7B60008F6C24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3BF253-178C-416B-B247-AADD4E0AFD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2811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C4F3E-6053-4AE8-9E07-7B60008F6C24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3BF253-178C-416B-B247-AADD4E0AFD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297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C4F3E-6053-4AE8-9E07-7B60008F6C24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3BF253-178C-416B-B247-AADD4E0AFD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02014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C4F3E-6053-4AE8-9E07-7B60008F6C24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3BF253-178C-416B-B247-AADD4E0AFD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5379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C4F3E-6053-4AE8-9E07-7B60008F6C24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3BF253-178C-416B-B247-AADD4E0AFD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7835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C4F3E-6053-4AE8-9E07-7B60008F6C24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3BF253-178C-416B-B247-AADD4E0AFD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2863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C4F3E-6053-4AE8-9E07-7B60008F6C24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3BF253-178C-416B-B247-AADD4E0AFD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57932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C4F3E-6053-4AE8-9E07-7B60008F6C24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3BF253-178C-416B-B247-AADD4E0AFD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8621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8C4F3E-6053-4AE8-9E07-7B60008F6C24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3BF253-178C-416B-B247-AADD4E0AFD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7018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4.xml"/><Relationship Id="rId3" Type="http://schemas.openxmlformats.org/officeDocument/2006/relationships/chart" Target="../charts/chart9.xml"/><Relationship Id="rId7" Type="http://schemas.openxmlformats.org/officeDocument/2006/relationships/chart" Target="../charts/chart13.xml"/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2.xml"/><Relationship Id="rId11" Type="http://schemas.openxmlformats.org/officeDocument/2006/relationships/chart" Target="../charts/chart17.xml"/><Relationship Id="rId5" Type="http://schemas.openxmlformats.org/officeDocument/2006/relationships/chart" Target="../charts/chart11.xml"/><Relationship Id="rId10" Type="http://schemas.openxmlformats.org/officeDocument/2006/relationships/chart" Target="../charts/chart16.xml"/><Relationship Id="rId4" Type="http://schemas.openxmlformats.org/officeDocument/2006/relationships/chart" Target="../charts/chart10.xml"/><Relationship Id="rId9" Type="http://schemas.openxmlformats.org/officeDocument/2006/relationships/chart" Target="../charts/char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8" name="グラフ 27">
            <a:extLst>
              <a:ext uri="{FF2B5EF4-FFF2-40B4-BE49-F238E27FC236}">
                <a16:creationId xmlns="" xmlns:a16="http://schemas.microsoft.com/office/drawing/2014/main" id="{00000000-0008-0000-2100-0000260000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471859"/>
              </p:ext>
            </p:extLst>
          </p:nvPr>
        </p:nvGraphicFramePr>
        <p:xfrm>
          <a:off x="1155780" y="5558150"/>
          <a:ext cx="1659991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4" name="グラフ 23">
            <a:extLst>
              <a:ext uri="{FF2B5EF4-FFF2-40B4-BE49-F238E27FC236}">
                <a16:creationId xmlns="" xmlns:a16="http://schemas.microsoft.com/office/drawing/2014/main" id="{00000000-0008-0000-2100-0000220000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7928937"/>
              </p:ext>
            </p:extLst>
          </p:nvPr>
        </p:nvGraphicFramePr>
        <p:xfrm>
          <a:off x="1161944" y="3723763"/>
          <a:ext cx="1661859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5" name="グラフ 24">
            <a:extLst>
              <a:ext uri="{FF2B5EF4-FFF2-40B4-BE49-F238E27FC236}">
                <a16:creationId xmlns="" xmlns:a16="http://schemas.microsoft.com/office/drawing/2014/main" id="{00000000-0008-0000-2100-0000230000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6928297"/>
              </p:ext>
            </p:extLst>
          </p:nvPr>
        </p:nvGraphicFramePr>
        <p:xfrm>
          <a:off x="2772815" y="3720588"/>
          <a:ext cx="1657189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1" name="グラフ 20">
            <a:extLst>
              <a:ext uri="{FF2B5EF4-FFF2-40B4-BE49-F238E27FC236}">
                <a16:creationId xmlns="" xmlns:a16="http://schemas.microsoft.com/office/drawing/2014/main" id="{00000000-0008-0000-2100-0000360000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70983976"/>
              </p:ext>
            </p:extLst>
          </p:nvPr>
        </p:nvGraphicFramePr>
        <p:xfrm>
          <a:off x="1161944" y="1889376"/>
          <a:ext cx="1661859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2" name="グラフ 21">
            <a:extLst>
              <a:ext uri="{FF2B5EF4-FFF2-40B4-BE49-F238E27FC236}">
                <a16:creationId xmlns="" xmlns:a16="http://schemas.microsoft.com/office/drawing/2014/main" id="{00000000-0008-0000-2100-0000200000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37255270"/>
              </p:ext>
            </p:extLst>
          </p:nvPr>
        </p:nvGraphicFramePr>
        <p:xfrm>
          <a:off x="2774403" y="1908424"/>
          <a:ext cx="1657189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3" name="グラフ 22">
            <a:extLst>
              <a:ext uri="{FF2B5EF4-FFF2-40B4-BE49-F238E27FC236}">
                <a16:creationId xmlns="" xmlns:a16="http://schemas.microsoft.com/office/drawing/2014/main" id="{00000000-0008-0000-2100-0000210000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3833443"/>
              </p:ext>
            </p:extLst>
          </p:nvPr>
        </p:nvGraphicFramePr>
        <p:xfrm>
          <a:off x="4386954" y="1903662"/>
          <a:ext cx="1666184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7" name="テキスト ボックス 26"/>
          <p:cNvSpPr txBox="1"/>
          <p:nvPr/>
        </p:nvSpPr>
        <p:spPr>
          <a:xfrm>
            <a:off x="1672838" y="1721004"/>
            <a:ext cx="8499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ay 1 to 4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276258" y="1721004"/>
            <a:ext cx="8499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ay 5 to 8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4848596" y="1721004"/>
            <a:ext cx="9284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ay 9 to 12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1541040" y="3544029"/>
            <a:ext cx="11135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ay 13 to 16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3144460" y="3544029"/>
            <a:ext cx="11135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ay 17 to 20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4756071" y="3544029"/>
            <a:ext cx="11135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ay 21 to 24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1493723" y="5369750"/>
            <a:ext cx="12081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ay 25 to </a:t>
            </a:r>
            <a:r>
              <a:rPr kumimoji="1" lang="en-US" altLang="ja-JP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2787270" y="3285647"/>
            <a:ext cx="1837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ncentration (</a:t>
            </a:r>
            <a:r>
              <a:rPr kumimoji="1"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2784887" y="5100530"/>
            <a:ext cx="1837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ncentration (</a:t>
            </a:r>
            <a:r>
              <a:rPr kumimoji="1"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1169562" y="6936244"/>
            <a:ext cx="1837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ncentration (</a:t>
            </a:r>
            <a:r>
              <a:rPr kumimoji="1"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6" name="グラフ 25">
            <a:extLst>
              <a:ext uri="{FF2B5EF4-FFF2-40B4-BE49-F238E27FC236}">
                <a16:creationId xmlns="" xmlns:a16="http://schemas.microsoft.com/office/drawing/2014/main" id="{00000000-0008-0000-2100-0000250000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7349331"/>
              </p:ext>
            </p:extLst>
          </p:nvPr>
        </p:nvGraphicFramePr>
        <p:xfrm>
          <a:off x="4388541" y="3723763"/>
          <a:ext cx="165719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9" name="テキスト ボックス 28"/>
          <p:cNvSpPr txBox="1"/>
          <p:nvPr/>
        </p:nvSpPr>
        <p:spPr>
          <a:xfrm>
            <a:off x="517055" y="1350198"/>
            <a:ext cx="1572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a) Acetaminophen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517055" y="3520185"/>
            <a:ext cx="553998" cy="1727396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Relative light </a:t>
            </a:r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</a:p>
          <a:p>
            <a:pPr algn="ctr"/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% 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of control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72002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434505" y="400204"/>
            <a:ext cx="8499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ay 1 to 4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3043842" y="400204"/>
            <a:ext cx="8499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ay 5 to 8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4611700" y="400204"/>
            <a:ext cx="9284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ay 9 to 12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1303704" y="2209581"/>
            <a:ext cx="11115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ay 13 to 16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913041" y="2209581"/>
            <a:ext cx="11115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ay 17 to 20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520172" y="2209581"/>
            <a:ext cx="11115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ay 21 to 24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303704" y="4062598"/>
            <a:ext cx="11115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ay 25 to 28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556404" y="1947382"/>
            <a:ext cx="1837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ncentration </a:t>
            </a:r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l-GR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555853" y="3766230"/>
            <a:ext cx="1837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ncentration </a:t>
            </a:r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l-GR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940961" y="5599562"/>
            <a:ext cx="1837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ncentration </a:t>
            </a:r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l-GR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44335" y="2237485"/>
            <a:ext cx="553998" cy="1727396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Relative light </a:t>
            </a:r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</a:p>
          <a:p>
            <a:pPr algn="ctr"/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% 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of control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344335" y="136078"/>
            <a:ext cx="20152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 3-Methylcholanthrene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1434505" y="6485762"/>
            <a:ext cx="8499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ay 1 to 4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3043842" y="6485762"/>
            <a:ext cx="8499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ay 5 to 8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4611700" y="6485762"/>
            <a:ext cx="9284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ay 9 to 12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2557512" y="8147974"/>
            <a:ext cx="1837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ncentration </a:t>
            </a:r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l-GR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0" name="グラフ 49">
            <a:extLst>
              <a:ext uri="{FF2B5EF4-FFF2-40B4-BE49-F238E27FC236}">
                <a16:creationId xmlns="" xmlns:a16="http://schemas.microsoft.com/office/drawing/2014/main" id="{755C5422-9BAA-4CFC-9ECE-AA0300C527B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1939622"/>
              </p:ext>
            </p:extLst>
          </p:nvPr>
        </p:nvGraphicFramePr>
        <p:xfrm>
          <a:off x="927131" y="6767689"/>
          <a:ext cx="1655394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1" name="グラフ 50">
            <a:extLst>
              <a:ext uri="{FF2B5EF4-FFF2-40B4-BE49-F238E27FC236}">
                <a16:creationId xmlns="" xmlns:a16="http://schemas.microsoft.com/office/drawing/2014/main" id="{95BE1924-DFAB-4EB9-BD06-BAD1E87173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6657637"/>
              </p:ext>
            </p:extLst>
          </p:nvPr>
        </p:nvGraphicFramePr>
        <p:xfrm>
          <a:off x="2547414" y="6767689"/>
          <a:ext cx="1653112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2" name="グラフ 51">
            <a:extLst>
              <a:ext uri="{FF2B5EF4-FFF2-40B4-BE49-F238E27FC236}">
                <a16:creationId xmlns="" xmlns:a16="http://schemas.microsoft.com/office/drawing/2014/main" id="{E1EE9A94-5CE3-45AD-86E8-E0A447D9C9D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0814056"/>
              </p:ext>
            </p:extLst>
          </p:nvPr>
        </p:nvGraphicFramePr>
        <p:xfrm>
          <a:off x="4152250" y="6767689"/>
          <a:ext cx="1662763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3" name="テキスト ボックス 52"/>
          <p:cNvSpPr txBox="1"/>
          <p:nvPr/>
        </p:nvSpPr>
        <p:spPr>
          <a:xfrm>
            <a:off x="344335" y="6181278"/>
            <a:ext cx="13235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 Aflatoxin 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1</a:t>
            </a: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344335" y="6555485"/>
            <a:ext cx="553998" cy="1727396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Relative light </a:t>
            </a:r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</a:p>
          <a:p>
            <a:pPr algn="ctr"/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% 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of control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583333" y="8942789"/>
            <a:ext cx="56913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4: Fig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.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aily changes of dose-response curves of ELuc bioluminescence from compound-treated 3D spheroids shown in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s. 4‒6.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concentration response curves for every four days were superimposed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2" name="グラフ 71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DBD3A728-E884-4EC0-9EAB-44EC1CC17B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21553070"/>
              </p:ext>
            </p:extLst>
          </p:nvPr>
        </p:nvGraphicFramePr>
        <p:xfrm>
          <a:off x="934698" y="558383"/>
          <a:ext cx="1655056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3" name="グラフ 72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AFE45BD0-461D-445E-946F-A6D2C4742FA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91190875"/>
              </p:ext>
            </p:extLst>
          </p:nvPr>
        </p:nvGraphicFramePr>
        <p:xfrm>
          <a:off x="2541940" y="567908"/>
          <a:ext cx="1655409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4" name="グラフ 73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093F26A0-E6CD-4709-9EAA-559543A47E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7013746"/>
              </p:ext>
            </p:extLst>
          </p:nvPr>
        </p:nvGraphicFramePr>
        <p:xfrm>
          <a:off x="4159550" y="564733"/>
          <a:ext cx="1644349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5" name="グラフ 74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D5655273-6D12-4816-AB9C-6BB624430F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5167788"/>
              </p:ext>
            </p:extLst>
          </p:nvPr>
        </p:nvGraphicFramePr>
        <p:xfrm>
          <a:off x="931523" y="2402295"/>
          <a:ext cx="1655056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76" name="グラフ 75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2D2938BD-F139-4721-B753-B97084250F7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9065401"/>
              </p:ext>
            </p:extLst>
          </p:nvPr>
        </p:nvGraphicFramePr>
        <p:xfrm>
          <a:off x="2541940" y="2376895"/>
          <a:ext cx="1655409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77" name="グラフ 76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64A3A5E0-854D-4035-8AF9-B6E69543706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43653628"/>
              </p:ext>
            </p:extLst>
          </p:nvPr>
        </p:nvGraphicFramePr>
        <p:xfrm>
          <a:off x="4159550" y="2373720"/>
          <a:ext cx="1650699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78" name="グラフ 77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8D89F235-7032-49A8-BC26-7578D3B95FE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691821"/>
              </p:ext>
            </p:extLst>
          </p:nvPr>
        </p:nvGraphicFramePr>
        <p:xfrm>
          <a:off x="930918" y="4220014"/>
          <a:ext cx="1648652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</p:spTree>
    <p:extLst>
      <p:ext uri="{BB962C8B-B14F-4D97-AF65-F5344CB8AC3E}">
        <p14:creationId xmlns:p14="http://schemas.microsoft.com/office/powerpoint/2010/main" val="40981249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8</TotalTime>
  <Words>171</Words>
  <Application>Microsoft Office PowerPoint</Application>
  <PresentationFormat>A4 210 x 297 mm</PresentationFormat>
  <Paragraphs>34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ibou-003</dc:creator>
  <cp:lastModifiedBy>nakajima</cp:lastModifiedBy>
  <cp:revision>39</cp:revision>
  <cp:lastPrinted>2017-05-24T08:24:27Z</cp:lastPrinted>
  <dcterms:created xsi:type="dcterms:W3CDTF">2017-05-24T03:00:07Z</dcterms:created>
  <dcterms:modified xsi:type="dcterms:W3CDTF">2017-06-14T11:55:11Z</dcterms:modified>
</cp:coreProperties>
</file>